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69" r:id="rId3"/>
    <p:sldId id="281" r:id="rId4"/>
    <p:sldId id="261" r:id="rId5"/>
    <p:sldId id="262" r:id="rId6"/>
    <p:sldId id="268" r:id="rId7"/>
    <p:sldId id="256" r:id="rId8"/>
    <p:sldId id="260" r:id="rId9"/>
  </p:sldIdLst>
  <p:sldSz cx="12192000" cy="6858000"/>
  <p:notesSz cx="6700838" cy="983615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>
        <p:scale>
          <a:sx n="78" d="100"/>
          <a:sy n="78" d="100"/>
        </p:scale>
        <p:origin x="1788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slide" Target="slides/slide7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aper\gdxlara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aper\gdxlara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aper\&#26032;&#12375;&#12356;&#12501;&#12457;&#12523;&#12480;&#12540;\&#22259;&#34920;\Gdx_Antiport_Assay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aper\&#26032;&#12375;&#12356;&#12501;&#12457;&#12523;&#12480;&#12540;\&#22259;&#34920;\Gdx_Antiport_Assay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6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0 mM CsC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6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6672227246948795"/>
          <c:y val="0.20414990269846264"/>
          <c:w val="0.76299304690283587"/>
          <c:h val="0.640778538219625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2</c:f>
              <c:strCache>
                <c:ptCount val="1"/>
                <c:pt idx="0">
                  <c:v>Mach1/pBAD24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5</c:f>
                <c:numCache>
                  <c:formatCode>General</c:formatCode>
                  <c:ptCount val="1"/>
                  <c:pt idx="0">
                    <c:v>0.12288205727444505</c:v>
                  </c:pt>
                </c:numCache>
              </c:numRef>
            </c:plus>
            <c:minus>
              <c:numRef>
                <c:f>Sheet1!$E$5</c:f>
                <c:numCache>
                  <c:formatCode>General</c:formatCode>
                  <c:ptCount val="1"/>
                  <c:pt idx="0">
                    <c:v>0.122882057274445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accent1">
                    <a:alpha val="97000"/>
                  </a:schemeClr>
                </a:solidFill>
                <a:round/>
              </a:ln>
              <a:effectLst/>
            </c:spPr>
          </c:errBars>
          <c:cat>
            <c:strRef>
              <c:f>Sheet1!$T$1</c:f>
              <c:strCache>
                <c:ptCount val="1"/>
                <c:pt idx="0">
                  <c:v>0 mM Cs⁺</c:v>
                </c:pt>
              </c:strCache>
            </c:strRef>
          </c:cat>
          <c:val>
            <c:numRef>
              <c:f>Sheet1!$T$2</c:f>
              <c:numCache>
                <c:formatCode>General</c:formatCode>
                <c:ptCount val="1"/>
                <c:pt idx="0">
                  <c:v>3.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E8A-40B8-AD7A-F79503E06EB2}"/>
            </c:ext>
          </c:extLst>
        </c:ser>
        <c:ser>
          <c:idx val="1"/>
          <c:order val="1"/>
          <c:tx>
            <c:strRef>
              <c:f>Sheet1!$S$3</c:f>
              <c:strCache>
                <c:ptCount val="1"/>
                <c:pt idx="0">
                  <c:v>Mach1/pBAD-Gdx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5</c:f>
                <c:numCache>
                  <c:formatCode>General</c:formatCode>
                  <c:ptCount val="1"/>
                  <c:pt idx="0">
                    <c:v>0.17637554630201224</c:v>
                  </c:pt>
                </c:numCache>
              </c:numRef>
            </c:plus>
            <c:minus>
              <c:numRef>
                <c:f>Sheet1!$I$5</c:f>
                <c:numCache>
                  <c:formatCode>General</c:formatCode>
                  <c:ptCount val="1"/>
                  <c:pt idx="0">
                    <c:v>0.176375546302012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1</c:f>
              <c:strCache>
                <c:ptCount val="1"/>
                <c:pt idx="0">
                  <c:v>0 mM Cs⁺</c:v>
                </c:pt>
              </c:strCache>
            </c:strRef>
          </c:cat>
          <c:val>
            <c:numRef>
              <c:f>Sheet1!$T$3</c:f>
              <c:numCache>
                <c:formatCode>General</c:formatCode>
                <c:ptCount val="1"/>
                <c:pt idx="0">
                  <c:v>3.908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E8A-40B8-AD7A-F79503E06EB2}"/>
            </c:ext>
          </c:extLst>
        </c:ser>
        <c:ser>
          <c:idx val="2"/>
          <c:order val="2"/>
          <c:tx>
            <c:strRef>
              <c:f>Sheet1!$S$4</c:f>
              <c:strCache>
                <c:ptCount val="1"/>
                <c:pt idx="0">
                  <c:v>Mach1/pBAD24(l-Ara)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0</c:f>
                <c:numCache>
                  <c:formatCode>General</c:formatCode>
                  <c:ptCount val="1"/>
                  <c:pt idx="0">
                    <c:v>0.32407560846197592</c:v>
                  </c:pt>
                </c:numCache>
              </c:numRef>
            </c:plus>
            <c:minus>
              <c:numRef>
                <c:f>Sheet1!$E$10</c:f>
                <c:numCache>
                  <c:formatCode>General</c:formatCode>
                  <c:ptCount val="1"/>
                  <c:pt idx="0">
                    <c:v>0.324075608461975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1</c:f>
              <c:strCache>
                <c:ptCount val="1"/>
                <c:pt idx="0">
                  <c:v>0 mM Cs⁺</c:v>
                </c:pt>
              </c:strCache>
            </c:strRef>
          </c:cat>
          <c:val>
            <c:numRef>
              <c:f>Sheet1!$T$4</c:f>
              <c:numCache>
                <c:formatCode>General</c:formatCode>
                <c:ptCount val="1"/>
                <c:pt idx="0">
                  <c:v>4.405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E8A-40B8-AD7A-F79503E06EB2}"/>
            </c:ext>
          </c:extLst>
        </c:ser>
        <c:ser>
          <c:idx val="3"/>
          <c:order val="3"/>
          <c:tx>
            <c:strRef>
              <c:f>Sheet1!$S$5</c:f>
              <c:strCache>
                <c:ptCount val="1"/>
                <c:pt idx="0">
                  <c:v>Mach1/pBAD-Gdx(l-Ara)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10</c:f>
                <c:numCache>
                  <c:formatCode>General</c:formatCode>
                  <c:ptCount val="1"/>
                  <c:pt idx="0">
                    <c:v>7.9739158092704696E-2</c:v>
                  </c:pt>
                </c:numCache>
              </c:numRef>
            </c:plus>
            <c:minus>
              <c:numRef>
                <c:f>Sheet1!$I$10</c:f>
                <c:numCache>
                  <c:formatCode>General</c:formatCode>
                  <c:ptCount val="1"/>
                  <c:pt idx="0">
                    <c:v>7.973915809270469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1</c:f>
              <c:strCache>
                <c:ptCount val="1"/>
                <c:pt idx="0">
                  <c:v>0 mM Cs⁺</c:v>
                </c:pt>
              </c:strCache>
            </c:strRef>
          </c:cat>
          <c:val>
            <c:numRef>
              <c:f>Sheet1!$T$5</c:f>
              <c:numCache>
                <c:formatCode>General</c:formatCode>
                <c:ptCount val="1"/>
                <c:pt idx="0">
                  <c:v>4.65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E8A-40B8-AD7A-F79503E06E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399978431"/>
        <c:axId val="399984255"/>
      </c:barChart>
      <c:catAx>
        <c:axId val="39997843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99984255"/>
        <c:crosses val="autoZero"/>
        <c:auto val="1"/>
        <c:lblAlgn val="ctr"/>
        <c:lblOffset val="100"/>
        <c:noMultiLvlLbl val="0"/>
      </c:catAx>
      <c:valAx>
        <c:axId val="399984255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99978431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6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700 mM CsC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6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533347142546925"/>
          <c:y val="0.20650169567102983"/>
          <c:w val="0.74291170958064268"/>
          <c:h val="0.636074961362699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2</c:f>
              <c:strCache>
                <c:ptCount val="1"/>
                <c:pt idx="0">
                  <c:v>Mach1/pBAD24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6</c:f>
                <c:numCache>
                  <c:formatCode>General</c:formatCode>
                  <c:ptCount val="1"/>
                  <c:pt idx="0">
                    <c:v>1.4285773809399802E-2</c:v>
                  </c:pt>
                </c:numCache>
              </c:numRef>
            </c:plus>
            <c:minus>
              <c:numRef>
                <c:f>Sheet1!$E$16</c:f>
                <c:numCache>
                  <c:formatCode>General</c:formatCode>
                  <c:ptCount val="1"/>
                  <c:pt idx="0">
                    <c:v>1.42857738093998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U$2</c:f>
              <c:numCache>
                <c:formatCode>General</c:formatCode>
                <c:ptCount val="1"/>
                <c:pt idx="0">
                  <c:v>2.383333333333333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18-4B69-BD9C-0EBFF5F2A9CC}"/>
            </c:ext>
          </c:extLst>
        </c:ser>
        <c:ser>
          <c:idx val="1"/>
          <c:order val="1"/>
          <c:tx>
            <c:strRef>
              <c:f>Sheet1!$S$3</c:f>
              <c:strCache>
                <c:ptCount val="1"/>
                <c:pt idx="0">
                  <c:v>Mach1/pBAD-Gdx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16</c:f>
                <c:numCache>
                  <c:formatCode>General</c:formatCode>
                  <c:ptCount val="1"/>
                  <c:pt idx="0">
                    <c:v>1.2691860908997115E-2</c:v>
                  </c:pt>
                </c:numCache>
              </c:numRef>
            </c:plus>
            <c:minus>
              <c:numRef>
                <c:f>Sheet1!$I$16</c:f>
                <c:numCache>
                  <c:formatCode>General</c:formatCode>
                  <c:ptCount val="1"/>
                  <c:pt idx="0">
                    <c:v>1.269186090899711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U$3</c:f>
              <c:numCache>
                <c:formatCode>General</c:formatCode>
                <c:ptCount val="1"/>
                <c:pt idx="0">
                  <c:v>0.102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818-4B69-BD9C-0EBFF5F2A9CC}"/>
            </c:ext>
          </c:extLst>
        </c:ser>
        <c:ser>
          <c:idx val="2"/>
          <c:order val="2"/>
          <c:tx>
            <c:strRef>
              <c:f>Sheet1!$S$4</c:f>
              <c:strCache>
                <c:ptCount val="1"/>
                <c:pt idx="0">
                  <c:v>Mach1/pBAD24(l-Ara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1</c:f>
                <c:numCache>
                  <c:formatCode>General</c:formatCode>
                  <c:ptCount val="1"/>
                  <c:pt idx="0">
                    <c:v>8.3516465442450283E-3</c:v>
                  </c:pt>
                </c:numCache>
              </c:numRef>
            </c:plus>
            <c:minus>
              <c:numRef>
                <c:f>Sheet1!$E$21</c:f>
                <c:numCache>
                  <c:formatCode>General</c:formatCode>
                  <c:ptCount val="1"/>
                  <c:pt idx="0">
                    <c:v>8.351646544245028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U$4</c:f>
              <c:numCache>
                <c:formatCode>General</c:formatCode>
                <c:ptCount val="1"/>
                <c:pt idx="0">
                  <c:v>2.10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818-4B69-BD9C-0EBFF5F2A9CC}"/>
            </c:ext>
          </c:extLst>
        </c:ser>
        <c:ser>
          <c:idx val="3"/>
          <c:order val="3"/>
          <c:tx>
            <c:strRef>
              <c:f>Sheet1!$S$5</c:f>
              <c:strCache>
                <c:ptCount val="1"/>
                <c:pt idx="0">
                  <c:v>Mach1/pBAD-Gdx(l-Ara)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21</c:f>
                <c:numCache>
                  <c:formatCode>General</c:formatCode>
                  <c:ptCount val="1"/>
                  <c:pt idx="0">
                    <c:v>6.3311399710741914E-2</c:v>
                  </c:pt>
                </c:numCache>
              </c:numRef>
            </c:plus>
            <c:minus>
              <c:numRef>
                <c:f>Sheet1!$I$21</c:f>
                <c:numCache>
                  <c:formatCode>General</c:formatCode>
                  <c:ptCount val="1"/>
                  <c:pt idx="0">
                    <c:v>6.331139971074191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U$5</c:f>
              <c:numCache>
                <c:formatCode>General</c:formatCode>
                <c:ptCount val="1"/>
                <c:pt idx="0">
                  <c:v>1.461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818-4B69-BD9C-0EBFF5F2A9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801097727"/>
        <c:axId val="801105631"/>
      </c:barChart>
      <c:catAx>
        <c:axId val="801097727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801105631"/>
        <c:crosses val="autoZero"/>
        <c:auto val="1"/>
        <c:lblAlgn val="ctr"/>
        <c:lblOffset val="100"/>
        <c:noMultiLvlLbl val="0"/>
      </c:catAx>
      <c:valAx>
        <c:axId val="801105631"/>
        <c:scaling>
          <c:orientation val="minMax"/>
          <c:max val="5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1097727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924971572362364"/>
          <c:y val="4.1884816753926704E-2"/>
          <c:w val="0.62403309020002262"/>
          <c:h val="0.863891934974096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7F3-45F3-A049-48D183F76377}"/>
              </c:ext>
            </c:extLst>
          </c:dPt>
          <c:errBars>
            <c:errBarType val="both"/>
            <c:errValType val="cust"/>
            <c:noEndCap val="0"/>
            <c:plus>
              <c:numRef>
                <c:f>Sheet4!$F$3:$F$4</c:f>
                <c:numCache>
                  <c:formatCode>General</c:formatCode>
                  <c:ptCount val="2"/>
                  <c:pt idx="0">
                    <c:v>0.76891698728363056</c:v>
                  </c:pt>
                  <c:pt idx="1">
                    <c:v>2.0314526821956753</c:v>
                  </c:pt>
                </c:numCache>
              </c:numRef>
            </c:plus>
            <c:minus>
              <c:numRef>
                <c:f>Sheet4!$F$3:$F$4</c:f>
                <c:numCache>
                  <c:formatCode>General</c:formatCode>
                  <c:ptCount val="2"/>
                  <c:pt idx="0">
                    <c:v>0.76891698728363056</c:v>
                  </c:pt>
                  <c:pt idx="1">
                    <c:v>2.03145268219567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A$3:$A$4</c:f>
              <c:strCache>
                <c:ptCount val="2"/>
                <c:pt idx="0">
                  <c:v>pBAD-Gdx</c:v>
                </c:pt>
                <c:pt idx="1">
                  <c:v>pBAD24</c:v>
                </c:pt>
              </c:strCache>
            </c:strRef>
          </c:cat>
          <c:val>
            <c:numRef>
              <c:f>Sheet4!$E$3:$E$4</c:f>
              <c:numCache>
                <c:formatCode>General</c:formatCode>
                <c:ptCount val="2"/>
                <c:pt idx="0">
                  <c:v>18.283333333333335</c:v>
                </c:pt>
                <c:pt idx="1">
                  <c:v>14.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F3-45F3-A049-48D183F763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18689904"/>
        <c:axId val="1218708624"/>
      </c:barChart>
      <c:catAx>
        <c:axId val="1218689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218708624"/>
        <c:crosses val="autoZero"/>
        <c:auto val="1"/>
        <c:lblAlgn val="ctr"/>
        <c:lblOffset val="100"/>
        <c:noMultiLvlLbl val="0"/>
      </c:catAx>
      <c:valAx>
        <c:axId val="1218708624"/>
        <c:scaling>
          <c:orientation val="minMax"/>
          <c:max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%Dequenching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5.1547195219053085E-2"/>
              <c:y val="0.324877767242445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218689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321297405526403"/>
          <c:y val="4.0645861675667506E-2"/>
          <c:w val="0.71066489261268817"/>
          <c:h val="0.865392532739690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E1D-4B9D-B629-06930AF2D1D2}"/>
              </c:ext>
            </c:extLst>
          </c:dPt>
          <c:errBars>
            <c:errBarType val="both"/>
            <c:errValType val="cust"/>
            <c:noEndCap val="0"/>
            <c:plus>
              <c:numRef>
                <c:f>Sheet4!$M$3:$M$4</c:f>
                <c:numCache>
                  <c:formatCode>General</c:formatCode>
                  <c:ptCount val="2"/>
                  <c:pt idx="0">
                    <c:v>3.9258289995023183</c:v>
                  </c:pt>
                  <c:pt idx="1">
                    <c:v>0.33421549934136907</c:v>
                  </c:pt>
                </c:numCache>
              </c:numRef>
            </c:plus>
            <c:minus>
              <c:numRef>
                <c:f>Sheet4!$M$3:$M$4</c:f>
                <c:numCache>
                  <c:formatCode>General</c:formatCode>
                  <c:ptCount val="2"/>
                  <c:pt idx="0">
                    <c:v>3.9258289995023183</c:v>
                  </c:pt>
                  <c:pt idx="1">
                    <c:v>0.334215499341369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A$3:$A$4</c:f>
              <c:strCache>
                <c:ptCount val="2"/>
                <c:pt idx="0">
                  <c:v>pBAD-Gdx</c:v>
                </c:pt>
                <c:pt idx="1">
                  <c:v>pBAD24</c:v>
                </c:pt>
              </c:strCache>
            </c:strRef>
          </c:cat>
          <c:val>
            <c:numRef>
              <c:f>Sheet4!$L$3:$L$4</c:f>
              <c:numCache>
                <c:formatCode>General</c:formatCode>
                <c:ptCount val="2"/>
                <c:pt idx="0">
                  <c:v>24.526666666666667</c:v>
                </c:pt>
                <c:pt idx="1">
                  <c:v>20.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1D-4B9D-B629-06930AF2D1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18689904"/>
        <c:axId val="1218708624"/>
      </c:barChart>
      <c:catAx>
        <c:axId val="1218689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218708624"/>
        <c:crosses val="autoZero"/>
        <c:auto val="1"/>
        <c:lblAlgn val="ctr"/>
        <c:lblOffset val="100"/>
        <c:noMultiLvlLbl val="0"/>
      </c:catAx>
      <c:valAx>
        <c:axId val="12187086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218689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29DF8C-111D-DE06-5D20-E040528491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CE84086-8E0E-F4BD-2F15-FBAF99195F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7DAD26-C586-EAE1-4690-B886BCD7F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D8EC8E-3E49-78BC-627F-301BC3479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9B8337-98F5-0534-4829-B4684DCA2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3363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96C584-C7FB-A0C9-8B0B-D8A8EC0273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3699EE2-9DEE-A539-E951-00546887B9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485F0A-5563-BC16-97B9-6FA4DA145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3DFAEB-CC7E-4A7F-1683-8EA9BD9FA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EC744E-CF6E-F5D9-C092-97FAF798C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3574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EA56419-31D0-A5B6-0789-F79CF6136D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3DCEC63-A3E4-0E0E-65A7-24D423A0D8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2E63DF-F527-70F4-B6B3-73AE5AAE7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F661D1-2BC4-A6F9-3806-A8AB4D3A5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14CBA4-E5B0-6433-FFBC-41C651A2B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585538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009F66-1C27-49E0-9E6E-30DA57A73D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D816203-3206-4CE7-8EC1-AB4462D1D9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9362556-B5CC-4C21-9FBB-A2A983167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F101D3-117C-4F3E-B2AF-D51ACDCFB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8132B8-F87F-4097-823A-66BB9F496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5839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C36D50-FD24-4199-9418-A2AA400D51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809C17D-03B3-4BD0-AD7D-FF3F620DD1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FA5979C-479F-4E4E-8B25-3F13161F4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579555-CE29-4FFC-AC1C-3325496AE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533C0B-5FB0-48E9-819B-B91E5C814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619737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9F639B-ED5D-48E6-B245-90595CD94F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D12DC4D-13B4-4F0B-AFAD-CC41D0750B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0165438-6192-4DE2-82F8-F1F1CAFC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2A3FB2-7897-4267-AD5F-248349B5B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DADC33-9469-4CEB-A00D-BD5BB1727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20413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FDAC07-8699-4983-BF88-5C4DE188D5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5381D7-F9A4-40D3-B99A-A2993E231E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2D966F0-2D3F-4B47-A6C5-2A65CFEAB6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FEFB38-3AE4-408C-8DDB-D96AB6C67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E7F839F-4E84-4BC6-A1B6-9C669EA12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132DA1-B156-4BBA-8259-D5D655E10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455677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6DD0D2-283E-4E65-9F8B-0720654830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8F3B87C-06D1-400C-AF37-C15260EE7C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5075AA-EEED-43FC-9306-589BB0D61A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351DA66-04AE-4F0F-91B5-5F0604B1DB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4DF3A6D-AE90-4974-A627-40E8F64008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62B5B04-D150-406A-AE98-019F14CF2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E32AB38-B100-44A2-BECB-C0D4451DA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4754606-2F80-4FE7-B0FC-79E954A7B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19365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6C2BB7-684B-483F-953B-1084CFF21B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D080894-795B-48E8-B9E7-0FE52BCD70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6EEC6D9-CA13-4024-B4C2-C33AF0DC1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7E0EA5C-714C-4AC7-9486-6BFF57F72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6418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AAEF26E-D7AF-4160-89FB-F3E98334E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8EC97E1-B93B-4205-AC3F-962887E86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D181F8A-5E06-47E0-AF8B-18805D8AD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33951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21594A-D250-44A2-9888-84FDBF61B9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0FA44B5-06CC-4F51-A2D7-72C08F9C66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E38C535-DC0F-451B-A7B8-63B81244BB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453E497-66B8-4893-B09A-60AC7CA0F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4438075-92D3-41FB-9809-811FB97483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0CDABEF-A6E4-4B6B-93A0-30DAC8182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132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BEDB97-8FE7-7552-393F-FB2204E0B8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25BE27D-E631-11F5-E231-BE3ABB4B3B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26F01D-F3A9-6F53-3D3E-A80C1CF15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2D1CFC-623A-6BFC-5C70-1EE2BD71F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EECC36-3846-4BE6-80A1-82C4B72B4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77608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CA0E9F-6806-4B84-957B-4233BB2720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F577E44-9EA8-416C-8BD4-03EA61A500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66AEC31-6A90-44F8-8E31-B635B762A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7C45DE1-7A03-4B79-8E4F-6D1893A78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CCB72C2-46CB-4CD9-8D3C-658F63FEB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95FD8D9-522E-48FC-A9AC-2C9888964C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290990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A8745A-A424-44C5-968A-4407AA9EF1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541F624-1120-41D8-AEC4-03FF6F8162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20C569-620B-410A-855E-32F1A16F3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F654DB-A7FF-4189-A1CE-2CE2FC919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C0AB9E-7456-42EB-AEF9-5D2F6DA4A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19257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7F3DC11-32E8-47CE-8885-06BB738C92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1FF21EF-C57B-408E-94F2-0B837E19C6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EC558B-9269-4744-8C1A-9142A1264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A96153-6F4F-4D4F-9973-3C335348F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6047A9-37A3-4F9C-AF2A-5A951CDEB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9638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F35FED-10A2-75A5-81C7-94EEE580B6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441CAF-A260-866A-F048-0B7A6C87C3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40007A-112A-6EB9-2612-05660D0046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4C81ED-A4D4-62D8-760B-41F5C22C2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822010-E35B-E9B3-CEB9-7507F0667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5821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110559-67D2-5696-06AF-529D9CAB32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B9C4E9F-CAA3-534C-6B07-8BB211C565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AFFE9B8-5461-1C3F-856D-23285C95EB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13EF746-CB4C-74E7-B4AD-FB65CF3EC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888476D-4117-C56D-E3EB-413691361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06B12E-7EE6-9466-D83D-D77226C87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1458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0F16E8-09E8-3E29-9773-E25C62E4C1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B67A4F0-6AFC-9928-2BCC-667A4B4592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69FD736-6E5B-8D08-FE71-C3369529D4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49C6C75-D0F4-00AD-5542-BB0F0C2BA3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95F586A-3EC0-2134-0E99-38773EE162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0122615-D70F-99C8-3DA3-6FF1BCAC3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C499CD1-3D1E-447A-308A-1C403CAC1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116DA7E-A86C-7A57-7F38-96BF8A057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1939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CD1BB3-53BF-1F0C-65CA-3B7E055191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F97D7C3-34BE-870D-5560-240BF2AC4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01BAD99-E45F-F085-2F47-84054F276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6A43E2E-A780-E67E-62F9-890BB95AA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7850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D787FEB-41E9-A7EE-6EBA-72BE8DB87A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4DE6A97-F3B9-1543-E73B-526B56DD5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BBA56E3-E3ED-6281-D94A-A7AA091E9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024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10A6BB-06C3-3EB8-2FC3-56C1F20A42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14611AC-F5D0-87F5-2877-EC765CFB2E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C19119-A6B7-3E45-6CB8-E219E3629D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B0819DA-8E6A-E223-552E-8D08DFBB8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9D80A0E-C9A6-0ECE-4FA6-1C3E5D793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11D19E1-2B62-8F43-79BA-328B7255F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52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EF8D93-5DD0-E4EA-16B9-8319C6AB04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259C27A-FA4B-29A3-A480-AEF99DFD33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782A986-E6CE-A593-0F64-9377BC226C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FAEE94F-A70C-BEDE-BC86-ABAA22B0F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053240F-011A-14E7-B834-66CAD91E4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C382DD-3459-170B-4A6E-4524D9F8F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596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B2A9637-03C9-0FC3-692D-22DD625849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687414-6239-3BAD-571F-B2AF5557DA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ECC281-C4D0-A9AC-2928-46A021FADC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4FB83B-F5C6-42BF-8F37-1F1829AF5F2B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50B5CB-7FF8-3A0D-F1AD-DFED7F463E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DE2EFCD-5B7E-26FF-716B-DD3F413AA7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577EC3-4412-4EA1-8638-AC5723B63E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345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C2E020F-4E97-4504-A843-F646643171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84F533-F86E-4919-BB17-5358B4DACF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4C6294-2F10-4CEE-90A6-B9A9C116A7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4B3C7D-5E6A-4982-BF43-D91B35461827}" type="datetimeFigureOut">
              <a:rPr kumimoji="1" lang="ja-JP" altLang="en-US" smtClean="0"/>
              <a:t>2025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CE8F52-07CA-4D23-BFC8-2B8CA813DD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6823798-54C8-40D5-A1A4-CB4300879D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43D95-8DC1-4C90-A2AA-B5215D51F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9061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BFF12D3-8F5D-DEB6-C661-282E12C7E3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1053" y="1271578"/>
            <a:ext cx="3149894" cy="325039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525E197-F6DE-A734-11EA-138F52BBA207}"/>
              </a:ext>
            </a:extLst>
          </p:cNvPr>
          <p:cNvSpPr txBox="1"/>
          <p:nvPr/>
        </p:nvSpPr>
        <p:spPr>
          <a:xfrm>
            <a:off x="2162432" y="5023327"/>
            <a:ext cx="839332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Map of the plasmid pBAD_Gdx used in this study.  </a:t>
            </a:r>
          </a:p>
          <a:p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4,831‑bp plasmid is derived from the pBAD24 backbone and carries the </a:t>
            </a:r>
            <a:r>
              <a:rPr lang="ja-JP" alt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x gene (Ec_gdx, yellow arrow) under the control of the arabinose‑inducible PBAD promoter.</a:t>
            </a:r>
          </a:p>
        </p:txBody>
      </p:sp>
    </p:spTree>
    <p:extLst>
      <p:ext uri="{BB962C8B-B14F-4D97-AF65-F5344CB8AC3E}">
        <p14:creationId xmlns:p14="http://schemas.microsoft.com/office/powerpoint/2010/main" val="3208200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1AF1624-BFA5-1A53-CC47-B56399DD4D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87495" y="1277629"/>
            <a:ext cx="4534263" cy="340069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4716B1B-1D3A-CEB7-A226-BE239651A9B9}"/>
              </a:ext>
            </a:extLst>
          </p:cNvPr>
          <p:cNvSpPr txBox="1"/>
          <p:nvPr/>
        </p:nvSpPr>
        <p:spPr>
          <a:xfrm>
            <a:off x="0" y="5147198"/>
            <a:ext cx="1190194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Structural model and membrane topology of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x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‑12. </a:t>
            </a:r>
          </a:p>
          <a:p>
            <a:pPr lvl="0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Predicted 3D structure of the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x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modimer generated using AlphaFold3, shown embedded in a schematic lipid bilayer (gray circles). Each protomer comprises four transmembrane helices, typical of SMR family transporters. The red circle and arrow indicate Glu13, a conserved residue proposed to be involved in binding of the substrates Gdm⁺. (B) Membrane topology prediction of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x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epTMHMM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dicating four transmembrane segments consistent with the AlphaFold3 structural model.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3A9D1A5-A8E4-4934-3537-D2E4F0D9F003}"/>
              </a:ext>
            </a:extLst>
          </p:cNvPr>
          <p:cNvSpPr txBox="1"/>
          <p:nvPr/>
        </p:nvSpPr>
        <p:spPr>
          <a:xfrm>
            <a:off x="1622306" y="984365"/>
            <a:ext cx="3693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3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endParaRPr kumimoji="1" lang="ja-JP" altLang="en-US" sz="3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FB1F4F0-1070-498C-B6D8-37EA610943F5}"/>
              </a:ext>
            </a:extLst>
          </p:cNvPr>
          <p:cNvSpPr txBox="1"/>
          <p:nvPr/>
        </p:nvSpPr>
        <p:spPr>
          <a:xfrm>
            <a:off x="6322032" y="984365"/>
            <a:ext cx="3693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3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endParaRPr kumimoji="1" lang="ja-JP" altLang="en-US" sz="3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14D62518-2A6C-D0D0-9BBD-9C299C216B22}"/>
              </a:ext>
            </a:extLst>
          </p:cNvPr>
          <p:cNvGrpSpPr/>
          <p:nvPr/>
        </p:nvGrpSpPr>
        <p:grpSpPr>
          <a:xfrm>
            <a:off x="2581262" y="1694929"/>
            <a:ext cx="3443080" cy="2983397"/>
            <a:chOff x="15760207" y="12941147"/>
            <a:chExt cx="3443080" cy="2983397"/>
          </a:xfrm>
        </p:grpSpPr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1669DFA4-C60C-6F5E-1864-9FB806BBFF32}"/>
                </a:ext>
              </a:extLst>
            </p:cNvPr>
            <p:cNvGrpSpPr/>
            <p:nvPr/>
          </p:nvGrpSpPr>
          <p:grpSpPr>
            <a:xfrm>
              <a:off x="15760207" y="12941147"/>
              <a:ext cx="3443080" cy="2831035"/>
              <a:chOff x="4254164" y="23939531"/>
              <a:chExt cx="4009736" cy="3381375"/>
            </a:xfrm>
          </p:grpSpPr>
          <p:pic>
            <p:nvPicPr>
              <p:cNvPr id="10" name="図 9">
                <a:extLst>
                  <a:ext uri="{FF2B5EF4-FFF2-40B4-BE49-F238E27FC236}">
                    <a16:creationId xmlns:a16="http://schemas.microsoft.com/office/drawing/2014/main" id="{B02FF562-571C-0619-1033-C5CE73CB2AE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254164" y="23939531"/>
                <a:ext cx="3105150" cy="3381375"/>
              </a:xfrm>
              <a:prstGeom prst="rect">
                <a:avLst/>
              </a:prstGeom>
            </p:spPr>
          </p:pic>
          <p:sp>
            <p:nvSpPr>
              <p:cNvPr id="11" name="楕円 10">
                <a:extLst>
                  <a:ext uri="{FF2B5EF4-FFF2-40B4-BE49-F238E27FC236}">
                    <a16:creationId xmlns:a16="http://schemas.microsoft.com/office/drawing/2014/main" id="{BA1C930D-48DD-D893-328F-487CAC2FD6AE}"/>
                  </a:ext>
                </a:extLst>
              </p:cNvPr>
              <p:cNvSpPr/>
              <p:nvPr/>
            </p:nvSpPr>
            <p:spPr>
              <a:xfrm>
                <a:off x="5676563" y="25432296"/>
                <a:ext cx="360000" cy="36000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2" name="直線矢印コネクタ 11">
                <a:extLst>
                  <a:ext uri="{FF2B5EF4-FFF2-40B4-BE49-F238E27FC236}">
                    <a16:creationId xmlns:a16="http://schemas.microsoft.com/office/drawing/2014/main" id="{3A532F1D-123A-E1F7-C935-9EA7AF413D68}"/>
                  </a:ext>
                </a:extLst>
              </p:cNvPr>
              <p:cNvCxnSpPr>
                <a:cxnSpLocks/>
                <a:stCxn id="13" idx="1"/>
              </p:cNvCxnSpPr>
              <p:nvPr/>
            </p:nvCxnSpPr>
            <p:spPr>
              <a:xfrm flipH="1">
                <a:off x="6073755" y="24882096"/>
                <a:ext cx="908893" cy="631183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497CFE73-7205-7D76-FCB5-F7E19EB6BAAD}"/>
                  </a:ext>
                </a:extLst>
              </p:cNvPr>
              <p:cNvSpPr txBox="1"/>
              <p:nvPr/>
            </p:nvSpPr>
            <p:spPr>
              <a:xfrm>
                <a:off x="6982647" y="24606391"/>
                <a:ext cx="1281253" cy="5514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2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u13</a:t>
                </a:r>
                <a:endParaRPr kumimoji="1" lang="ja-JP" altLang="en-US" sz="2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2EFA293B-6B3F-8159-D40A-42C269C6F384}"/>
                </a:ext>
              </a:extLst>
            </p:cNvPr>
            <p:cNvSpPr txBox="1"/>
            <p:nvPr/>
          </p:nvSpPr>
          <p:spPr>
            <a:xfrm>
              <a:off x="16040535" y="15524434"/>
              <a:ext cx="222129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dx</a:t>
              </a:r>
              <a:r>
                <a:rPr kumimoji="1" lang="en-US" altLang="ja-JP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-Homodimer</a:t>
              </a:r>
              <a:endParaRPr kumimoji="1" lang="ja-JP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4" name="図 13">
            <a:extLst>
              <a:ext uri="{FF2B5EF4-FFF2-40B4-BE49-F238E27FC236}">
                <a16:creationId xmlns:a16="http://schemas.microsoft.com/office/drawing/2014/main" id="{200EF68B-490F-169B-42B1-864BA04DE2E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91869" y="2568024"/>
            <a:ext cx="286537" cy="59746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7DF81927-A914-14D6-3C0B-C787124D68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05332" y="2568024"/>
            <a:ext cx="286537" cy="59746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006FD148-9928-F2BE-59C9-7892940268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18795" y="2568024"/>
            <a:ext cx="286537" cy="59746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070DD7C8-B370-AE9A-00A3-78D250C399E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58870" y="2625140"/>
            <a:ext cx="286537" cy="59746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03400519-C75C-2789-5C20-9583D59A898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72333" y="2625140"/>
            <a:ext cx="286537" cy="59746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6FFFA6B0-90B7-8778-44AB-D1E52BAAD6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85796" y="2625140"/>
            <a:ext cx="286537" cy="59746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0B60FF21-3EA1-04C2-D6EE-C56FFE242B2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2491869" y="3182096"/>
            <a:ext cx="286537" cy="597460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C65FE2BA-6F9E-6C81-2181-58A864D2FF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2205332" y="3182096"/>
            <a:ext cx="286537" cy="59746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0E12D929-8E89-4571-9801-31D630174D3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1918795" y="3182096"/>
            <a:ext cx="286537" cy="59746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10036B49-6A06-207D-2704-F7340C5F33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5458870" y="3239212"/>
            <a:ext cx="286537" cy="59746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E57E4E54-70F5-E740-B446-D575A74AF7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5172333" y="3239212"/>
            <a:ext cx="286537" cy="59746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D81790DA-773C-E9F9-5CB1-92365C53E2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0800000">
            <a:off x="4885796" y="3239212"/>
            <a:ext cx="286537" cy="597460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F3DD3E3-2053-06C9-CABF-170E6ACE402F}"/>
              </a:ext>
            </a:extLst>
          </p:cNvPr>
          <p:cNvSpPr txBox="1"/>
          <p:nvPr/>
        </p:nvSpPr>
        <p:spPr>
          <a:xfrm>
            <a:off x="1753418" y="2253253"/>
            <a:ext cx="1054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Outside</a:t>
            </a:r>
            <a:endParaRPr kumimoji="1" lang="ja-JP" altLang="en-US" b="1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EF25DEF-8F35-EB78-5723-FB18249EBA0D}"/>
              </a:ext>
            </a:extLst>
          </p:cNvPr>
          <p:cNvSpPr txBox="1"/>
          <p:nvPr/>
        </p:nvSpPr>
        <p:spPr>
          <a:xfrm>
            <a:off x="1911257" y="3779555"/>
            <a:ext cx="1054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In</a:t>
            </a:r>
            <a:r>
              <a:rPr kumimoji="1" lang="en-US" altLang="ja-JP" b="1" dirty="0"/>
              <a:t>side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23023362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051A49DE-97AE-4BD9-B0DA-38638E64C5FF}"/>
              </a:ext>
            </a:extLst>
          </p:cNvPr>
          <p:cNvGraphicFramePr>
            <a:graphicFrameLocks/>
          </p:cNvGraphicFramePr>
          <p:nvPr/>
        </p:nvGraphicFramePr>
        <p:xfrm>
          <a:off x="2301432" y="4"/>
          <a:ext cx="3794568" cy="54002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F5A472D5-4D2B-42B4-8C1B-8705884F97BE}"/>
              </a:ext>
            </a:extLst>
          </p:cNvPr>
          <p:cNvCxnSpPr>
            <a:cxnSpLocks/>
          </p:cNvCxnSpPr>
          <p:nvPr/>
        </p:nvCxnSpPr>
        <p:spPr>
          <a:xfrm>
            <a:off x="2952132" y="4556182"/>
            <a:ext cx="2493169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CDA1D3D-96F6-43B3-AFCC-2E5D58C9E5CB}"/>
              </a:ext>
            </a:extLst>
          </p:cNvPr>
          <p:cNvSpPr txBox="1"/>
          <p:nvPr/>
        </p:nvSpPr>
        <p:spPr>
          <a:xfrm>
            <a:off x="3409332" y="502818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</a:t>
            </a:r>
            <a:r>
              <a:rPr kumimoji="1" lang="en-US" altLang="ja-JP" sz="1800" b="1" i="0" u="none" strike="noStrike" kern="1200" cap="small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Ara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9DB8EAF-B409-4ED3-8286-4CFBE5F61A31}"/>
              </a:ext>
            </a:extLst>
          </p:cNvPr>
          <p:cNvSpPr txBox="1"/>
          <p:nvPr/>
        </p:nvSpPr>
        <p:spPr>
          <a:xfrm>
            <a:off x="4454701" y="502818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+</a:t>
            </a:r>
            <a:r>
              <a:rPr kumimoji="1" lang="en-US" altLang="ja-JP" sz="1800" b="1" i="0" u="none" strike="noStrike" kern="1200" cap="small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Ara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E4A1B80F-2068-4E59-8B82-F247CCE176FC}"/>
              </a:ext>
            </a:extLst>
          </p:cNvPr>
          <p:cNvGraphicFramePr>
            <a:graphicFrameLocks/>
          </p:cNvGraphicFramePr>
          <p:nvPr/>
        </p:nvGraphicFramePr>
        <p:xfrm>
          <a:off x="5912366" y="0"/>
          <a:ext cx="3794568" cy="54002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3B2C7992-B38F-4180-8401-365588E05A79}"/>
              </a:ext>
            </a:extLst>
          </p:cNvPr>
          <p:cNvCxnSpPr>
            <a:cxnSpLocks/>
          </p:cNvCxnSpPr>
          <p:nvPr/>
        </p:nvCxnSpPr>
        <p:spPr>
          <a:xfrm>
            <a:off x="6489080" y="4550625"/>
            <a:ext cx="2493169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A2DCF7D-1D10-4469-9FCD-D018A011A7AF}"/>
              </a:ext>
            </a:extLst>
          </p:cNvPr>
          <p:cNvSpPr txBox="1"/>
          <p:nvPr/>
        </p:nvSpPr>
        <p:spPr>
          <a:xfrm>
            <a:off x="6883482" y="502818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</a:t>
            </a:r>
            <a:r>
              <a:rPr kumimoji="1" lang="en-US" altLang="ja-JP" sz="1800" b="1" i="0" u="none" strike="noStrike" kern="1200" cap="small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Ara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6F71335-3AA2-4269-83DA-C72FE1E86C84}"/>
              </a:ext>
            </a:extLst>
          </p:cNvPr>
          <p:cNvSpPr txBox="1"/>
          <p:nvPr/>
        </p:nvSpPr>
        <p:spPr>
          <a:xfrm>
            <a:off x="7928851" y="502818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+</a:t>
            </a:r>
            <a:r>
              <a:rPr kumimoji="1" lang="en-US" altLang="ja-JP" sz="1800" b="1" i="0" u="none" strike="noStrike" kern="1200" cap="small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Ara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FF019CCF-A1FC-4A3D-3127-152B205FDF8A}"/>
              </a:ext>
            </a:extLst>
          </p:cNvPr>
          <p:cNvSpPr/>
          <p:nvPr/>
        </p:nvSpPr>
        <p:spPr>
          <a:xfrm>
            <a:off x="3946318" y="4851135"/>
            <a:ext cx="180000" cy="18000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3A08FFB3-8F47-B01D-6327-EA44A980FF24}"/>
              </a:ext>
            </a:extLst>
          </p:cNvPr>
          <p:cNvSpPr/>
          <p:nvPr/>
        </p:nvSpPr>
        <p:spPr>
          <a:xfrm>
            <a:off x="6096000" y="4850890"/>
            <a:ext cx="180000" cy="180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C0EB335-7B03-9ED4-9E16-15A338302AB5}"/>
              </a:ext>
            </a:extLst>
          </p:cNvPr>
          <p:cNvSpPr txBox="1"/>
          <p:nvPr/>
        </p:nvSpPr>
        <p:spPr>
          <a:xfrm>
            <a:off x="4126318" y="4756469"/>
            <a:ext cx="1969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ach1/pBAD24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4A5FBD9-63B3-610E-9C2E-08E11522D81F}"/>
              </a:ext>
            </a:extLst>
          </p:cNvPr>
          <p:cNvSpPr txBox="1"/>
          <p:nvPr/>
        </p:nvSpPr>
        <p:spPr>
          <a:xfrm>
            <a:off x="6276000" y="4756469"/>
            <a:ext cx="2243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ach1/</a:t>
            </a: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0956C3B-1ED1-9F24-0A80-4AB0562FD4BE}"/>
              </a:ext>
            </a:extLst>
          </p:cNvPr>
          <p:cNvSpPr txBox="1"/>
          <p:nvPr/>
        </p:nvSpPr>
        <p:spPr>
          <a:xfrm>
            <a:off x="0" y="5147198"/>
            <a:ext cx="12192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ure S3. Cesium resistance of </a:t>
            </a:r>
            <a:r>
              <a:rPr kumimoji="1" lang="en-US" altLang="ja-JP" sz="14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. coli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Mach1/pBAD24 and Mach1/</a:t>
            </a:r>
            <a:r>
              <a:rPr kumimoji="1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in the presence or absence of </a:t>
            </a:r>
            <a:r>
              <a:rPr kumimoji="1" lang="en-US" altLang="ja-JP" sz="14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arabinose.</a:t>
            </a:r>
            <a:b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</a:b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ar graphs represent OD₆₀₀ turbidity of </a:t>
            </a:r>
            <a:r>
              <a:rPr kumimoji="1" lang="en-US" altLang="ja-JP" sz="14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. coli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strains Mach1/pBAD24 (blue) and Mach1/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red) cultured under various cesium concentrations (mM), as indicated on the x-axis. The y-axis shows turbidity (OD₆₀₀) after 16 h of cultivation. “-</a:t>
            </a:r>
            <a:r>
              <a:rPr kumimoji="1" lang="en-US" altLang="ja-JP" sz="1400" b="0" i="0" u="none" strike="noStrike" kern="1200" cap="small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r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” and “+</a:t>
            </a:r>
            <a:r>
              <a:rPr kumimoji="1" lang="en-US" altLang="ja-JP" sz="1400" b="0" i="0" u="none" strike="noStrike" kern="1200" cap="small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r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” indicate conditions without and with 2% (w/v) </a:t>
            </a:r>
            <a:r>
              <a:rPr kumimoji="1" lang="en-US" altLang="ja-JP" sz="1400" b="0" i="0" u="none" strike="noStrike" kern="1200" cap="small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arabinose, respectively. Error bars represent the standard deviation of three independent experiments.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or Mach1/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pairwise comparisons between −</a:t>
            </a:r>
            <a:r>
              <a:rPr kumimoji="1" lang="en-US" altLang="ja-JP" sz="1400" b="0" i="0" u="none" strike="noStrike" kern="1200" cap="small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r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nd +</a:t>
            </a:r>
            <a:r>
              <a:rPr kumimoji="1" lang="en-US" altLang="ja-JP" sz="1400" b="0" i="0" u="none" strike="noStrike" kern="1200" cap="small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-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r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t 700 mM 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sCl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condition were assessed by two-sided Student’s t-test (n=3). 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6" name="右大かっこ 15">
            <a:extLst>
              <a:ext uri="{FF2B5EF4-FFF2-40B4-BE49-F238E27FC236}">
                <a16:creationId xmlns:a16="http://schemas.microsoft.com/office/drawing/2014/main" id="{DFCFAF2A-E964-BE47-17D9-EB5A93B2167B}"/>
              </a:ext>
            </a:extLst>
          </p:cNvPr>
          <p:cNvSpPr/>
          <p:nvPr/>
        </p:nvSpPr>
        <p:spPr>
          <a:xfrm rot="16200000">
            <a:off x="7935599" y="2699553"/>
            <a:ext cx="348018" cy="990600"/>
          </a:xfrm>
          <a:prstGeom prst="rightBracket">
            <a:avLst>
              <a:gd name="adj" fmla="val 0"/>
            </a:avLst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3358939-7855-891E-3C68-5247E4A196E5}"/>
              </a:ext>
            </a:extLst>
          </p:cNvPr>
          <p:cNvSpPr txBox="1"/>
          <p:nvPr/>
        </p:nvSpPr>
        <p:spPr>
          <a:xfrm>
            <a:off x="7533854" y="2593357"/>
            <a:ext cx="11515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 &lt; 0.001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43094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112B9A5-C1DB-A171-81C5-EBAAE71D8D72}"/>
              </a:ext>
            </a:extLst>
          </p:cNvPr>
          <p:cNvSpPr txBox="1"/>
          <p:nvPr/>
        </p:nvSpPr>
        <p:spPr>
          <a:xfrm>
            <a:off x="1789695" y="41814"/>
            <a:ext cx="19465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pBAD24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05658B2-8728-7DC8-F652-47F05068B512}"/>
              </a:ext>
            </a:extLst>
          </p:cNvPr>
          <p:cNvSpPr txBox="1"/>
          <p:nvPr/>
        </p:nvSpPr>
        <p:spPr>
          <a:xfrm>
            <a:off x="3708960" y="41814"/>
            <a:ext cx="2355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</a:t>
            </a: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7E8F122-0671-3CFE-DDB2-1FA95542FAEE}"/>
              </a:ext>
            </a:extLst>
          </p:cNvPr>
          <p:cNvSpPr txBox="1"/>
          <p:nvPr/>
        </p:nvSpPr>
        <p:spPr>
          <a:xfrm>
            <a:off x="254505" y="642586"/>
            <a:ext cx="133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0 mM Na</a:t>
            </a:r>
            <a:r>
              <a:rPr kumimoji="1" lang="en-US" altLang="ja-JP" sz="1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+</a:t>
            </a:r>
            <a:endParaRPr kumimoji="1" lang="ja-JP" altLang="en-US" sz="1800" b="1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AA86711-BCD3-D5FD-85B7-87921E2C1C11}"/>
              </a:ext>
            </a:extLst>
          </p:cNvPr>
          <p:cNvSpPr txBox="1"/>
          <p:nvPr/>
        </p:nvSpPr>
        <p:spPr>
          <a:xfrm>
            <a:off x="254505" y="1692398"/>
            <a:ext cx="13369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0 mM K</a:t>
            </a:r>
            <a:r>
              <a:rPr kumimoji="1" lang="en-US" altLang="ja-JP" sz="1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+</a:t>
            </a:r>
            <a:endParaRPr kumimoji="1" lang="ja-JP" altLang="en-US" sz="1800" b="1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BC68D8D-2769-5723-ED33-2ABCD014BB46}"/>
              </a:ext>
            </a:extLst>
          </p:cNvPr>
          <p:cNvSpPr txBox="1"/>
          <p:nvPr/>
        </p:nvSpPr>
        <p:spPr>
          <a:xfrm>
            <a:off x="254505" y="2741829"/>
            <a:ext cx="1544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0 mM Ca</a:t>
            </a:r>
            <a:r>
              <a:rPr kumimoji="1" lang="en-US" altLang="ja-JP" sz="1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2+</a:t>
            </a:r>
            <a:endParaRPr kumimoji="1" lang="ja-JP" altLang="en-US" sz="1800" b="1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6C9D258-5306-C45E-4F93-726E45AF45BF}"/>
              </a:ext>
            </a:extLst>
          </p:cNvPr>
          <p:cNvSpPr txBox="1"/>
          <p:nvPr/>
        </p:nvSpPr>
        <p:spPr>
          <a:xfrm>
            <a:off x="254505" y="4579314"/>
            <a:ext cx="1288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0 mM Cs</a:t>
            </a:r>
            <a:r>
              <a:rPr kumimoji="1" lang="en-US" altLang="ja-JP" sz="1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+</a:t>
            </a:r>
            <a:endParaRPr kumimoji="1" lang="ja-JP" altLang="en-US" sz="1800" b="1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F4651F5-1C78-303A-B89C-9F2082A4CD81}"/>
              </a:ext>
            </a:extLst>
          </p:cNvPr>
          <p:cNvSpPr txBox="1"/>
          <p:nvPr/>
        </p:nvSpPr>
        <p:spPr>
          <a:xfrm>
            <a:off x="254504" y="6157834"/>
            <a:ext cx="1544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0 mM Gdm</a:t>
            </a:r>
            <a:r>
              <a:rPr kumimoji="1" lang="en-US" altLang="ja-JP" sz="1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+</a:t>
            </a:r>
            <a:endParaRPr kumimoji="1" lang="ja-JP" altLang="en-US" sz="1800" b="1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9E58F917-1016-3639-FAFE-A9D93184DC65}"/>
              </a:ext>
            </a:extLst>
          </p:cNvPr>
          <p:cNvGrpSpPr/>
          <p:nvPr/>
        </p:nvGrpSpPr>
        <p:grpSpPr>
          <a:xfrm>
            <a:off x="5505148" y="5573736"/>
            <a:ext cx="935688" cy="953430"/>
            <a:chOff x="2601152" y="392573"/>
            <a:chExt cx="935688" cy="953430"/>
          </a:xfrm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503FCB9-73C9-9441-52EB-6C353CDA5933}"/>
                </a:ext>
              </a:extLst>
            </p:cNvPr>
            <p:cNvSpPr txBox="1"/>
            <p:nvPr/>
          </p:nvSpPr>
          <p:spPr>
            <a:xfrm rot="16200000">
              <a:off x="2602802" y="840519"/>
              <a:ext cx="3679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2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8EAD62C4-AC8B-CD11-2CBD-9B135A2BC44E}"/>
                </a:ext>
              </a:extLst>
            </p:cNvPr>
            <p:cNvSpPr txBox="1"/>
            <p:nvPr/>
          </p:nvSpPr>
          <p:spPr>
            <a:xfrm>
              <a:off x="2935705" y="1069004"/>
              <a:ext cx="601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1 min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0AFB77A5-3764-3A8E-E75C-C3BCE26B91A4}"/>
                </a:ext>
              </a:extLst>
            </p:cNvPr>
            <p:cNvCxnSpPr>
              <a:cxnSpLocks/>
            </p:cNvCxnSpPr>
            <p:nvPr/>
          </p:nvCxnSpPr>
          <p:spPr>
            <a:xfrm>
              <a:off x="2971422" y="577651"/>
              <a:ext cx="0" cy="4721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44C8DF07-8101-E7A4-9515-2D001A17E288}"/>
                </a:ext>
              </a:extLst>
            </p:cNvPr>
            <p:cNvCxnSpPr/>
            <p:nvPr/>
          </p:nvCxnSpPr>
          <p:spPr>
            <a:xfrm>
              <a:off x="2969546" y="1054246"/>
              <a:ext cx="495352" cy="0"/>
            </a:xfrm>
            <a:prstGeom prst="line">
              <a:avLst/>
            </a:prstGeom>
            <a:ln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97DEF001-B707-F840-9140-BD9849AA1F69}"/>
                </a:ext>
              </a:extLst>
            </p:cNvPr>
            <p:cNvSpPr txBox="1"/>
            <p:nvPr/>
          </p:nvSpPr>
          <p:spPr>
            <a:xfrm rot="10800000">
              <a:off x="2601152" y="392573"/>
              <a:ext cx="369332" cy="55072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游ゴシック" panose="020F0502020204030204"/>
                  <a:ea typeface="游ゴシック" panose="020B0400000000000000" pitchFamily="50" charset="-128"/>
                  <a:cs typeface="+mn-cs"/>
                </a:rPr>
                <a:t>%ΔQ</a:t>
              </a: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15" name="フリーフォーム: 図形 14">
            <a:extLst>
              <a:ext uri="{FF2B5EF4-FFF2-40B4-BE49-F238E27FC236}">
                <a16:creationId xmlns:a16="http://schemas.microsoft.com/office/drawing/2014/main" id="{B894CBA3-6198-0855-7A8E-6703583DE1C3}"/>
              </a:ext>
            </a:extLst>
          </p:cNvPr>
          <p:cNvSpPr/>
          <p:nvPr/>
        </p:nvSpPr>
        <p:spPr>
          <a:xfrm>
            <a:off x="1893938" y="829401"/>
            <a:ext cx="1152525" cy="85725"/>
          </a:xfrm>
          <a:custGeom>
            <a:avLst/>
            <a:gdLst>
              <a:gd name="connsiteX0" fmla="*/ 0 w 1152525"/>
              <a:gd name="connsiteY0" fmla="*/ 25400 h 85725"/>
              <a:gd name="connsiteX1" fmla="*/ 69850 w 1152525"/>
              <a:gd name="connsiteY1" fmla="*/ 28575 h 85725"/>
              <a:gd name="connsiteX2" fmla="*/ 95250 w 1152525"/>
              <a:gd name="connsiteY2" fmla="*/ 25400 h 85725"/>
              <a:gd name="connsiteX3" fmla="*/ 127000 w 1152525"/>
              <a:gd name="connsiteY3" fmla="*/ 22225 h 85725"/>
              <a:gd name="connsiteX4" fmla="*/ 155575 w 1152525"/>
              <a:gd name="connsiteY4" fmla="*/ 19050 h 85725"/>
              <a:gd name="connsiteX5" fmla="*/ 190500 w 1152525"/>
              <a:gd name="connsiteY5" fmla="*/ 15875 h 85725"/>
              <a:gd name="connsiteX6" fmla="*/ 314325 w 1152525"/>
              <a:gd name="connsiteY6" fmla="*/ 12700 h 85725"/>
              <a:gd name="connsiteX7" fmla="*/ 333375 w 1152525"/>
              <a:gd name="connsiteY7" fmla="*/ 6350 h 85725"/>
              <a:gd name="connsiteX8" fmla="*/ 396875 w 1152525"/>
              <a:gd name="connsiteY8" fmla="*/ 0 h 85725"/>
              <a:gd name="connsiteX9" fmla="*/ 441325 w 1152525"/>
              <a:gd name="connsiteY9" fmla="*/ 9525 h 85725"/>
              <a:gd name="connsiteX10" fmla="*/ 450850 w 1152525"/>
              <a:gd name="connsiteY10" fmla="*/ 41275 h 85725"/>
              <a:gd name="connsiteX11" fmla="*/ 479425 w 1152525"/>
              <a:gd name="connsiteY11" fmla="*/ 63500 h 85725"/>
              <a:gd name="connsiteX12" fmla="*/ 482600 w 1152525"/>
              <a:gd name="connsiteY12" fmla="*/ 73025 h 85725"/>
              <a:gd name="connsiteX13" fmla="*/ 514350 w 1152525"/>
              <a:gd name="connsiteY13" fmla="*/ 85725 h 85725"/>
              <a:gd name="connsiteX14" fmla="*/ 644525 w 1152525"/>
              <a:gd name="connsiteY14" fmla="*/ 82550 h 85725"/>
              <a:gd name="connsiteX15" fmla="*/ 679450 w 1152525"/>
              <a:gd name="connsiteY15" fmla="*/ 79375 h 85725"/>
              <a:gd name="connsiteX16" fmla="*/ 733425 w 1152525"/>
              <a:gd name="connsiteY16" fmla="*/ 66675 h 85725"/>
              <a:gd name="connsiteX17" fmla="*/ 809625 w 1152525"/>
              <a:gd name="connsiteY17" fmla="*/ 60325 h 85725"/>
              <a:gd name="connsiteX18" fmla="*/ 981075 w 1152525"/>
              <a:gd name="connsiteY18" fmla="*/ 53975 h 85725"/>
              <a:gd name="connsiteX19" fmla="*/ 993775 w 1152525"/>
              <a:gd name="connsiteY19" fmla="*/ 50800 h 85725"/>
              <a:gd name="connsiteX20" fmla="*/ 1066800 w 1152525"/>
              <a:gd name="connsiteY20" fmla="*/ 47625 h 85725"/>
              <a:gd name="connsiteX21" fmla="*/ 1152525 w 1152525"/>
              <a:gd name="connsiteY21" fmla="*/ 44450 h 857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1152525" h="85725">
                <a:moveTo>
                  <a:pt x="0" y="25400"/>
                </a:moveTo>
                <a:cubicBezTo>
                  <a:pt x="31776" y="38111"/>
                  <a:pt x="12818" y="33138"/>
                  <a:pt x="69850" y="28575"/>
                </a:cubicBezTo>
                <a:cubicBezTo>
                  <a:pt x="78355" y="27895"/>
                  <a:pt x="86770" y="26342"/>
                  <a:pt x="95250" y="25400"/>
                </a:cubicBezTo>
                <a:cubicBezTo>
                  <a:pt x="105821" y="24225"/>
                  <a:pt x="116422" y="23338"/>
                  <a:pt x="127000" y="22225"/>
                </a:cubicBezTo>
                <a:lnTo>
                  <a:pt x="155575" y="19050"/>
                </a:lnTo>
                <a:cubicBezTo>
                  <a:pt x="167207" y="17887"/>
                  <a:pt x="178820" y="16342"/>
                  <a:pt x="190500" y="15875"/>
                </a:cubicBezTo>
                <a:cubicBezTo>
                  <a:pt x="231756" y="14225"/>
                  <a:pt x="273050" y="13758"/>
                  <a:pt x="314325" y="12700"/>
                </a:cubicBezTo>
                <a:cubicBezTo>
                  <a:pt x="320675" y="10583"/>
                  <a:pt x="326881" y="7973"/>
                  <a:pt x="333375" y="6350"/>
                </a:cubicBezTo>
                <a:cubicBezTo>
                  <a:pt x="351350" y="1856"/>
                  <a:pt x="382295" y="1041"/>
                  <a:pt x="396875" y="0"/>
                </a:cubicBezTo>
                <a:cubicBezTo>
                  <a:pt x="411692" y="3175"/>
                  <a:pt x="428118" y="2096"/>
                  <a:pt x="441325" y="9525"/>
                </a:cubicBezTo>
                <a:cubicBezTo>
                  <a:pt x="453713" y="16493"/>
                  <a:pt x="443015" y="32657"/>
                  <a:pt x="450850" y="41275"/>
                </a:cubicBezTo>
                <a:cubicBezTo>
                  <a:pt x="458967" y="50204"/>
                  <a:pt x="479425" y="63500"/>
                  <a:pt x="479425" y="63500"/>
                </a:cubicBezTo>
                <a:cubicBezTo>
                  <a:pt x="480483" y="66675"/>
                  <a:pt x="480233" y="70658"/>
                  <a:pt x="482600" y="73025"/>
                </a:cubicBezTo>
                <a:cubicBezTo>
                  <a:pt x="487272" y="77697"/>
                  <a:pt x="510630" y="84485"/>
                  <a:pt x="514350" y="85725"/>
                </a:cubicBezTo>
                <a:lnTo>
                  <a:pt x="644525" y="82550"/>
                </a:lnTo>
                <a:cubicBezTo>
                  <a:pt x="656206" y="82101"/>
                  <a:pt x="667903" y="81198"/>
                  <a:pt x="679450" y="79375"/>
                </a:cubicBezTo>
                <a:cubicBezTo>
                  <a:pt x="710500" y="74472"/>
                  <a:pt x="700597" y="70654"/>
                  <a:pt x="733425" y="66675"/>
                </a:cubicBezTo>
                <a:cubicBezTo>
                  <a:pt x="758728" y="63608"/>
                  <a:pt x="784225" y="62442"/>
                  <a:pt x="809625" y="60325"/>
                </a:cubicBezTo>
                <a:cubicBezTo>
                  <a:pt x="878150" y="46620"/>
                  <a:pt x="802915" y="60698"/>
                  <a:pt x="981075" y="53975"/>
                </a:cubicBezTo>
                <a:cubicBezTo>
                  <a:pt x="985436" y="53810"/>
                  <a:pt x="989423" y="51122"/>
                  <a:pt x="993775" y="50800"/>
                </a:cubicBezTo>
                <a:cubicBezTo>
                  <a:pt x="1018073" y="49000"/>
                  <a:pt x="1042469" y="48906"/>
                  <a:pt x="1066800" y="47625"/>
                </a:cubicBezTo>
                <a:cubicBezTo>
                  <a:pt x="1143176" y="43605"/>
                  <a:pt x="1085680" y="44450"/>
                  <a:pt x="1152525" y="44450"/>
                </a:cubicBez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6" name="フリーフォーム: 図形 15">
            <a:extLst>
              <a:ext uri="{FF2B5EF4-FFF2-40B4-BE49-F238E27FC236}">
                <a16:creationId xmlns:a16="http://schemas.microsoft.com/office/drawing/2014/main" id="{2A8F59A8-001B-7782-9FA4-0D47B774516D}"/>
              </a:ext>
            </a:extLst>
          </p:cNvPr>
          <p:cNvSpPr/>
          <p:nvPr/>
        </p:nvSpPr>
        <p:spPr>
          <a:xfrm>
            <a:off x="3939316" y="842101"/>
            <a:ext cx="1082675" cy="73025"/>
          </a:xfrm>
          <a:custGeom>
            <a:avLst/>
            <a:gdLst>
              <a:gd name="connsiteX0" fmla="*/ 0 w 1082675"/>
              <a:gd name="connsiteY0" fmla="*/ 57150 h 73025"/>
              <a:gd name="connsiteX1" fmla="*/ 63500 w 1082675"/>
              <a:gd name="connsiteY1" fmla="*/ 50800 h 73025"/>
              <a:gd name="connsiteX2" fmla="*/ 85725 w 1082675"/>
              <a:gd name="connsiteY2" fmla="*/ 47625 h 73025"/>
              <a:gd name="connsiteX3" fmla="*/ 130175 w 1082675"/>
              <a:gd name="connsiteY3" fmla="*/ 44450 h 73025"/>
              <a:gd name="connsiteX4" fmla="*/ 155575 w 1082675"/>
              <a:gd name="connsiteY4" fmla="*/ 38100 h 73025"/>
              <a:gd name="connsiteX5" fmla="*/ 165100 w 1082675"/>
              <a:gd name="connsiteY5" fmla="*/ 34925 h 73025"/>
              <a:gd name="connsiteX6" fmla="*/ 190500 w 1082675"/>
              <a:gd name="connsiteY6" fmla="*/ 31750 h 73025"/>
              <a:gd name="connsiteX7" fmla="*/ 311150 w 1082675"/>
              <a:gd name="connsiteY7" fmla="*/ 25400 h 73025"/>
              <a:gd name="connsiteX8" fmla="*/ 352425 w 1082675"/>
              <a:gd name="connsiteY8" fmla="*/ 15875 h 73025"/>
              <a:gd name="connsiteX9" fmla="*/ 387350 w 1082675"/>
              <a:gd name="connsiteY9" fmla="*/ 9525 h 73025"/>
              <a:gd name="connsiteX10" fmla="*/ 409575 w 1082675"/>
              <a:gd name="connsiteY10" fmla="*/ 3175 h 73025"/>
              <a:gd name="connsiteX11" fmla="*/ 422275 w 1082675"/>
              <a:gd name="connsiteY11" fmla="*/ 0 h 73025"/>
              <a:gd name="connsiteX12" fmla="*/ 479425 w 1082675"/>
              <a:gd name="connsiteY12" fmla="*/ 3175 h 73025"/>
              <a:gd name="connsiteX13" fmla="*/ 495300 w 1082675"/>
              <a:gd name="connsiteY13" fmla="*/ 9525 h 73025"/>
              <a:gd name="connsiteX14" fmla="*/ 517525 w 1082675"/>
              <a:gd name="connsiteY14" fmla="*/ 12700 h 73025"/>
              <a:gd name="connsiteX15" fmla="*/ 530225 w 1082675"/>
              <a:gd name="connsiteY15" fmla="*/ 15875 h 73025"/>
              <a:gd name="connsiteX16" fmla="*/ 552450 w 1082675"/>
              <a:gd name="connsiteY16" fmla="*/ 31750 h 73025"/>
              <a:gd name="connsiteX17" fmla="*/ 571500 w 1082675"/>
              <a:gd name="connsiteY17" fmla="*/ 53975 h 73025"/>
              <a:gd name="connsiteX18" fmla="*/ 590550 w 1082675"/>
              <a:gd name="connsiteY18" fmla="*/ 60325 h 73025"/>
              <a:gd name="connsiteX19" fmla="*/ 663575 w 1082675"/>
              <a:gd name="connsiteY19" fmla="*/ 73025 h 73025"/>
              <a:gd name="connsiteX20" fmla="*/ 695325 w 1082675"/>
              <a:gd name="connsiteY20" fmla="*/ 66675 h 73025"/>
              <a:gd name="connsiteX21" fmla="*/ 752475 w 1082675"/>
              <a:gd name="connsiteY21" fmla="*/ 60325 h 73025"/>
              <a:gd name="connsiteX22" fmla="*/ 768350 w 1082675"/>
              <a:gd name="connsiteY22" fmla="*/ 63500 h 73025"/>
              <a:gd name="connsiteX23" fmla="*/ 911225 w 1082675"/>
              <a:gd name="connsiteY23" fmla="*/ 63500 h 73025"/>
              <a:gd name="connsiteX24" fmla="*/ 981075 w 1082675"/>
              <a:gd name="connsiteY24" fmla="*/ 57150 h 73025"/>
              <a:gd name="connsiteX25" fmla="*/ 1082675 w 1082675"/>
              <a:gd name="connsiteY25" fmla="*/ 53975 h 73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1082675" h="73025">
                <a:moveTo>
                  <a:pt x="0" y="57150"/>
                </a:moveTo>
                <a:cubicBezTo>
                  <a:pt x="72715" y="48061"/>
                  <a:pt x="-34884" y="61156"/>
                  <a:pt x="63500" y="50800"/>
                </a:cubicBezTo>
                <a:cubicBezTo>
                  <a:pt x="70942" y="50017"/>
                  <a:pt x="78275" y="48335"/>
                  <a:pt x="85725" y="47625"/>
                </a:cubicBezTo>
                <a:cubicBezTo>
                  <a:pt x="100513" y="46217"/>
                  <a:pt x="115358" y="45508"/>
                  <a:pt x="130175" y="44450"/>
                </a:cubicBezTo>
                <a:cubicBezTo>
                  <a:pt x="138642" y="42333"/>
                  <a:pt x="147296" y="40860"/>
                  <a:pt x="155575" y="38100"/>
                </a:cubicBezTo>
                <a:cubicBezTo>
                  <a:pt x="158750" y="37042"/>
                  <a:pt x="161807" y="35524"/>
                  <a:pt x="165100" y="34925"/>
                </a:cubicBezTo>
                <a:cubicBezTo>
                  <a:pt x="173495" y="33399"/>
                  <a:pt x="182014" y="32643"/>
                  <a:pt x="190500" y="31750"/>
                </a:cubicBezTo>
                <a:cubicBezTo>
                  <a:pt x="240563" y="26480"/>
                  <a:pt x="246373" y="27799"/>
                  <a:pt x="311150" y="25400"/>
                </a:cubicBezTo>
                <a:cubicBezTo>
                  <a:pt x="326790" y="21490"/>
                  <a:pt x="334183" y="19523"/>
                  <a:pt x="352425" y="15875"/>
                </a:cubicBezTo>
                <a:cubicBezTo>
                  <a:pt x="366579" y="13044"/>
                  <a:pt x="373729" y="12930"/>
                  <a:pt x="387350" y="9525"/>
                </a:cubicBezTo>
                <a:cubicBezTo>
                  <a:pt x="394825" y="7656"/>
                  <a:pt x="402142" y="5202"/>
                  <a:pt x="409575" y="3175"/>
                </a:cubicBezTo>
                <a:cubicBezTo>
                  <a:pt x="413785" y="2027"/>
                  <a:pt x="418042" y="1058"/>
                  <a:pt x="422275" y="0"/>
                </a:cubicBezTo>
                <a:cubicBezTo>
                  <a:pt x="441325" y="1058"/>
                  <a:pt x="460506" y="707"/>
                  <a:pt x="479425" y="3175"/>
                </a:cubicBezTo>
                <a:cubicBezTo>
                  <a:pt x="485076" y="3912"/>
                  <a:pt x="489771" y="8143"/>
                  <a:pt x="495300" y="9525"/>
                </a:cubicBezTo>
                <a:cubicBezTo>
                  <a:pt x="502560" y="11340"/>
                  <a:pt x="510162" y="11361"/>
                  <a:pt x="517525" y="12700"/>
                </a:cubicBezTo>
                <a:cubicBezTo>
                  <a:pt x="521818" y="13481"/>
                  <a:pt x="525992" y="14817"/>
                  <a:pt x="530225" y="15875"/>
                </a:cubicBezTo>
                <a:cubicBezTo>
                  <a:pt x="535633" y="19481"/>
                  <a:pt x="548512" y="27812"/>
                  <a:pt x="552450" y="31750"/>
                </a:cubicBezTo>
                <a:cubicBezTo>
                  <a:pt x="558198" y="37498"/>
                  <a:pt x="563724" y="49655"/>
                  <a:pt x="571500" y="53975"/>
                </a:cubicBezTo>
                <a:cubicBezTo>
                  <a:pt x="577351" y="57226"/>
                  <a:pt x="584398" y="57688"/>
                  <a:pt x="590550" y="60325"/>
                </a:cubicBezTo>
                <a:cubicBezTo>
                  <a:pt x="628370" y="76533"/>
                  <a:pt x="604731" y="69347"/>
                  <a:pt x="663575" y="73025"/>
                </a:cubicBezTo>
                <a:cubicBezTo>
                  <a:pt x="674158" y="70908"/>
                  <a:pt x="684623" y="68071"/>
                  <a:pt x="695325" y="66675"/>
                </a:cubicBezTo>
                <a:cubicBezTo>
                  <a:pt x="777869" y="55908"/>
                  <a:pt x="709034" y="69013"/>
                  <a:pt x="752475" y="60325"/>
                </a:cubicBezTo>
                <a:cubicBezTo>
                  <a:pt x="757767" y="61383"/>
                  <a:pt x="762969" y="63086"/>
                  <a:pt x="768350" y="63500"/>
                </a:cubicBezTo>
                <a:cubicBezTo>
                  <a:pt x="837668" y="68832"/>
                  <a:pt x="838788" y="66518"/>
                  <a:pt x="911225" y="63500"/>
                </a:cubicBezTo>
                <a:cubicBezTo>
                  <a:pt x="943957" y="58045"/>
                  <a:pt x="931897" y="59385"/>
                  <a:pt x="981075" y="57150"/>
                </a:cubicBezTo>
                <a:cubicBezTo>
                  <a:pt x="1054249" y="53824"/>
                  <a:pt x="1043172" y="53975"/>
                  <a:pt x="1082675" y="53975"/>
                </a:cubicBez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7" name="フリーフォーム: 図形 16">
            <a:extLst>
              <a:ext uri="{FF2B5EF4-FFF2-40B4-BE49-F238E27FC236}">
                <a16:creationId xmlns:a16="http://schemas.microsoft.com/office/drawing/2014/main" id="{43F2496E-EBC3-7DA2-A89D-0EB82B7282CC}"/>
              </a:ext>
            </a:extLst>
          </p:cNvPr>
          <p:cNvSpPr/>
          <p:nvPr/>
        </p:nvSpPr>
        <p:spPr>
          <a:xfrm>
            <a:off x="1893938" y="1488541"/>
            <a:ext cx="1140883" cy="467783"/>
          </a:xfrm>
          <a:custGeom>
            <a:avLst/>
            <a:gdLst>
              <a:gd name="connsiteX0" fmla="*/ 0 w 1140883"/>
              <a:gd name="connsiteY0" fmla="*/ 467783 h 467783"/>
              <a:gd name="connsiteX1" fmla="*/ 46566 w 1140883"/>
              <a:gd name="connsiteY1" fmla="*/ 463550 h 467783"/>
              <a:gd name="connsiteX2" fmla="*/ 57150 w 1140883"/>
              <a:gd name="connsiteY2" fmla="*/ 459317 h 467783"/>
              <a:gd name="connsiteX3" fmla="*/ 84666 w 1140883"/>
              <a:gd name="connsiteY3" fmla="*/ 457200 h 467783"/>
              <a:gd name="connsiteX4" fmla="*/ 95250 w 1140883"/>
              <a:gd name="connsiteY4" fmla="*/ 455083 h 467783"/>
              <a:gd name="connsiteX5" fmla="*/ 101600 w 1140883"/>
              <a:gd name="connsiteY5" fmla="*/ 452967 h 467783"/>
              <a:gd name="connsiteX6" fmla="*/ 139700 w 1140883"/>
              <a:gd name="connsiteY6" fmla="*/ 448733 h 467783"/>
              <a:gd name="connsiteX7" fmla="*/ 232833 w 1140883"/>
              <a:gd name="connsiteY7" fmla="*/ 448733 h 467783"/>
              <a:gd name="connsiteX8" fmla="*/ 294216 w 1140883"/>
              <a:gd name="connsiteY8" fmla="*/ 444500 h 467783"/>
              <a:gd name="connsiteX9" fmla="*/ 351366 w 1140883"/>
              <a:gd name="connsiteY9" fmla="*/ 440267 h 467783"/>
              <a:gd name="connsiteX10" fmla="*/ 361950 w 1140883"/>
              <a:gd name="connsiteY10" fmla="*/ 438150 h 467783"/>
              <a:gd name="connsiteX11" fmla="*/ 370416 w 1140883"/>
              <a:gd name="connsiteY11" fmla="*/ 436033 h 467783"/>
              <a:gd name="connsiteX12" fmla="*/ 402166 w 1140883"/>
              <a:gd name="connsiteY12" fmla="*/ 433917 h 467783"/>
              <a:gd name="connsiteX13" fmla="*/ 404283 w 1140883"/>
              <a:gd name="connsiteY13" fmla="*/ 427567 h 467783"/>
              <a:gd name="connsiteX14" fmla="*/ 408516 w 1140883"/>
              <a:gd name="connsiteY14" fmla="*/ 406400 h 467783"/>
              <a:gd name="connsiteX15" fmla="*/ 412750 w 1140883"/>
              <a:gd name="connsiteY15" fmla="*/ 395817 h 467783"/>
              <a:gd name="connsiteX16" fmla="*/ 421216 w 1140883"/>
              <a:gd name="connsiteY16" fmla="*/ 366183 h 467783"/>
              <a:gd name="connsiteX17" fmla="*/ 427566 w 1140883"/>
              <a:gd name="connsiteY17" fmla="*/ 359833 h 467783"/>
              <a:gd name="connsiteX18" fmla="*/ 433916 w 1140883"/>
              <a:gd name="connsiteY18" fmla="*/ 342900 h 467783"/>
              <a:gd name="connsiteX19" fmla="*/ 442383 w 1140883"/>
              <a:gd name="connsiteY19" fmla="*/ 323850 h 467783"/>
              <a:gd name="connsiteX20" fmla="*/ 444500 w 1140883"/>
              <a:gd name="connsiteY20" fmla="*/ 315383 h 467783"/>
              <a:gd name="connsiteX21" fmla="*/ 448733 w 1140883"/>
              <a:gd name="connsiteY21" fmla="*/ 309033 h 467783"/>
              <a:gd name="connsiteX22" fmla="*/ 450850 w 1140883"/>
              <a:gd name="connsiteY22" fmla="*/ 296333 h 467783"/>
              <a:gd name="connsiteX23" fmla="*/ 455083 w 1140883"/>
              <a:gd name="connsiteY23" fmla="*/ 285750 h 467783"/>
              <a:gd name="connsiteX24" fmla="*/ 459316 w 1140883"/>
              <a:gd name="connsiteY24" fmla="*/ 273050 h 467783"/>
              <a:gd name="connsiteX25" fmla="*/ 461433 w 1140883"/>
              <a:gd name="connsiteY25" fmla="*/ 266700 h 467783"/>
              <a:gd name="connsiteX26" fmla="*/ 463550 w 1140883"/>
              <a:gd name="connsiteY26" fmla="*/ 256117 h 467783"/>
              <a:gd name="connsiteX27" fmla="*/ 472016 w 1140883"/>
              <a:gd name="connsiteY27" fmla="*/ 241300 h 467783"/>
              <a:gd name="connsiteX28" fmla="*/ 474133 w 1140883"/>
              <a:gd name="connsiteY28" fmla="*/ 230717 h 467783"/>
              <a:gd name="connsiteX29" fmla="*/ 478366 w 1140883"/>
              <a:gd name="connsiteY29" fmla="*/ 224367 h 467783"/>
              <a:gd name="connsiteX30" fmla="*/ 480483 w 1140883"/>
              <a:gd name="connsiteY30" fmla="*/ 218017 h 467783"/>
              <a:gd name="connsiteX31" fmla="*/ 484716 w 1140883"/>
              <a:gd name="connsiteY31" fmla="*/ 209550 h 467783"/>
              <a:gd name="connsiteX32" fmla="*/ 491066 w 1140883"/>
              <a:gd name="connsiteY32" fmla="*/ 194733 h 467783"/>
              <a:gd name="connsiteX33" fmla="*/ 495300 w 1140883"/>
              <a:gd name="connsiteY33" fmla="*/ 190500 h 467783"/>
              <a:gd name="connsiteX34" fmla="*/ 499533 w 1140883"/>
              <a:gd name="connsiteY34" fmla="*/ 182033 h 467783"/>
              <a:gd name="connsiteX35" fmla="*/ 505883 w 1140883"/>
              <a:gd name="connsiteY35" fmla="*/ 171450 h 467783"/>
              <a:gd name="connsiteX36" fmla="*/ 508000 w 1140883"/>
              <a:gd name="connsiteY36" fmla="*/ 160867 h 467783"/>
              <a:gd name="connsiteX37" fmla="*/ 514350 w 1140883"/>
              <a:gd name="connsiteY37" fmla="*/ 152400 h 467783"/>
              <a:gd name="connsiteX38" fmla="*/ 518583 w 1140883"/>
              <a:gd name="connsiteY38" fmla="*/ 143933 h 467783"/>
              <a:gd name="connsiteX39" fmla="*/ 524933 w 1140883"/>
              <a:gd name="connsiteY39" fmla="*/ 137583 h 467783"/>
              <a:gd name="connsiteX40" fmla="*/ 533400 w 1140883"/>
              <a:gd name="connsiteY40" fmla="*/ 124883 h 467783"/>
              <a:gd name="connsiteX41" fmla="*/ 552450 w 1140883"/>
              <a:gd name="connsiteY41" fmla="*/ 101600 h 467783"/>
              <a:gd name="connsiteX42" fmla="*/ 567266 w 1140883"/>
              <a:gd name="connsiteY42" fmla="*/ 80433 h 467783"/>
              <a:gd name="connsiteX43" fmla="*/ 575733 w 1140883"/>
              <a:gd name="connsiteY43" fmla="*/ 74083 h 467783"/>
              <a:gd name="connsiteX44" fmla="*/ 590550 w 1140883"/>
              <a:gd name="connsiteY44" fmla="*/ 63500 h 467783"/>
              <a:gd name="connsiteX45" fmla="*/ 599016 w 1140883"/>
              <a:gd name="connsiteY45" fmla="*/ 57150 h 467783"/>
              <a:gd name="connsiteX46" fmla="*/ 603250 w 1140883"/>
              <a:gd name="connsiteY46" fmla="*/ 52917 h 467783"/>
              <a:gd name="connsiteX47" fmla="*/ 613833 w 1140883"/>
              <a:gd name="connsiteY47" fmla="*/ 48683 h 467783"/>
              <a:gd name="connsiteX48" fmla="*/ 618066 w 1140883"/>
              <a:gd name="connsiteY48" fmla="*/ 42333 h 467783"/>
              <a:gd name="connsiteX49" fmla="*/ 632883 w 1140883"/>
              <a:gd name="connsiteY49" fmla="*/ 35983 h 467783"/>
              <a:gd name="connsiteX50" fmla="*/ 639233 w 1140883"/>
              <a:gd name="connsiteY50" fmla="*/ 33867 h 467783"/>
              <a:gd name="connsiteX51" fmla="*/ 643466 w 1140883"/>
              <a:gd name="connsiteY51" fmla="*/ 29633 h 467783"/>
              <a:gd name="connsiteX52" fmla="*/ 651933 w 1140883"/>
              <a:gd name="connsiteY52" fmla="*/ 27517 h 467783"/>
              <a:gd name="connsiteX53" fmla="*/ 658283 w 1140883"/>
              <a:gd name="connsiteY53" fmla="*/ 25400 h 467783"/>
              <a:gd name="connsiteX54" fmla="*/ 666750 w 1140883"/>
              <a:gd name="connsiteY54" fmla="*/ 19050 h 467783"/>
              <a:gd name="connsiteX55" fmla="*/ 692150 w 1140883"/>
              <a:gd name="connsiteY55" fmla="*/ 14817 h 467783"/>
              <a:gd name="connsiteX56" fmla="*/ 728133 w 1140883"/>
              <a:gd name="connsiteY56" fmla="*/ 10583 h 467783"/>
              <a:gd name="connsiteX57" fmla="*/ 770466 w 1140883"/>
              <a:gd name="connsiteY57" fmla="*/ 8467 h 467783"/>
              <a:gd name="connsiteX58" fmla="*/ 812800 w 1140883"/>
              <a:gd name="connsiteY58" fmla="*/ 10583 h 467783"/>
              <a:gd name="connsiteX59" fmla="*/ 965200 w 1140883"/>
              <a:gd name="connsiteY59" fmla="*/ 6350 h 467783"/>
              <a:gd name="connsiteX60" fmla="*/ 982133 w 1140883"/>
              <a:gd name="connsiteY60" fmla="*/ 4233 h 467783"/>
              <a:gd name="connsiteX61" fmla="*/ 992716 w 1140883"/>
              <a:gd name="connsiteY61" fmla="*/ 2117 h 467783"/>
              <a:gd name="connsiteX62" fmla="*/ 1007533 w 1140883"/>
              <a:gd name="connsiteY62" fmla="*/ 0 h 467783"/>
              <a:gd name="connsiteX63" fmla="*/ 1083733 w 1140883"/>
              <a:gd name="connsiteY63" fmla="*/ 4233 h 467783"/>
              <a:gd name="connsiteX64" fmla="*/ 1140883 w 1140883"/>
              <a:gd name="connsiteY64" fmla="*/ 6350 h 4677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</a:cxnLst>
            <a:rect l="l" t="t" r="r" b="b"/>
            <a:pathLst>
              <a:path w="1140883" h="467783">
                <a:moveTo>
                  <a:pt x="0" y="467783"/>
                </a:moveTo>
                <a:cubicBezTo>
                  <a:pt x="4394" y="467469"/>
                  <a:pt x="37563" y="465628"/>
                  <a:pt x="46566" y="463550"/>
                </a:cubicBezTo>
                <a:cubicBezTo>
                  <a:pt x="50268" y="462696"/>
                  <a:pt x="53402" y="459942"/>
                  <a:pt x="57150" y="459317"/>
                </a:cubicBezTo>
                <a:cubicBezTo>
                  <a:pt x="66224" y="457805"/>
                  <a:pt x="75494" y="457906"/>
                  <a:pt x="84666" y="457200"/>
                </a:cubicBezTo>
                <a:cubicBezTo>
                  <a:pt x="88194" y="456494"/>
                  <a:pt x="91760" y="455956"/>
                  <a:pt x="95250" y="455083"/>
                </a:cubicBezTo>
                <a:cubicBezTo>
                  <a:pt x="97414" y="454542"/>
                  <a:pt x="99405" y="453366"/>
                  <a:pt x="101600" y="452967"/>
                </a:cubicBezTo>
                <a:cubicBezTo>
                  <a:pt x="108929" y="451635"/>
                  <a:pt x="133617" y="449341"/>
                  <a:pt x="139700" y="448733"/>
                </a:cubicBezTo>
                <a:cubicBezTo>
                  <a:pt x="180872" y="453880"/>
                  <a:pt x="155300" y="451552"/>
                  <a:pt x="232833" y="448733"/>
                </a:cubicBezTo>
                <a:cubicBezTo>
                  <a:pt x="304684" y="446120"/>
                  <a:pt x="246724" y="448019"/>
                  <a:pt x="294216" y="444500"/>
                </a:cubicBezTo>
                <a:cubicBezTo>
                  <a:pt x="362654" y="439430"/>
                  <a:pt x="303270" y="445075"/>
                  <a:pt x="351366" y="440267"/>
                </a:cubicBezTo>
                <a:cubicBezTo>
                  <a:pt x="354894" y="439561"/>
                  <a:pt x="358438" y="438931"/>
                  <a:pt x="361950" y="438150"/>
                </a:cubicBezTo>
                <a:cubicBezTo>
                  <a:pt x="364790" y="437519"/>
                  <a:pt x="367523" y="436337"/>
                  <a:pt x="370416" y="436033"/>
                </a:cubicBezTo>
                <a:cubicBezTo>
                  <a:pt x="380965" y="434923"/>
                  <a:pt x="391583" y="434622"/>
                  <a:pt x="402166" y="433917"/>
                </a:cubicBezTo>
                <a:cubicBezTo>
                  <a:pt x="402872" y="431800"/>
                  <a:pt x="403781" y="429741"/>
                  <a:pt x="404283" y="427567"/>
                </a:cubicBezTo>
                <a:cubicBezTo>
                  <a:pt x="405901" y="420556"/>
                  <a:pt x="405843" y="413081"/>
                  <a:pt x="408516" y="406400"/>
                </a:cubicBezTo>
                <a:lnTo>
                  <a:pt x="412750" y="395817"/>
                </a:lnTo>
                <a:cubicBezTo>
                  <a:pt x="414770" y="385718"/>
                  <a:pt x="415007" y="374876"/>
                  <a:pt x="421216" y="366183"/>
                </a:cubicBezTo>
                <a:cubicBezTo>
                  <a:pt x="422956" y="363747"/>
                  <a:pt x="425449" y="361950"/>
                  <a:pt x="427566" y="359833"/>
                </a:cubicBezTo>
                <a:cubicBezTo>
                  <a:pt x="432149" y="341506"/>
                  <a:pt x="426538" y="361345"/>
                  <a:pt x="433916" y="342900"/>
                </a:cubicBezTo>
                <a:cubicBezTo>
                  <a:pt x="441472" y="324010"/>
                  <a:pt x="434240" y="336066"/>
                  <a:pt x="442383" y="323850"/>
                </a:cubicBezTo>
                <a:cubicBezTo>
                  <a:pt x="443089" y="321028"/>
                  <a:pt x="443354" y="318057"/>
                  <a:pt x="444500" y="315383"/>
                </a:cubicBezTo>
                <a:cubicBezTo>
                  <a:pt x="445502" y="313045"/>
                  <a:pt x="447929" y="311446"/>
                  <a:pt x="448733" y="309033"/>
                </a:cubicBezTo>
                <a:cubicBezTo>
                  <a:pt x="450090" y="304961"/>
                  <a:pt x="449721" y="300474"/>
                  <a:pt x="450850" y="296333"/>
                </a:cubicBezTo>
                <a:cubicBezTo>
                  <a:pt x="451850" y="292667"/>
                  <a:pt x="453785" y="289321"/>
                  <a:pt x="455083" y="285750"/>
                </a:cubicBezTo>
                <a:cubicBezTo>
                  <a:pt x="456608" y="281556"/>
                  <a:pt x="457905" y="277283"/>
                  <a:pt x="459316" y="273050"/>
                </a:cubicBezTo>
                <a:cubicBezTo>
                  <a:pt x="460022" y="270933"/>
                  <a:pt x="460995" y="268888"/>
                  <a:pt x="461433" y="266700"/>
                </a:cubicBezTo>
                <a:cubicBezTo>
                  <a:pt x="462139" y="263172"/>
                  <a:pt x="462412" y="259530"/>
                  <a:pt x="463550" y="256117"/>
                </a:cubicBezTo>
                <a:cubicBezTo>
                  <a:pt x="465341" y="250745"/>
                  <a:pt x="468919" y="245946"/>
                  <a:pt x="472016" y="241300"/>
                </a:cubicBezTo>
                <a:cubicBezTo>
                  <a:pt x="472722" y="237772"/>
                  <a:pt x="472870" y="234085"/>
                  <a:pt x="474133" y="230717"/>
                </a:cubicBezTo>
                <a:cubicBezTo>
                  <a:pt x="475026" y="228335"/>
                  <a:pt x="477228" y="226642"/>
                  <a:pt x="478366" y="224367"/>
                </a:cubicBezTo>
                <a:cubicBezTo>
                  <a:pt x="479364" y="222371"/>
                  <a:pt x="479604" y="220068"/>
                  <a:pt x="480483" y="218017"/>
                </a:cubicBezTo>
                <a:cubicBezTo>
                  <a:pt x="481726" y="215117"/>
                  <a:pt x="483473" y="212450"/>
                  <a:pt x="484716" y="209550"/>
                </a:cubicBezTo>
                <a:cubicBezTo>
                  <a:pt x="488100" y="201653"/>
                  <a:pt x="485454" y="203150"/>
                  <a:pt x="491066" y="194733"/>
                </a:cubicBezTo>
                <a:cubicBezTo>
                  <a:pt x="492173" y="193073"/>
                  <a:pt x="493889" y="191911"/>
                  <a:pt x="495300" y="190500"/>
                </a:cubicBezTo>
                <a:cubicBezTo>
                  <a:pt x="496711" y="187678"/>
                  <a:pt x="498001" y="184791"/>
                  <a:pt x="499533" y="182033"/>
                </a:cubicBezTo>
                <a:cubicBezTo>
                  <a:pt x="501531" y="178437"/>
                  <a:pt x="504355" y="175270"/>
                  <a:pt x="505883" y="171450"/>
                </a:cubicBezTo>
                <a:cubicBezTo>
                  <a:pt x="507219" y="168110"/>
                  <a:pt x="506539" y="164154"/>
                  <a:pt x="508000" y="160867"/>
                </a:cubicBezTo>
                <a:cubicBezTo>
                  <a:pt x="509433" y="157643"/>
                  <a:pt x="512480" y="155392"/>
                  <a:pt x="514350" y="152400"/>
                </a:cubicBezTo>
                <a:cubicBezTo>
                  <a:pt x="516022" y="149724"/>
                  <a:pt x="516749" y="146501"/>
                  <a:pt x="518583" y="143933"/>
                </a:cubicBezTo>
                <a:cubicBezTo>
                  <a:pt x="520323" y="141497"/>
                  <a:pt x="523095" y="139946"/>
                  <a:pt x="524933" y="137583"/>
                </a:cubicBezTo>
                <a:cubicBezTo>
                  <a:pt x="528057" y="133567"/>
                  <a:pt x="530309" y="128925"/>
                  <a:pt x="533400" y="124883"/>
                </a:cubicBezTo>
                <a:cubicBezTo>
                  <a:pt x="539491" y="116917"/>
                  <a:pt x="546888" y="109944"/>
                  <a:pt x="552450" y="101600"/>
                </a:cubicBezTo>
                <a:cubicBezTo>
                  <a:pt x="553834" y="99524"/>
                  <a:pt x="564131" y="83568"/>
                  <a:pt x="567266" y="80433"/>
                </a:cubicBezTo>
                <a:cubicBezTo>
                  <a:pt x="569761" y="77938"/>
                  <a:pt x="573078" y="76406"/>
                  <a:pt x="575733" y="74083"/>
                </a:cubicBezTo>
                <a:cubicBezTo>
                  <a:pt x="588096" y="63267"/>
                  <a:pt x="579118" y="67311"/>
                  <a:pt x="590550" y="63500"/>
                </a:cubicBezTo>
                <a:cubicBezTo>
                  <a:pt x="593372" y="61383"/>
                  <a:pt x="596306" y="59408"/>
                  <a:pt x="599016" y="57150"/>
                </a:cubicBezTo>
                <a:cubicBezTo>
                  <a:pt x="600549" y="55872"/>
                  <a:pt x="601517" y="53907"/>
                  <a:pt x="603250" y="52917"/>
                </a:cubicBezTo>
                <a:cubicBezTo>
                  <a:pt x="606549" y="51032"/>
                  <a:pt x="610305" y="50094"/>
                  <a:pt x="613833" y="48683"/>
                </a:cubicBezTo>
                <a:cubicBezTo>
                  <a:pt x="615244" y="46566"/>
                  <a:pt x="616267" y="44132"/>
                  <a:pt x="618066" y="42333"/>
                </a:cubicBezTo>
                <a:cubicBezTo>
                  <a:pt x="623220" y="37179"/>
                  <a:pt x="626084" y="37925"/>
                  <a:pt x="632883" y="35983"/>
                </a:cubicBezTo>
                <a:cubicBezTo>
                  <a:pt x="635028" y="35370"/>
                  <a:pt x="637116" y="34572"/>
                  <a:pt x="639233" y="33867"/>
                </a:cubicBezTo>
                <a:cubicBezTo>
                  <a:pt x="640644" y="32456"/>
                  <a:pt x="641681" y="30526"/>
                  <a:pt x="643466" y="29633"/>
                </a:cubicBezTo>
                <a:cubicBezTo>
                  <a:pt x="646068" y="28332"/>
                  <a:pt x="649136" y="28316"/>
                  <a:pt x="651933" y="27517"/>
                </a:cubicBezTo>
                <a:cubicBezTo>
                  <a:pt x="654078" y="26904"/>
                  <a:pt x="656166" y="26106"/>
                  <a:pt x="658283" y="25400"/>
                </a:cubicBezTo>
                <a:cubicBezTo>
                  <a:pt x="661105" y="23283"/>
                  <a:pt x="663595" y="20628"/>
                  <a:pt x="666750" y="19050"/>
                </a:cubicBezTo>
                <a:cubicBezTo>
                  <a:pt x="671414" y="16718"/>
                  <a:pt x="690556" y="15016"/>
                  <a:pt x="692150" y="14817"/>
                </a:cubicBezTo>
                <a:cubicBezTo>
                  <a:pt x="708711" y="10676"/>
                  <a:pt x="700338" y="12267"/>
                  <a:pt x="728133" y="10583"/>
                </a:cubicBezTo>
                <a:cubicBezTo>
                  <a:pt x="742236" y="9728"/>
                  <a:pt x="756355" y="9172"/>
                  <a:pt x="770466" y="8467"/>
                </a:cubicBezTo>
                <a:cubicBezTo>
                  <a:pt x="784577" y="9172"/>
                  <a:pt x="798672" y="10737"/>
                  <a:pt x="812800" y="10583"/>
                </a:cubicBezTo>
                <a:cubicBezTo>
                  <a:pt x="863617" y="10031"/>
                  <a:pt x="965200" y="6350"/>
                  <a:pt x="965200" y="6350"/>
                </a:cubicBezTo>
                <a:cubicBezTo>
                  <a:pt x="970844" y="5644"/>
                  <a:pt x="976511" y="5098"/>
                  <a:pt x="982133" y="4233"/>
                </a:cubicBezTo>
                <a:cubicBezTo>
                  <a:pt x="985689" y="3686"/>
                  <a:pt x="989167" y="2708"/>
                  <a:pt x="992716" y="2117"/>
                </a:cubicBezTo>
                <a:cubicBezTo>
                  <a:pt x="997637" y="1297"/>
                  <a:pt x="1002594" y="706"/>
                  <a:pt x="1007533" y="0"/>
                </a:cubicBezTo>
                <a:lnTo>
                  <a:pt x="1083733" y="4233"/>
                </a:lnTo>
                <a:cubicBezTo>
                  <a:pt x="1127926" y="6406"/>
                  <a:pt x="1119807" y="6350"/>
                  <a:pt x="1140883" y="6350"/>
                </a:cubicBez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8" name="フリーフォーム: 図形 17">
            <a:extLst>
              <a:ext uri="{FF2B5EF4-FFF2-40B4-BE49-F238E27FC236}">
                <a16:creationId xmlns:a16="http://schemas.microsoft.com/office/drawing/2014/main" id="{73AB1C59-F5F3-CF0D-F74B-5A819350B4E9}"/>
              </a:ext>
            </a:extLst>
          </p:cNvPr>
          <p:cNvSpPr/>
          <p:nvPr/>
        </p:nvSpPr>
        <p:spPr>
          <a:xfrm>
            <a:off x="3964259" y="1601067"/>
            <a:ext cx="922338" cy="358828"/>
          </a:xfrm>
          <a:custGeom>
            <a:avLst/>
            <a:gdLst>
              <a:gd name="connsiteX0" fmla="*/ 0 w 922338"/>
              <a:gd name="connsiteY0" fmla="*/ 349303 h 358828"/>
              <a:gd name="connsiteX1" fmla="*/ 31750 w 922338"/>
              <a:gd name="connsiteY1" fmla="*/ 349303 h 358828"/>
              <a:gd name="connsiteX2" fmla="*/ 96838 w 922338"/>
              <a:gd name="connsiteY2" fmla="*/ 347716 h 358828"/>
              <a:gd name="connsiteX3" fmla="*/ 169863 w 922338"/>
              <a:gd name="connsiteY3" fmla="*/ 347716 h 358828"/>
              <a:gd name="connsiteX4" fmla="*/ 184150 w 922338"/>
              <a:gd name="connsiteY4" fmla="*/ 350891 h 358828"/>
              <a:gd name="connsiteX5" fmla="*/ 211138 w 922338"/>
              <a:gd name="connsiteY5" fmla="*/ 358828 h 358828"/>
              <a:gd name="connsiteX6" fmla="*/ 242888 w 922338"/>
              <a:gd name="connsiteY6" fmla="*/ 357241 h 358828"/>
              <a:gd name="connsiteX7" fmla="*/ 274638 w 922338"/>
              <a:gd name="connsiteY7" fmla="*/ 354066 h 358828"/>
              <a:gd name="connsiteX8" fmla="*/ 280988 w 922338"/>
              <a:gd name="connsiteY8" fmla="*/ 344541 h 358828"/>
              <a:gd name="connsiteX9" fmla="*/ 282575 w 922338"/>
              <a:gd name="connsiteY9" fmla="*/ 333428 h 358828"/>
              <a:gd name="connsiteX10" fmla="*/ 285750 w 922338"/>
              <a:gd name="connsiteY10" fmla="*/ 327078 h 358828"/>
              <a:gd name="connsiteX11" fmla="*/ 288925 w 922338"/>
              <a:gd name="connsiteY11" fmla="*/ 315966 h 358828"/>
              <a:gd name="connsiteX12" fmla="*/ 296863 w 922338"/>
              <a:gd name="connsiteY12" fmla="*/ 303266 h 358828"/>
              <a:gd name="connsiteX13" fmla="*/ 301625 w 922338"/>
              <a:gd name="connsiteY13" fmla="*/ 300091 h 358828"/>
              <a:gd name="connsiteX14" fmla="*/ 304800 w 922338"/>
              <a:gd name="connsiteY14" fmla="*/ 288978 h 358828"/>
              <a:gd name="connsiteX15" fmla="*/ 311150 w 922338"/>
              <a:gd name="connsiteY15" fmla="*/ 281041 h 358828"/>
              <a:gd name="connsiteX16" fmla="*/ 328613 w 922338"/>
              <a:gd name="connsiteY16" fmla="*/ 258816 h 358828"/>
              <a:gd name="connsiteX17" fmla="*/ 333375 w 922338"/>
              <a:gd name="connsiteY17" fmla="*/ 247703 h 358828"/>
              <a:gd name="connsiteX18" fmla="*/ 338138 w 922338"/>
              <a:gd name="connsiteY18" fmla="*/ 239766 h 358828"/>
              <a:gd name="connsiteX19" fmla="*/ 342900 w 922338"/>
              <a:gd name="connsiteY19" fmla="*/ 227066 h 358828"/>
              <a:gd name="connsiteX20" fmla="*/ 349250 w 922338"/>
              <a:gd name="connsiteY20" fmla="*/ 219128 h 358828"/>
              <a:gd name="connsiteX21" fmla="*/ 354013 w 922338"/>
              <a:gd name="connsiteY21" fmla="*/ 208016 h 358828"/>
              <a:gd name="connsiteX22" fmla="*/ 357188 w 922338"/>
              <a:gd name="connsiteY22" fmla="*/ 201666 h 358828"/>
              <a:gd name="connsiteX23" fmla="*/ 366713 w 922338"/>
              <a:gd name="connsiteY23" fmla="*/ 179441 h 358828"/>
              <a:gd name="connsiteX24" fmla="*/ 376238 w 922338"/>
              <a:gd name="connsiteY24" fmla="*/ 154041 h 358828"/>
              <a:gd name="connsiteX25" fmla="*/ 382588 w 922338"/>
              <a:gd name="connsiteY25" fmla="*/ 142928 h 358828"/>
              <a:gd name="connsiteX26" fmla="*/ 393700 w 922338"/>
              <a:gd name="connsiteY26" fmla="*/ 122291 h 358828"/>
              <a:gd name="connsiteX27" fmla="*/ 396875 w 922338"/>
              <a:gd name="connsiteY27" fmla="*/ 114353 h 358828"/>
              <a:gd name="connsiteX28" fmla="*/ 403225 w 922338"/>
              <a:gd name="connsiteY28" fmla="*/ 103241 h 358828"/>
              <a:gd name="connsiteX29" fmla="*/ 409575 w 922338"/>
              <a:gd name="connsiteY29" fmla="*/ 100066 h 358828"/>
              <a:gd name="connsiteX30" fmla="*/ 419100 w 922338"/>
              <a:gd name="connsiteY30" fmla="*/ 87366 h 358828"/>
              <a:gd name="connsiteX31" fmla="*/ 425450 w 922338"/>
              <a:gd name="connsiteY31" fmla="*/ 79428 h 358828"/>
              <a:gd name="connsiteX32" fmla="*/ 436563 w 922338"/>
              <a:gd name="connsiteY32" fmla="*/ 68316 h 358828"/>
              <a:gd name="connsiteX33" fmla="*/ 447675 w 922338"/>
              <a:gd name="connsiteY33" fmla="*/ 50853 h 358828"/>
              <a:gd name="connsiteX34" fmla="*/ 452438 w 922338"/>
              <a:gd name="connsiteY34" fmla="*/ 39741 h 358828"/>
              <a:gd name="connsiteX35" fmla="*/ 460375 w 922338"/>
              <a:gd name="connsiteY35" fmla="*/ 31803 h 358828"/>
              <a:gd name="connsiteX36" fmla="*/ 465138 w 922338"/>
              <a:gd name="connsiteY36" fmla="*/ 25453 h 358828"/>
              <a:gd name="connsiteX37" fmla="*/ 469900 w 922338"/>
              <a:gd name="connsiteY37" fmla="*/ 22278 h 358828"/>
              <a:gd name="connsiteX38" fmla="*/ 476250 w 922338"/>
              <a:gd name="connsiteY38" fmla="*/ 17516 h 358828"/>
              <a:gd name="connsiteX39" fmla="*/ 482600 w 922338"/>
              <a:gd name="connsiteY39" fmla="*/ 14341 h 358828"/>
              <a:gd name="connsiteX40" fmla="*/ 495300 w 922338"/>
              <a:gd name="connsiteY40" fmla="*/ 9578 h 358828"/>
              <a:gd name="connsiteX41" fmla="*/ 501650 w 922338"/>
              <a:gd name="connsiteY41" fmla="*/ 7991 h 358828"/>
              <a:gd name="connsiteX42" fmla="*/ 509588 w 922338"/>
              <a:gd name="connsiteY42" fmla="*/ 3228 h 358828"/>
              <a:gd name="connsiteX43" fmla="*/ 552450 w 922338"/>
              <a:gd name="connsiteY43" fmla="*/ 4816 h 358828"/>
              <a:gd name="connsiteX44" fmla="*/ 577850 w 922338"/>
              <a:gd name="connsiteY44" fmla="*/ 6403 h 358828"/>
              <a:gd name="connsiteX45" fmla="*/ 615950 w 922338"/>
              <a:gd name="connsiteY45" fmla="*/ 11166 h 358828"/>
              <a:gd name="connsiteX46" fmla="*/ 635000 w 922338"/>
              <a:gd name="connsiteY46" fmla="*/ 17516 h 358828"/>
              <a:gd name="connsiteX47" fmla="*/ 676275 w 922338"/>
              <a:gd name="connsiteY47" fmla="*/ 27041 h 358828"/>
              <a:gd name="connsiteX48" fmla="*/ 687388 w 922338"/>
              <a:gd name="connsiteY48" fmla="*/ 28628 h 358828"/>
              <a:gd name="connsiteX49" fmla="*/ 693738 w 922338"/>
              <a:gd name="connsiteY49" fmla="*/ 30216 h 358828"/>
              <a:gd name="connsiteX50" fmla="*/ 714375 w 922338"/>
              <a:gd name="connsiteY50" fmla="*/ 31803 h 358828"/>
              <a:gd name="connsiteX51" fmla="*/ 731838 w 922338"/>
              <a:gd name="connsiteY51" fmla="*/ 34978 h 358828"/>
              <a:gd name="connsiteX52" fmla="*/ 769938 w 922338"/>
              <a:gd name="connsiteY52" fmla="*/ 39741 h 358828"/>
              <a:gd name="connsiteX53" fmla="*/ 781050 w 922338"/>
              <a:gd name="connsiteY53" fmla="*/ 41328 h 358828"/>
              <a:gd name="connsiteX54" fmla="*/ 787400 w 922338"/>
              <a:gd name="connsiteY54" fmla="*/ 42916 h 358828"/>
              <a:gd name="connsiteX55" fmla="*/ 796925 w 922338"/>
              <a:gd name="connsiteY55" fmla="*/ 44503 h 358828"/>
              <a:gd name="connsiteX56" fmla="*/ 814388 w 922338"/>
              <a:gd name="connsiteY56" fmla="*/ 50853 h 358828"/>
              <a:gd name="connsiteX57" fmla="*/ 820738 w 922338"/>
              <a:gd name="connsiteY57" fmla="*/ 54028 h 358828"/>
              <a:gd name="connsiteX58" fmla="*/ 898525 w 922338"/>
              <a:gd name="connsiteY58" fmla="*/ 58791 h 358828"/>
              <a:gd name="connsiteX59" fmla="*/ 917575 w 922338"/>
              <a:gd name="connsiteY59" fmla="*/ 65141 h 358828"/>
              <a:gd name="connsiteX60" fmla="*/ 922338 w 922338"/>
              <a:gd name="connsiteY60" fmla="*/ 65141 h 3588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</a:cxnLst>
            <a:rect l="l" t="t" r="r" b="b"/>
            <a:pathLst>
              <a:path w="922338" h="358828">
                <a:moveTo>
                  <a:pt x="0" y="349303"/>
                </a:moveTo>
                <a:cubicBezTo>
                  <a:pt x="17040" y="356119"/>
                  <a:pt x="428" y="350981"/>
                  <a:pt x="31750" y="349303"/>
                </a:cubicBezTo>
                <a:cubicBezTo>
                  <a:pt x="53421" y="348142"/>
                  <a:pt x="75142" y="348245"/>
                  <a:pt x="96838" y="347716"/>
                </a:cubicBezTo>
                <a:cubicBezTo>
                  <a:pt x="126252" y="343513"/>
                  <a:pt x="115990" y="344349"/>
                  <a:pt x="169863" y="347716"/>
                </a:cubicBezTo>
                <a:cubicBezTo>
                  <a:pt x="174732" y="348020"/>
                  <a:pt x="179396" y="349794"/>
                  <a:pt x="184150" y="350891"/>
                </a:cubicBezTo>
                <a:cubicBezTo>
                  <a:pt x="194161" y="353201"/>
                  <a:pt x="199375" y="355209"/>
                  <a:pt x="211138" y="358828"/>
                </a:cubicBezTo>
                <a:lnTo>
                  <a:pt x="242888" y="357241"/>
                </a:lnTo>
                <a:cubicBezTo>
                  <a:pt x="271054" y="355719"/>
                  <a:pt x="261417" y="358471"/>
                  <a:pt x="274638" y="354066"/>
                </a:cubicBezTo>
                <a:cubicBezTo>
                  <a:pt x="276755" y="350891"/>
                  <a:pt x="279618" y="348103"/>
                  <a:pt x="280988" y="344541"/>
                </a:cubicBezTo>
                <a:cubicBezTo>
                  <a:pt x="282331" y="341048"/>
                  <a:pt x="281591" y="337038"/>
                  <a:pt x="282575" y="333428"/>
                </a:cubicBezTo>
                <a:cubicBezTo>
                  <a:pt x="283198" y="331145"/>
                  <a:pt x="284941" y="329302"/>
                  <a:pt x="285750" y="327078"/>
                </a:cubicBezTo>
                <a:cubicBezTo>
                  <a:pt x="287067" y="323458"/>
                  <a:pt x="287608" y="319586"/>
                  <a:pt x="288925" y="315966"/>
                </a:cubicBezTo>
                <a:cubicBezTo>
                  <a:pt x="290363" y="312013"/>
                  <a:pt x="293946" y="306183"/>
                  <a:pt x="296863" y="303266"/>
                </a:cubicBezTo>
                <a:cubicBezTo>
                  <a:pt x="298212" y="301917"/>
                  <a:pt x="300038" y="301149"/>
                  <a:pt x="301625" y="300091"/>
                </a:cubicBezTo>
                <a:cubicBezTo>
                  <a:pt x="302683" y="296387"/>
                  <a:pt x="303077" y="292424"/>
                  <a:pt x="304800" y="288978"/>
                </a:cubicBezTo>
                <a:cubicBezTo>
                  <a:pt x="306315" y="285948"/>
                  <a:pt x="309271" y="283860"/>
                  <a:pt x="311150" y="281041"/>
                </a:cubicBezTo>
                <a:cubicBezTo>
                  <a:pt x="324574" y="260905"/>
                  <a:pt x="308988" y="278439"/>
                  <a:pt x="328613" y="258816"/>
                </a:cubicBezTo>
                <a:cubicBezTo>
                  <a:pt x="330200" y="255112"/>
                  <a:pt x="331573" y="251308"/>
                  <a:pt x="333375" y="247703"/>
                </a:cubicBezTo>
                <a:cubicBezTo>
                  <a:pt x="334755" y="244943"/>
                  <a:pt x="336845" y="242567"/>
                  <a:pt x="338138" y="239766"/>
                </a:cubicBezTo>
                <a:cubicBezTo>
                  <a:pt x="340033" y="235661"/>
                  <a:pt x="340757" y="231047"/>
                  <a:pt x="342900" y="227066"/>
                </a:cubicBezTo>
                <a:cubicBezTo>
                  <a:pt x="344506" y="224083"/>
                  <a:pt x="347543" y="222055"/>
                  <a:pt x="349250" y="219128"/>
                </a:cubicBezTo>
                <a:cubicBezTo>
                  <a:pt x="351281" y="215647"/>
                  <a:pt x="352345" y="211685"/>
                  <a:pt x="354013" y="208016"/>
                </a:cubicBezTo>
                <a:cubicBezTo>
                  <a:pt x="354992" y="205862"/>
                  <a:pt x="356196" y="203815"/>
                  <a:pt x="357188" y="201666"/>
                </a:cubicBezTo>
                <a:cubicBezTo>
                  <a:pt x="359275" y="197143"/>
                  <a:pt x="364565" y="185454"/>
                  <a:pt x="366713" y="179441"/>
                </a:cubicBezTo>
                <a:cubicBezTo>
                  <a:pt x="370765" y="168096"/>
                  <a:pt x="371090" y="164336"/>
                  <a:pt x="376238" y="154041"/>
                </a:cubicBezTo>
                <a:cubicBezTo>
                  <a:pt x="378146" y="150225"/>
                  <a:pt x="380532" y="146666"/>
                  <a:pt x="382588" y="142928"/>
                </a:cubicBezTo>
                <a:cubicBezTo>
                  <a:pt x="386353" y="136082"/>
                  <a:pt x="390799" y="129545"/>
                  <a:pt x="393700" y="122291"/>
                </a:cubicBezTo>
                <a:cubicBezTo>
                  <a:pt x="394758" y="119645"/>
                  <a:pt x="395601" y="116902"/>
                  <a:pt x="396875" y="114353"/>
                </a:cubicBezTo>
                <a:cubicBezTo>
                  <a:pt x="398783" y="110537"/>
                  <a:pt x="400391" y="106429"/>
                  <a:pt x="403225" y="103241"/>
                </a:cubicBezTo>
                <a:cubicBezTo>
                  <a:pt x="404797" y="101472"/>
                  <a:pt x="407458" y="101124"/>
                  <a:pt x="409575" y="100066"/>
                </a:cubicBezTo>
                <a:cubicBezTo>
                  <a:pt x="414995" y="89226"/>
                  <a:pt x="409930" y="97683"/>
                  <a:pt x="419100" y="87366"/>
                </a:cubicBezTo>
                <a:cubicBezTo>
                  <a:pt x="421351" y="84833"/>
                  <a:pt x="423054" y="81824"/>
                  <a:pt x="425450" y="79428"/>
                </a:cubicBezTo>
                <a:cubicBezTo>
                  <a:pt x="437446" y="67432"/>
                  <a:pt x="426683" y="82429"/>
                  <a:pt x="436563" y="68316"/>
                </a:cubicBezTo>
                <a:cubicBezTo>
                  <a:pt x="438769" y="65164"/>
                  <a:pt x="445685" y="54834"/>
                  <a:pt x="447675" y="50853"/>
                </a:cubicBezTo>
                <a:cubicBezTo>
                  <a:pt x="449477" y="47249"/>
                  <a:pt x="450203" y="43094"/>
                  <a:pt x="452438" y="39741"/>
                </a:cubicBezTo>
                <a:cubicBezTo>
                  <a:pt x="454514" y="36628"/>
                  <a:pt x="457889" y="34600"/>
                  <a:pt x="460375" y="31803"/>
                </a:cubicBezTo>
                <a:cubicBezTo>
                  <a:pt x="462133" y="29825"/>
                  <a:pt x="463267" y="27324"/>
                  <a:pt x="465138" y="25453"/>
                </a:cubicBezTo>
                <a:cubicBezTo>
                  <a:pt x="466487" y="24104"/>
                  <a:pt x="468348" y="23387"/>
                  <a:pt x="469900" y="22278"/>
                </a:cubicBezTo>
                <a:cubicBezTo>
                  <a:pt x="472053" y="20740"/>
                  <a:pt x="474006" y="18918"/>
                  <a:pt x="476250" y="17516"/>
                </a:cubicBezTo>
                <a:cubicBezTo>
                  <a:pt x="478257" y="16262"/>
                  <a:pt x="480437" y="15302"/>
                  <a:pt x="482600" y="14341"/>
                </a:cubicBezTo>
                <a:cubicBezTo>
                  <a:pt x="485608" y="13004"/>
                  <a:pt x="491642" y="10623"/>
                  <a:pt x="495300" y="9578"/>
                </a:cubicBezTo>
                <a:cubicBezTo>
                  <a:pt x="497398" y="8979"/>
                  <a:pt x="499533" y="8520"/>
                  <a:pt x="501650" y="7991"/>
                </a:cubicBezTo>
                <a:cubicBezTo>
                  <a:pt x="504296" y="6403"/>
                  <a:pt x="506643" y="4148"/>
                  <a:pt x="509588" y="3228"/>
                </a:cubicBezTo>
                <a:cubicBezTo>
                  <a:pt x="530841" y="-3414"/>
                  <a:pt x="528056" y="1767"/>
                  <a:pt x="552450" y="4816"/>
                </a:cubicBezTo>
                <a:cubicBezTo>
                  <a:pt x="560868" y="5868"/>
                  <a:pt x="569388" y="5799"/>
                  <a:pt x="577850" y="6403"/>
                </a:cubicBezTo>
                <a:cubicBezTo>
                  <a:pt x="600125" y="7994"/>
                  <a:pt x="593838" y="7481"/>
                  <a:pt x="615950" y="11166"/>
                </a:cubicBezTo>
                <a:cubicBezTo>
                  <a:pt x="628924" y="16355"/>
                  <a:pt x="619175" y="12769"/>
                  <a:pt x="635000" y="17516"/>
                </a:cubicBezTo>
                <a:cubicBezTo>
                  <a:pt x="652651" y="22811"/>
                  <a:pt x="630150" y="20454"/>
                  <a:pt x="676275" y="27041"/>
                </a:cubicBezTo>
                <a:cubicBezTo>
                  <a:pt x="679979" y="27570"/>
                  <a:pt x="683706" y="27959"/>
                  <a:pt x="687388" y="28628"/>
                </a:cubicBezTo>
                <a:cubicBezTo>
                  <a:pt x="689535" y="29018"/>
                  <a:pt x="691571" y="29961"/>
                  <a:pt x="693738" y="30216"/>
                </a:cubicBezTo>
                <a:cubicBezTo>
                  <a:pt x="700590" y="31022"/>
                  <a:pt x="707496" y="31274"/>
                  <a:pt x="714375" y="31803"/>
                </a:cubicBezTo>
                <a:cubicBezTo>
                  <a:pt x="720196" y="32861"/>
                  <a:pt x="725981" y="34141"/>
                  <a:pt x="731838" y="34978"/>
                </a:cubicBezTo>
                <a:cubicBezTo>
                  <a:pt x="744508" y="36788"/>
                  <a:pt x="757244" y="38103"/>
                  <a:pt x="769938" y="39741"/>
                </a:cubicBezTo>
                <a:cubicBezTo>
                  <a:pt x="773649" y="40220"/>
                  <a:pt x="777369" y="40659"/>
                  <a:pt x="781050" y="41328"/>
                </a:cubicBezTo>
                <a:cubicBezTo>
                  <a:pt x="783197" y="41718"/>
                  <a:pt x="785261" y="42488"/>
                  <a:pt x="787400" y="42916"/>
                </a:cubicBezTo>
                <a:cubicBezTo>
                  <a:pt x="790556" y="43547"/>
                  <a:pt x="793750" y="43974"/>
                  <a:pt x="796925" y="44503"/>
                </a:cubicBezTo>
                <a:cubicBezTo>
                  <a:pt x="820877" y="56480"/>
                  <a:pt x="793837" y="44004"/>
                  <a:pt x="814388" y="50853"/>
                </a:cubicBezTo>
                <a:cubicBezTo>
                  <a:pt x="816633" y="51601"/>
                  <a:pt x="818451" y="53418"/>
                  <a:pt x="820738" y="54028"/>
                </a:cubicBezTo>
                <a:cubicBezTo>
                  <a:pt x="844840" y="60455"/>
                  <a:pt x="877001" y="58224"/>
                  <a:pt x="898525" y="58791"/>
                </a:cubicBezTo>
                <a:cubicBezTo>
                  <a:pt x="902993" y="60466"/>
                  <a:pt x="911798" y="64315"/>
                  <a:pt x="917575" y="65141"/>
                </a:cubicBezTo>
                <a:cubicBezTo>
                  <a:pt x="919147" y="65366"/>
                  <a:pt x="920750" y="65141"/>
                  <a:pt x="922338" y="65141"/>
                </a:cubicBez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9" name="フリーフォーム: 図形 18">
            <a:extLst>
              <a:ext uri="{FF2B5EF4-FFF2-40B4-BE49-F238E27FC236}">
                <a16:creationId xmlns:a16="http://schemas.microsoft.com/office/drawing/2014/main" id="{B993AE75-C533-7BEE-5863-17B334ED6D24}"/>
              </a:ext>
            </a:extLst>
          </p:cNvPr>
          <p:cNvSpPr/>
          <p:nvPr/>
        </p:nvSpPr>
        <p:spPr>
          <a:xfrm>
            <a:off x="1893938" y="2529739"/>
            <a:ext cx="1094317" cy="518584"/>
          </a:xfrm>
          <a:custGeom>
            <a:avLst/>
            <a:gdLst>
              <a:gd name="connsiteX0" fmla="*/ 0 w 1094317"/>
              <a:gd name="connsiteY0" fmla="*/ 518584 h 518584"/>
              <a:gd name="connsiteX1" fmla="*/ 16934 w 1094317"/>
              <a:gd name="connsiteY1" fmla="*/ 516467 h 518584"/>
              <a:gd name="connsiteX2" fmla="*/ 23284 w 1094317"/>
              <a:gd name="connsiteY2" fmla="*/ 510117 h 518584"/>
              <a:gd name="connsiteX3" fmla="*/ 137584 w 1094317"/>
              <a:gd name="connsiteY3" fmla="*/ 512234 h 518584"/>
              <a:gd name="connsiteX4" fmla="*/ 192617 w 1094317"/>
              <a:gd name="connsiteY4" fmla="*/ 512234 h 518584"/>
              <a:gd name="connsiteX5" fmla="*/ 264584 w 1094317"/>
              <a:gd name="connsiteY5" fmla="*/ 508000 h 518584"/>
              <a:gd name="connsiteX6" fmla="*/ 285750 w 1094317"/>
              <a:gd name="connsiteY6" fmla="*/ 501650 h 518584"/>
              <a:gd name="connsiteX7" fmla="*/ 349250 w 1094317"/>
              <a:gd name="connsiteY7" fmla="*/ 497417 h 518584"/>
              <a:gd name="connsiteX8" fmla="*/ 359834 w 1094317"/>
              <a:gd name="connsiteY8" fmla="*/ 488950 h 518584"/>
              <a:gd name="connsiteX9" fmla="*/ 361950 w 1094317"/>
              <a:gd name="connsiteY9" fmla="*/ 482600 h 518584"/>
              <a:gd name="connsiteX10" fmla="*/ 368300 w 1094317"/>
              <a:gd name="connsiteY10" fmla="*/ 478367 h 518584"/>
              <a:gd name="connsiteX11" fmla="*/ 372534 w 1094317"/>
              <a:gd name="connsiteY11" fmla="*/ 474134 h 518584"/>
              <a:gd name="connsiteX12" fmla="*/ 376767 w 1094317"/>
              <a:gd name="connsiteY12" fmla="*/ 429684 h 518584"/>
              <a:gd name="connsiteX13" fmla="*/ 378884 w 1094317"/>
              <a:gd name="connsiteY13" fmla="*/ 323850 h 518584"/>
              <a:gd name="connsiteX14" fmla="*/ 383117 w 1094317"/>
              <a:gd name="connsiteY14" fmla="*/ 289984 h 518584"/>
              <a:gd name="connsiteX15" fmla="*/ 385234 w 1094317"/>
              <a:gd name="connsiteY15" fmla="*/ 270934 h 518584"/>
              <a:gd name="connsiteX16" fmla="*/ 387350 w 1094317"/>
              <a:gd name="connsiteY16" fmla="*/ 154517 h 518584"/>
              <a:gd name="connsiteX17" fmla="*/ 391584 w 1094317"/>
              <a:gd name="connsiteY17" fmla="*/ 141817 h 518584"/>
              <a:gd name="connsiteX18" fmla="*/ 395817 w 1094317"/>
              <a:gd name="connsiteY18" fmla="*/ 124884 h 518584"/>
              <a:gd name="connsiteX19" fmla="*/ 397934 w 1094317"/>
              <a:gd name="connsiteY19" fmla="*/ 95250 h 518584"/>
              <a:gd name="connsiteX20" fmla="*/ 408517 w 1094317"/>
              <a:gd name="connsiteY20" fmla="*/ 67734 h 518584"/>
              <a:gd name="connsiteX21" fmla="*/ 412750 w 1094317"/>
              <a:gd name="connsiteY21" fmla="*/ 57150 h 518584"/>
              <a:gd name="connsiteX22" fmla="*/ 414867 w 1094317"/>
              <a:gd name="connsiteY22" fmla="*/ 50800 h 518584"/>
              <a:gd name="connsiteX23" fmla="*/ 419100 w 1094317"/>
              <a:gd name="connsiteY23" fmla="*/ 44450 h 518584"/>
              <a:gd name="connsiteX24" fmla="*/ 421217 w 1094317"/>
              <a:gd name="connsiteY24" fmla="*/ 35984 h 518584"/>
              <a:gd name="connsiteX25" fmla="*/ 423334 w 1094317"/>
              <a:gd name="connsiteY25" fmla="*/ 16934 h 518584"/>
              <a:gd name="connsiteX26" fmla="*/ 431800 w 1094317"/>
              <a:gd name="connsiteY26" fmla="*/ 0 h 518584"/>
              <a:gd name="connsiteX27" fmla="*/ 440267 w 1094317"/>
              <a:gd name="connsiteY27" fmla="*/ 8467 h 518584"/>
              <a:gd name="connsiteX28" fmla="*/ 446617 w 1094317"/>
              <a:gd name="connsiteY28" fmla="*/ 35984 h 518584"/>
              <a:gd name="connsiteX29" fmla="*/ 450850 w 1094317"/>
              <a:gd name="connsiteY29" fmla="*/ 48684 h 518584"/>
              <a:gd name="connsiteX30" fmla="*/ 455084 w 1094317"/>
              <a:gd name="connsiteY30" fmla="*/ 52917 h 518584"/>
              <a:gd name="connsiteX31" fmla="*/ 461434 w 1094317"/>
              <a:gd name="connsiteY31" fmla="*/ 65617 h 518584"/>
              <a:gd name="connsiteX32" fmla="*/ 469900 w 1094317"/>
              <a:gd name="connsiteY32" fmla="*/ 80434 h 518584"/>
              <a:gd name="connsiteX33" fmla="*/ 476250 w 1094317"/>
              <a:gd name="connsiteY33" fmla="*/ 84667 h 518584"/>
              <a:gd name="connsiteX34" fmla="*/ 480484 w 1094317"/>
              <a:gd name="connsiteY34" fmla="*/ 91017 h 518584"/>
              <a:gd name="connsiteX35" fmla="*/ 491067 w 1094317"/>
              <a:gd name="connsiteY35" fmla="*/ 107950 h 518584"/>
              <a:gd name="connsiteX36" fmla="*/ 497417 w 1094317"/>
              <a:gd name="connsiteY36" fmla="*/ 112184 h 518584"/>
              <a:gd name="connsiteX37" fmla="*/ 499534 w 1094317"/>
              <a:gd name="connsiteY37" fmla="*/ 120650 h 518584"/>
              <a:gd name="connsiteX38" fmla="*/ 508000 w 1094317"/>
              <a:gd name="connsiteY38" fmla="*/ 124884 h 518584"/>
              <a:gd name="connsiteX39" fmla="*/ 514350 w 1094317"/>
              <a:gd name="connsiteY39" fmla="*/ 131234 h 518584"/>
              <a:gd name="connsiteX40" fmla="*/ 520700 w 1094317"/>
              <a:gd name="connsiteY40" fmla="*/ 135467 h 518584"/>
              <a:gd name="connsiteX41" fmla="*/ 524934 w 1094317"/>
              <a:gd name="connsiteY41" fmla="*/ 146050 h 518584"/>
              <a:gd name="connsiteX42" fmla="*/ 527050 w 1094317"/>
              <a:gd name="connsiteY42" fmla="*/ 152400 h 518584"/>
              <a:gd name="connsiteX43" fmla="*/ 531284 w 1094317"/>
              <a:gd name="connsiteY43" fmla="*/ 158750 h 518584"/>
              <a:gd name="connsiteX44" fmla="*/ 539750 w 1094317"/>
              <a:gd name="connsiteY44" fmla="*/ 175684 h 518584"/>
              <a:gd name="connsiteX45" fmla="*/ 543984 w 1094317"/>
              <a:gd name="connsiteY45" fmla="*/ 186267 h 518584"/>
              <a:gd name="connsiteX46" fmla="*/ 556684 w 1094317"/>
              <a:gd name="connsiteY46" fmla="*/ 198967 h 518584"/>
              <a:gd name="connsiteX47" fmla="*/ 569384 w 1094317"/>
              <a:gd name="connsiteY47" fmla="*/ 215900 h 518584"/>
              <a:gd name="connsiteX48" fmla="*/ 573617 w 1094317"/>
              <a:gd name="connsiteY48" fmla="*/ 224367 h 518584"/>
              <a:gd name="connsiteX49" fmla="*/ 582084 w 1094317"/>
              <a:gd name="connsiteY49" fmla="*/ 232834 h 518584"/>
              <a:gd name="connsiteX50" fmla="*/ 584200 w 1094317"/>
              <a:gd name="connsiteY50" fmla="*/ 241300 h 518584"/>
              <a:gd name="connsiteX51" fmla="*/ 588434 w 1094317"/>
              <a:gd name="connsiteY51" fmla="*/ 245534 h 518584"/>
              <a:gd name="connsiteX52" fmla="*/ 607484 w 1094317"/>
              <a:gd name="connsiteY52" fmla="*/ 251884 h 518584"/>
              <a:gd name="connsiteX53" fmla="*/ 620184 w 1094317"/>
              <a:gd name="connsiteY53" fmla="*/ 260350 h 518584"/>
              <a:gd name="connsiteX54" fmla="*/ 639234 w 1094317"/>
              <a:gd name="connsiteY54" fmla="*/ 264584 h 518584"/>
              <a:gd name="connsiteX55" fmla="*/ 649817 w 1094317"/>
              <a:gd name="connsiteY55" fmla="*/ 266700 h 518584"/>
              <a:gd name="connsiteX56" fmla="*/ 654050 w 1094317"/>
              <a:gd name="connsiteY56" fmla="*/ 270934 h 518584"/>
              <a:gd name="connsiteX57" fmla="*/ 660400 w 1094317"/>
              <a:gd name="connsiteY57" fmla="*/ 279400 h 518584"/>
              <a:gd name="connsiteX58" fmla="*/ 675217 w 1094317"/>
              <a:gd name="connsiteY58" fmla="*/ 287867 h 518584"/>
              <a:gd name="connsiteX59" fmla="*/ 679450 w 1094317"/>
              <a:gd name="connsiteY59" fmla="*/ 294217 h 518584"/>
              <a:gd name="connsiteX60" fmla="*/ 702734 w 1094317"/>
              <a:gd name="connsiteY60" fmla="*/ 298450 h 518584"/>
              <a:gd name="connsiteX61" fmla="*/ 717550 w 1094317"/>
              <a:gd name="connsiteY61" fmla="*/ 306917 h 518584"/>
              <a:gd name="connsiteX62" fmla="*/ 738717 w 1094317"/>
              <a:gd name="connsiteY62" fmla="*/ 317500 h 518584"/>
              <a:gd name="connsiteX63" fmla="*/ 747184 w 1094317"/>
              <a:gd name="connsiteY63" fmla="*/ 323850 h 518584"/>
              <a:gd name="connsiteX64" fmla="*/ 751417 w 1094317"/>
              <a:gd name="connsiteY64" fmla="*/ 328084 h 518584"/>
              <a:gd name="connsiteX65" fmla="*/ 759884 w 1094317"/>
              <a:gd name="connsiteY65" fmla="*/ 332317 h 518584"/>
              <a:gd name="connsiteX66" fmla="*/ 766234 w 1094317"/>
              <a:gd name="connsiteY66" fmla="*/ 336550 h 518584"/>
              <a:gd name="connsiteX67" fmla="*/ 781050 w 1094317"/>
              <a:gd name="connsiteY67" fmla="*/ 342900 h 518584"/>
              <a:gd name="connsiteX68" fmla="*/ 789517 w 1094317"/>
              <a:gd name="connsiteY68" fmla="*/ 345017 h 518584"/>
              <a:gd name="connsiteX69" fmla="*/ 831850 w 1094317"/>
              <a:gd name="connsiteY69" fmla="*/ 347134 h 518584"/>
              <a:gd name="connsiteX70" fmla="*/ 848784 w 1094317"/>
              <a:gd name="connsiteY70" fmla="*/ 351367 h 518584"/>
              <a:gd name="connsiteX71" fmla="*/ 855134 w 1094317"/>
              <a:gd name="connsiteY71" fmla="*/ 353484 h 518584"/>
              <a:gd name="connsiteX72" fmla="*/ 882650 w 1094317"/>
              <a:gd name="connsiteY72" fmla="*/ 355600 h 518584"/>
              <a:gd name="connsiteX73" fmla="*/ 889000 w 1094317"/>
              <a:gd name="connsiteY73" fmla="*/ 357717 h 518584"/>
              <a:gd name="connsiteX74" fmla="*/ 903817 w 1094317"/>
              <a:gd name="connsiteY74" fmla="*/ 364067 h 518584"/>
              <a:gd name="connsiteX75" fmla="*/ 920750 w 1094317"/>
              <a:gd name="connsiteY75" fmla="*/ 366184 h 518584"/>
              <a:gd name="connsiteX76" fmla="*/ 986367 w 1094317"/>
              <a:gd name="connsiteY76" fmla="*/ 364067 h 518584"/>
              <a:gd name="connsiteX77" fmla="*/ 1003300 w 1094317"/>
              <a:gd name="connsiteY77" fmla="*/ 361950 h 518584"/>
              <a:gd name="connsiteX78" fmla="*/ 1062567 w 1094317"/>
              <a:gd name="connsiteY78" fmla="*/ 359834 h 518584"/>
              <a:gd name="connsiteX79" fmla="*/ 1071034 w 1094317"/>
              <a:gd name="connsiteY79" fmla="*/ 357717 h 518584"/>
              <a:gd name="connsiteX80" fmla="*/ 1079500 w 1094317"/>
              <a:gd name="connsiteY80" fmla="*/ 353484 h 518584"/>
              <a:gd name="connsiteX81" fmla="*/ 1094317 w 1094317"/>
              <a:gd name="connsiteY81" fmla="*/ 355600 h 5185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</a:cxnLst>
            <a:rect l="l" t="t" r="r" b="b"/>
            <a:pathLst>
              <a:path w="1094317" h="518584">
                <a:moveTo>
                  <a:pt x="0" y="518584"/>
                </a:moveTo>
                <a:cubicBezTo>
                  <a:pt x="5645" y="517878"/>
                  <a:pt x="11588" y="518411"/>
                  <a:pt x="16934" y="516467"/>
                </a:cubicBezTo>
                <a:cubicBezTo>
                  <a:pt x="19747" y="515444"/>
                  <a:pt x="20292" y="510222"/>
                  <a:pt x="23284" y="510117"/>
                </a:cubicBezTo>
                <a:cubicBezTo>
                  <a:pt x="61367" y="508781"/>
                  <a:pt x="99484" y="511528"/>
                  <a:pt x="137584" y="512234"/>
                </a:cubicBezTo>
                <a:cubicBezTo>
                  <a:pt x="210959" y="506589"/>
                  <a:pt x="119240" y="512234"/>
                  <a:pt x="192617" y="512234"/>
                </a:cubicBezTo>
                <a:cubicBezTo>
                  <a:pt x="198105" y="512234"/>
                  <a:pt x="257066" y="508470"/>
                  <a:pt x="264584" y="508000"/>
                </a:cubicBezTo>
                <a:cubicBezTo>
                  <a:pt x="271201" y="505794"/>
                  <a:pt x="278719" y="502928"/>
                  <a:pt x="285750" y="501650"/>
                </a:cubicBezTo>
                <a:cubicBezTo>
                  <a:pt x="307936" y="497616"/>
                  <a:pt x="323943" y="498518"/>
                  <a:pt x="349250" y="497417"/>
                </a:cubicBezTo>
                <a:cubicBezTo>
                  <a:pt x="352135" y="495494"/>
                  <a:pt x="357823" y="492302"/>
                  <a:pt x="359834" y="488950"/>
                </a:cubicBezTo>
                <a:cubicBezTo>
                  <a:pt x="360982" y="487037"/>
                  <a:pt x="360556" y="484342"/>
                  <a:pt x="361950" y="482600"/>
                </a:cubicBezTo>
                <a:cubicBezTo>
                  <a:pt x="363539" y="480614"/>
                  <a:pt x="366313" y="479956"/>
                  <a:pt x="368300" y="478367"/>
                </a:cubicBezTo>
                <a:cubicBezTo>
                  <a:pt x="369858" y="477120"/>
                  <a:pt x="371123" y="475545"/>
                  <a:pt x="372534" y="474134"/>
                </a:cubicBezTo>
                <a:cubicBezTo>
                  <a:pt x="377253" y="455250"/>
                  <a:pt x="375759" y="463450"/>
                  <a:pt x="376767" y="429684"/>
                </a:cubicBezTo>
                <a:cubicBezTo>
                  <a:pt x="377820" y="394415"/>
                  <a:pt x="377746" y="359117"/>
                  <a:pt x="378884" y="323850"/>
                </a:cubicBezTo>
                <a:cubicBezTo>
                  <a:pt x="379583" y="302184"/>
                  <a:pt x="379507" y="304421"/>
                  <a:pt x="383117" y="289984"/>
                </a:cubicBezTo>
                <a:cubicBezTo>
                  <a:pt x="383823" y="283634"/>
                  <a:pt x="385034" y="277320"/>
                  <a:pt x="385234" y="270934"/>
                </a:cubicBezTo>
                <a:cubicBezTo>
                  <a:pt x="386446" y="232141"/>
                  <a:pt x="385444" y="193282"/>
                  <a:pt x="387350" y="154517"/>
                </a:cubicBezTo>
                <a:cubicBezTo>
                  <a:pt x="387569" y="150060"/>
                  <a:pt x="390709" y="146193"/>
                  <a:pt x="391584" y="141817"/>
                </a:cubicBezTo>
                <a:cubicBezTo>
                  <a:pt x="394137" y="129046"/>
                  <a:pt x="392562" y="134647"/>
                  <a:pt x="395817" y="124884"/>
                </a:cubicBezTo>
                <a:cubicBezTo>
                  <a:pt x="396523" y="115006"/>
                  <a:pt x="396237" y="105007"/>
                  <a:pt x="397934" y="95250"/>
                </a:cubicBezTo>
                <a:cubicBezTo>
                  <a:pt x="400604" y="79897"/>
                  <a:pt x="403495" y="79033"/>
                  <a:pt x="408517" y="67734"/>
                </a:cubicBezTo>
                <a:cubicBezTo>
                  <a:pt x="410060" y="64262"/>
                  <a:pt x="411416" y="60708"/>
                  <a:pt x="412750" y="57150"/>
                </a:cubicBezTo>
                <a:cubicBezTo>
                  <a:pt x="413533" y="55061"/>
                  <a:pt x="413869" y="52796"/>
                  <a:pt x="414867" y="50800"/>
                </a:cubicBezTo>
                <a:cubicBezTo>
                  <a:pt x="416005" y="48525"/>
                  <a:pt x="417689" y="46567"/>
                  <a:pt x="419100" y="44450"/>
                </a:cubicBezTo>
                <a:cubicBezTo>
                  <a:pt x="419806" y="41628"/>
                  <a:pt x="420775" y="38859"/>
                  <a:pt x="421217" y="35984"/>
                </a:cubicBezTo>
                <a:cubicBezTo>
                  <a:pt x="422189" y="29669"/>
                  <a:pt x="421995" y="23181"/>
                  <a:pt x="423334" y="16934"/>
                </a:cubicBezTo>
                <a:cubicBezTo>
                  <a:pt x="424969" y="9302"/>
                  <a:pt x="427831" y="5954"/>
                  <a:pt x="431800" y="0"/>
                </a:cubicBezTo>
                <a:cubicBezTo>
                  <a:pt x="434622" y="2822"/>
                  <a:pt x="438213" y="5044"/>
                  <a:pt x="440267" y="8467"/>
                </a:cubicBezTo>
                <a:cubicBezTo>
                  <a:pt x="445629" y="17404"/>
                  <a:pt x="444371" y="26249"/>
                  <a:pt x="446617" y="35984"/>
                </a:cubicBezTo>
                <a:cubicBezTo>
                  <a:pt x="447620" y="40332"/>
                  <a:pt x="447694" y="45529"/>
                  <a:pt x="450850" y="48684"/>
                </a:cubicBezTo>
                <a:lnTo>
                  <a:pt x="455084" y="52917"/>
                </a:lnTo>
                <a:cubicBezTo>
                  <a:pt x="459518" y="70658"/>
                  <a:pt x="453885" y="54294"/>
                  <a:pt x="461434" y="65617"/>
                </a:cubicBezTo>
                <a:cubicBezTo>
                  <a:pt x="464755" y="70598"/>
                  <a:pt x="465569" y="76103"/>
                  <a:pt x="469900" y="80434"/>
                </a:cubicBezTo>
                <a:cubicBezTo>
                  <a:pt x="471699" y="82233"/>
                  <a:pt x="474133" y="83256"/>
                  <a:pt x="476250" y="84667"/>
                </a:cubicBezTo>
                <a:cubicBezTo>
                  <a:pt x="477661" y="86784"/>
                  <a:pt x="479118" y="88871"/>
                  <a:pt x="480484" y="91017"/>
                </a:cubicBezTo>
                <a:cubicBezTo>
                  <a:pt x="484058" y="96632"/>
                  <a:pt x="485529" y="104257"/>
                  <a:pt x="491067" y="107950"/>
                </a:cubicBezTo>
                <a:lnTo>
                  <a:pt x="497417" y="112184"/>
                </a:lnTo>
                <a:cubicBezTo>
                  <a:pt x="498123" y="115006"/>
                  <a:pt x="497672" y="118415"/>
                  <a:pt x="499534" y="120650"/>
                </a:cubicBezTo>
                <a:cubicBezTo>
                  <a:pt x="501554" y="123074"/>
                  <a:pt x="505433" y="123050"/>
                  <a:pt x="508000" y="124884"/>
                </a:cubicBezTo>
                <a:cubicBezTo>
                  <a:pt x="510436" y="126624"/>
                  <a:pt x="512050" y="129318"/>
                  <a:pt x="514350" y="131234"/>
                </a:cubicBezTo>
                <a:cubicBezTo>
                  <a:pt x="516304" y="132863"/>
                  <a:pt x="518583" y="134056"/>
                  <a:pt x="520700" y="135467"/>
                </a:cubicBezTo>
                <a:cubicBezTo>
                  <a:pt x="522111" y="138995"/>
                  <a:pt x="523600" y="142492"/>
                  <a:pt x="524934" y="146050"/>
                </a:cubicBezTo>
                <a:cubicBezTo>
                  <a:pt x="525717" y="148139"/>
                  <a:pt x="526052" y="150404"/>
                  <a:pt x="527050" y="152400"/>
                </a:cubicBezTo>
                <a:cubicBezTo>
                  <a:pt x="528188" y="154675"/>
                  <a:pt x="529873" y="156633"/>
                  <a:pt x="531284" y="158750"/>
                </a:cubicBezTo>
                <a:cubicBezTo>
                  <a:pt x="536054" y="173064"/>
                  <a:pt x="529757" y="155699"/>
                  <a:pt x="539750" y="175684"/>
                </a:cubicBezTo>
                <a:cubicBezTo>
                  <a:pt x="541449" y="179082"/>
                  <a:pt x="541749" y="183194"/>
                  <a:pt x="543984" y="186267"/>
                </a:cubicBezTo>
                <a:cubicBezTo>
                  <a:pt x="547505" y="191109"/>
                  <a:pt x="553604" y="193833"/>
                  <a:pt x="556684" y="198967"/>
                </a:cubicBezTo>
                <a:cubicBezTo>
                  <a:pt x="564574" y="212117"/>
                  <a:pt x="560125" y="206641"/>
                  <a:pt x="569384" y="215900"/>
                </a:cubicBezTo>
                <a:cubicBezTo>
                  <a:pt x="570795" y="218722"/>
                  <a:pt x="571724" y="221843"/>
                  <a:pt x="573617" y="224367"/>
                </a:cubicBezTo>
                <a:cubicBezTo>
                  <a:pt x="576012" y="227560"/>
                  <a:pt x="579969" y="229449"/>
                  <a:pt x="582084" y="232834"/>
                </a:cubicBezTo>
                <a:cubicBezTo>
                  <a:pt x="583626" y="235301"/>
                  <a:pt x="582899" y="238698"/>
                  <a:pt x="584200" y="241300"/>
                </a:cubicBezTo>
                <a:cubicBezTo>
                  <a:pt x="585093" y="243085"/>
                  <a:pt x="586875" y="244287"/>
                  <a:pt x="588434" y="245534"/>
                </a:cubicBezTo>
                <a:cubicBezTo>
                  <a:pt x="596266" y="251799"/>
                  <a:pt x="595800" y="249936"/>
                  <a:pt x="607484" y="251884"/>
                </a:cubicBezTo>
                <a:cubicBezTo>
                  <a:pt x="611717" y="254706"/>
                  <a:pt x="615195" y="259352"/>
                  <a:pt x="620184" y="260350"/>
                </a:cubicBezTo>
                <a:cubicBezTo>
                  <a:pt x="652180" y="266750"/>
                  <a:pt x="612268" y="258592"/>
                  <a:pt x="639234" y="264584"/>
                </a:cubicBezTo>
                <a:cubicBezTo>
                  <a:pt x="642746" y="265364"/>
                  <a:pt x="646289" y="265995"/>
                  <a:pt x="649817" y="266700"/>
                </a:cubicBezTo>
                <a:cubicBezTo>
                  <a:pt x="651228" y="268111"/>
                  <a:pt x="652772" y="269401"/>
                  <a:pt x="654050" y="270934"/>
                </a:cubicBezTo>
                <a:cubicBezTo>
                  <a:pt x="656308" y="273644"/>
                  <a:pt x="657906" y="276906"/>
                  <a:pt x="660400" y="279400"/>
                </a:cubicBezTo>
                <a:cubicBezTo>
                  <a:pt x="666807" y="285807"/>
                  <a:pt x="667952" y="285445"/>
                  <a:pt x="675217" y="287867"/>
                </a:cubicBezTo>
                <a:cubicBezTo>
                  <a:pt x="676628" y="289984"/>
                  <a:pt x="677241" y="292955"/>
                  <a:pt x="679450" y="294217"/>
                </a:cubicBezTo>
                <a:cubicBezTo>
                  <a:pt x="680671" y="294915"/>
                  <a:pt x="702674" y="298440"/>
                  <a:pt x="702734" y="298450"/>
                </a:cubicBezTo>
                <a:cubicBezTo>
                  <a:pt x="730502" y="319278"/>
                  <a:pt x="696774" y="295374"/>
                  <a:pt x="717550" y="306917"/>
                </a:cubicBezTo>
                <a:cubicBezTo>
                  <a:pt x="738166" y="318371"/>
                  <a:pt x="722172" y="313365"/>
                  <a:pt x="738717" y="317500"/>
                </a:cubicBezTo>
                <a:cubicBezTo>
                  <a:pt x="741539" y="319617"/>
                  <a:pt x="744474" y="321591"/>
                  <a:pt x="747184" y="323850"/>
                </a:cubicBezTo>
                <a:cubicBezTo>
                  <a:pt x="748717" y="325128"/>
                  <a:pt x="749757" y="326977"/>
                  <a:pt x="751417" y="328084"/>
                </a:cubicBezTo>
                <a:cubicBezTo>
                  <a:pt x="754042" y="329834"/>
                  <a:pt x="757144" y="330752"/>
                  <a:pt x="759884" y="332317"/>
                </a:cubicBezTo>
                <a:cubicBezTo>
                  <a:pt x="762093" y="333579"/>
                  <a:pt x="764025" y="335288"/>
                  <a:pt x="766234" y="336550"/>
                </a:cubicBezTo>
                <a:cubicBezTo>
                  <a:pt x="771885" y="339780"/>
                  <a:pt x="775108" y="341202"/>
                  <a:pt x="781050" y="342900"/>
                </a:cubicBezTo>
                <a:cubicBezTo>
                  <a:pt x="783847" y="343699"/>
                  <a:pt x="786618" y="344775"/>
                  <a:pt x="789517" y="345017"/>
                </a:cubicBezTo>
                <a:cubicBezTo>
                  <a:pt x="803597" y="346191"/>
                  <a:pt x="817739" y="346428"/>
                  <a:pt x="831850" y="347134"/>
                </a:cubicBezTo>
                <a:cubicBezTo>
                  <a:pt x="846374" y="351974"/>
                  <a:pt x="828335" y="346254"/>
                  <a:pt x="848784" y="351367"/>
                </a:cubicBezTo>
                <a:cubicBezTo>
                  <a:pt x="850949" y="351908"/>
                  <a:pt x="852920" y="353207"/>
                  <a:pt x="855134" y="353484"/>
                </a:cubicBezTo>
                <a:cubicBezTo>
                  <a:pt x="864262" y="354625"/>
                  <a:pt x="873478" y="354895"/>
                  <a:pt x="882650" y="355600"/>
                </a:cubicBezTo>
                <a:cubicBezTo>
                  <a:pt x="884767" y="356306"/>
                  <a:pt x="886949" y="356838"/>
                  <a:pt x="889000" y="357717"/>
                </a:cubicBezTo>
                <a:cubicBezTo>
                  <a:pt x="894374" y="360020"/>
                  <a:pt x="898072" y="363022"/>
                  <a:pt x="903817" y="364067"/>
                </a:cubicBezTo>
                <a:cubicBezTo>
                  <a:pt x="909413" y="365085"/>
                  <a:pt x="915106" y="365478"/>
                  <a:pt x="920750" y="366184"/>
                </a:cubicBezTo>
                <a:cubicBezTo>
                  <a:pt x="942622" y="365478"/>
                  <a:pt x="964563" y="365936"/>
                  <a:pt x="986367" y="364067"/>
                </a:cubicBezTo>
                <a:cubicBezTo>
                  <a:pt x="1011096" y="361947"/>
                  <a:pt x="979180" y="355922"/>
                  <a:pt x="1003300" y="361950"/>
                </a:cubicBezTo>
                <a:cubicBezTo>
                  <a:pt x="1023056" y="361245"/>
                  <a:pt x="1042837" y="361067"/>
                  <a:pt x="1062567" y="359834"/>
                </a:cubicBezTo>
                <a:cubicBezTo>
                  <a:pt x="1065471" y="359653"/>
                  <a:pt x="1068310" y="358739"/>
                  <a:pt x="1071034" y="357717"/>
                </a:cubicBezTo>
                <a:cubicBezTo>
                  <a:pt x="1073988" y="356609"/>
                  <a:pt x="1076678" y="354895"/>
                  <a:pt x="1079500" y="353484"/>
                </a:cubicBezTo>
                <a:cubicBezTo>
                  <a:pt x="1092896" y="355716"/>
                  <a:pt x="1087908" y="355600"/>
                  <a:pt x="1094317" y="355600"/>
                </a:cubicBez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0" name="フリーフォーム: 図形 19">
            <a:extLst>
              <a:ext uri="{FF2B5EF4-FFF2-40B4-BE49-F238E27FC236}">
                <a16:creationId xmlns:a16="http://schemas.microsoft.com/office/drawing/2014/main" id="{44BFDC31-84DC-73C9-DA3F-07C7B76A77D7}"/>
              </a:ext>
            </a:extLst>
          </p:cNvPr>
          <p:cNvSpPr/>
          <p:nvPr/>
        </p:nvSpPr>
        <p:spPr>
          <a:xfrm>
            <a:off x="3939316" y="2563798"/>
            <a:ext cx="1128712" cy="484525"/>
          </a:xfrm>
          <a:custGeom>
            <a:avLst/>
            <a:gdLst>
              <a:gd name="connsiteX0" fmla="*/ 0 w 1128712"/>
              <a:gd name="connsiteY0" fmla="*/ 484525 h 484525"/>
              <a:gd name="connsiteX1" fmla="*/ 38100 w 1128712"/>
              <a:gd name="connsiteY1" fmla="*/ 482938 h 484525"/>
              <a:gd name="connsiteX2" fmla="*/ 46037 w 1128712"/>
              <a:gd name="connsiteY2" fmla="*/ 481350 h 484525"/>
              <a:gd name="connsiteX3" fmla="*/ 87312 w 1128712"/>
              <a:gd name="connsiteY3" fmla="*/ 479763 h 484525"/>
              <a:gd name="connsiteX4" fmla="*/ 150812 w 1128712"/>
              <a:gd name="connsiteY4" fmla="*/ 476588 h 484525"/>
              <a:gd name="connsiteX5" fmla="*/ 185737 w 1128712"/>
              <a:gd name="connsiteY5" fmla="*/ 476588 h 484525"/>
              <a:gd name="connsiteX6" fmla="*/ 254000 w 1128712"/>
              <a:gd name="connsiteY6" fmla="*/ 473413 h 484525"/>
              <a:gd name="connsiteX7" fmla="*/ 268287 w 1128712"/>
              <a:gd name="connsiteY7" fmla="*/ 470238 h 484525"/>
              <a:gd name="connsiteX8" fmla="*/ 280987 w 1128712"/>
              <a:gd name="connsiteY8" fmla="*/ 462300 h 484525"/>
              <a:gd name="connsiteX9" fmla="*/ 290512 w 1128712"/>
              <a:gd name="connsiteY9" fmla="*/ 460713 h 484525"/>
              <a:gd name="connsiteX10" fmla="*/ 292100 w 1128712"/>
              <a:gd name="connsiteY10" fmla="*/ 449600 h 484525"/>
              <a:gd name="connsiteX11" fmla="*/ 295275 w 1128712"/>
              <a:gd name="connsiteY11" fmla="*/ 443250 h 484525"/>
              <a:gd name="connsiteX12" fmla="*/ 300037 w 1128712"/>
              <a:gd name="connsiteY12" fmla="*/ 432138 h 484525"/>
              <a:gd name="connsiteX13" fmla="*/ 301625 w 1128712"/>
              <a:gd name="connsiteY13" fmla="*/ 390863 h 484525"/>
              <a:gd name="connsiteX14" fmla="*/ 303212 w 1128712"/>
              <a:gd name="connsiteY14" fmla="*/ 384513 h 484525"/>
              <a:gd name="connsiteX15" fmla="*/ 304800 w 1128712"/>
              <a:gd name="connsiteY15" fmla="*/ 309900 h 484525"/>
              <a:gd name="connsiteX16" fmla="*/ 306387 w 1128712"/>
              <a:gd name="connsiteY16" fmla="*/ 303550 h 484525"/>
              <a:gd name="connsiteX17" fmla="*/ 307975 w 1128712"/>
              <a:gd name="connsiteY17" fmla="*/ 292438 h 484525"/>
              <a:gd name="connsiteX18" fmla="*/ 311150 w 1128712"/>
              <a:gd name="connsiteY18" fmla="*/ 232113 h 484525"/>
              <a:gd name="connsiteX19" fmla="*/ 315912 w 1128712"/>
              <a:gd name="connsiteY19" fmla="*/ 208300 h 484525"/>
              <a:gd name="connsiteX20" fmla="*/ 319087 w 1128712"/>
              <a:gd name="connsiteY20" fmla="*/ 192425 h 484525"/>
              <a:gd name="connsiteX21" fmla="*/ 320675 w 1128712"/>
              <a:gd name="connsiteY21" fmla="*/ 171788 h 484525"/>
              <a:gd name="connsiteX22" fmla="*/ 322262 w 1128712"/>
              <a:gd name="connsiteY22" fmla="*/ 160675 h 484525"/>
              <a:gd name="connsiteX23" fmla="*/ 325437 w 1128712"/>
              <a:gd name="connsiteY23" fmla="*/ 144800 h 484525"/>
              <a:gd name="connsiteX24" fmla="*/ 327025 w 1128712"/>
              <a:gd name="connsiteY24" fmla="*/ 130513 h 484525"/>
              <a:gd name="connsiteX25" fmla="*/ 328612 w 1128712"/>
              <a:gd name="connsiteY25" fmla="*/ 101938 h 484525"/>
              <a:gd name="connsiteX26" fmla="*/ 334962 w 1128712"/>
              <a:gd name="connsiteY26" fmla="*/ 92413 h 484525"/>
              <a:gd name="connsiteX27" fmla="*/ 336550 w 1128712"/>
              <a:gd name="connsiteY27" fmla="*/ 87650 h 484525"/>
              <a:gd name="connsiteX28" fmla="*/ 338137 w 1128712"/>
              <a:gd name="connsiteY28" fmla="*/ 65425 h 484525"/>
              <a:gd name="connsiteX29" fmla="*/ 341312 w 1128712"/>
              <a:gd name="connsiteY29" fmla="*/ 51138 h 484525"/>
              <a:gd name="connsiteX30" fmla="*/ 342900 w 1128712"/>
              <a:gd name="connsiteY30" fmla="*/ 46375 h 484525"/>
              <a:gd name="connsiteX31" fmla="*/ 347662 w 1128712"/>
              <a:gd name="connsiteY31" fmla="*/ 35263 h 484525"/>
              <a:gd name="connsiteX32" fmla="*/ 349250 w 1128712"/>
              <a:gd name="connsiteY32" fmla="*/ 27325 h 484525"/>
              <a:gd name="connsiteX33" fmla="*/ 352425 w 1128712"/>
              <a:gd name="connsiteY33" fmla="*/ 20975 h 484525"/>
              <a:gd name="connsiteX34" fmla="*/ 354012 w 1128712"/>
              <a:gd name="connsiteY34" fmla="*/ 16213 h 484525"/>
              <a:gd name="connsiteX35" fmla="*/ 355600 w 1128712"/>
              <a:gd name="connsiteY35" fmla="*/ 9863 h 484525"/>
              <a:gd name="connsiteX36" fmla="*/ 360362 w 1128712"/>
              <a:gd name="connsiteY36" fmla="*/ 6688 h 484525"/>
              <a:gd name="connsiteX37" fmla="*/ 368300 w 1128712"/>
              <a:gd name="connsiteY37" fmla="*/ 338 h 484525"/>
              <a:gd name="connsiteX38" fmla="*/ 373062 w 1128712"/>
              <a:gd name="connsiteY38" fmla="*/ 6688 h 484525"/>
              <a:gd name="connsiteX39" fmla="*/ 379412 w 1128712"/>
              <a:gd name="connsiteY39" fmla="*/ 9863 h 484525"/>
              <a:gd name="connsiteX40" fmla="*/ 387350 w 1128712"/>
              <a:gd name="connsiteY40" fmla="*/ 14625 h 484525"/>
              <a:gd name="connsiteX41" fmla="*/ 396875 w 1128712"/>
              <a:gd name="connsiteY41" fmla="*/ 19388 h 484525"/>
              <a:gd name="connsiteX42" fmla="*/ 401637 w 1128712"/>
              <a:gd name="connsiteY42" fmla="*/ 25738 h 484525"/>
              <a:gd name="connsiteX43" fmla="*/ 403225 w 1128712"/>
              <a:gd name="connsiteY43" fmla="*/ 32088 h 484525"/>
              <a:gd name="connsiteX44" fmla="*/ 407987 w 1128712"/>
              <a:gd name="connsiteY44" fmla="*/ 36850 h 484525"/>
              <a:gd name="connsiteX45" fmla="*/ 414337 w 1128712"/>
              <a:gd name="connsiteY45" fmla="*/ 47963 h 484525"/>
              <a:gd name="connsiteX46" fmla="*/ 419100 w 1128712"/>
              <a:gd name="connsiteY46" fmla="*/ 52725 h 484525"/>
              <a:gd name="connsiteX47" fmla="*/ 420687 w 1128712"/>
              <a:gd name="connsiteY47" fmla="*/ 60663 h 484525"/>
              <a:gd name="connsiteX48" fmla="*/ 428625 w 1128712"/>
              <a:gd name="connsiteY48" fmla="*/ 70188 h 484525"/>
              <a:gd name="connsiteX49" fmla="*/ 436562 w 1128712"/>
              <a:gd name="connsiteY49" fmla="*/ 79713 h 484525"/>
              <a:gd name="connsiteX50" fmla="*/ 438150 w 1128712"/>
              <a:gd name="connsiteY50" fmla="*/ 84475 h 484525"/>
              <a:gd name="connsiteX51" fmla="*/ 441325 w 1128712"/>
              <a:gd name="connsiteY51" fmla="*/ 95588 h 484525"/>
              <a:gd name="connsiteX52" fmla="*/ 447675 w 1128712"/>
              <a:gd name="connsiteY52" fmla="*/ 100350 h 484525"/>
              <a:gd name="connsiteX53" fmla="*/ 450850 w 1128712"/>
              <a:gd name="connsiteY53" fmla="*/ 108288 h 484525"/>
              <a:gd name="connsiteX54" fmla="*/ 452437 w 1128712"/>
              <a:gd name="connsiteY54" fmla="*/ 113050 h 484525"/>
              <a:gd name="connsiteX55" fmla="*/ 455612 w 1128712"/>
              <a:gd name="connsiteY55" fmla="*/ 117813 h 484525"/>
              <a:gd name="connsiteX56" fmla="*/ 457200 w 1128712"/>
              <a:gd name="connsiteY56" fmla="*/ 122575 h 484525"/>
              <a:gd name="connsiteX57" fmla="*/ 461962 w 1128712"/>
              <a:gd name="connsiteY57" fmla="*/ 125750 h 484525"/>
              <a:gd name="connsiteX58" fmla="*/ 466725 w 1128712"/>
              <a:gd name="connsiteY58" fmla="*/ 130513 h 484525"/>
              <a:gd name="connsiteX59" fmla="*/ 474662 w 1128712"/>
              <a:gd name="connsiteY59" fmla="*/ 136863 h 484525"/>
              <a:gd name="connsiteX60" fmla="*/ 479425 w 1128712"/>
              <a:gd name="connsiteY60" fmla="*/ 149563 h 484525"/>
              <a:gd name="connsiteX61" fmla="*/ 481012 w 1128712"/>
              <a:gd name="connsiteY61" fmla="*/ 155913 h 484525"/>
              <a:gd name="connsiteX62" fmla="*/ 490537 w 1128712"/>
              <a:gd name="connsiteY62" fmla="*/ 178138 h 484525"/>
              <a:gd name="connsiteX63" fmla="*/ 495300 w 1128712"/>
              <a:gd name="connsiteY63" fmla="*/ 181313 h 484525"/>
              <a:gd name="connsiteX64" fmla="*/ 498475 w 1128712"/>
              <a:gd name="connsiteY64" fmla="*/ 186075 h 484525"/>
              <a:gd name="connsiteX65" fmla="*/ 503237 w 1128712"/>
              <a:gd name="connsiteY65" fmla="*/ 195600 h 484525"/>
              <a:gd name="connsiteX66" fmla="*/ 512762 w 1128712"/>
              <a:gd name="connsiteY66" fmla="*/ 200363 h 484525"/>
              <a:gd name="connsiteX67" fmla="*/ 525462 w 1128712"/>
              <a:gd name="connsiteY67" fmla="*/ 217825 h 484525"/>
              <a:gd name="connsiteX68" fmla="*/ 533400 w 1128712"/>
              <a:gd name="connsiteY68" fmla="*/ 230525 h 484525"/>
              <a:gd name="connsiteX69" fmla="*/ 538162 w 1128712"/>
              <a:gd name="connsiteY69" fmla="*/ 233700 h 484525"/>
              <a:gd name="connsiteX70" fmla="*/ 539750 w 1128712"/>
              <a:gd name="connsiteY70" fmla="*/ 238463 h 484525"/>
              <a:gd name="connsiteX71" fmla="*/ 544512 w 1128712"/>
              <a:gd name="connsiteY71" fmla="*/ 240050 h 484525"/>
              <a:gd name="connsiteX72" fmla="*/ 558800 w 1128712"/>
              <a:gd name="connsiteY72" fmla="*/ 251163 h 484525"/>
              <a:gd name="connsiteX73" fmla="*/ 569912 w 1128712"/>
              <a:gd name="connsiteY73" fmla="*/ 259100 h 484525"/>
              <a:gd name="connsiteX74" fmla="*/ 576262 w 1128712"/>
              <a:gd name="connsiteY74" fmla="*/ 265450 h 484525"/>
              <a:gd name="connsiteX75" fmla="*/ 587375 w 1128712"/>
              <a:gd name="connsiteY75" fmla="*/ 274975 h 484525"/>
              <a:gd name="connsiteX76" fmla="*/ 592137 w 1128712"/>
              <a:gd name="connsiteY76" fmla="*/ 281325 h 484525"/>
              <a:gd name="connsiteX77" fmla="*/ 596900 w 1128712"/>
              <a:gd name="connsiteY77" fmla="*/ 286088 h 484525"/>
              <a:gd name="connsiteX78" fmla="*/ 601662 w 1128712"/>
              <a:gd name="connsiteY78" fmla="*/ 294025 h 484525"/>
              <a:gd name="connsiteX79" fmla="*/ 606425 w 1128712"/>
              <a:gd name="connsiteY79" fmla="*/ 297200 h 484525"/>
              <a:gd name="connsiteX80" fmla="*/ 620712 w 1128712"/>
              <a:gd name="connsiteY80" fmla="*/ 305138 h 484525"/>
              <a:gd name="connsiteX81" fmla="*/ 627062 w 1128712"/>
              <a:gd name="connsiteY81" fmla="*/ 311488 h 484525"/>
              <a:gd name="connsiteX82" fmla="*/ 631825 w 1128712"/>
              <a:gd name="connsiteY82" fmla="*/ 313075 h 484525"/>
              <a:gd name="connsiteX83" fmla="*/ 635000 w 1128712"/>
              <a:gd name="connsiteY83" fmla="*/ 317838 h 484525"/>
              <a:gd name="connsiteX84" fmla="*/ 647700 w 1128712"/>
              <a:gd name="connsiteY84" fmla="*/ 322600 h 484525"/>
              <a:gd name="connsiteX85" fmla="*/ 652462 w 1128712"/>
              <a:gd name="connsiteY85" fmla="*/ 327363 h 484525"/>
              <a:gd name="connsiteX86" fmla="*/ 657225 w 1128712"/>
              <a:gd name="connsiteY86" fmla="*/ 330538 h 484525"/>
              <a:gd name="connsiteX87" fmla="*/ 661987 w 1128712"/>
              <a:gd name="connsiteY87" fmla="*/ 336888 h 484525"/>
              <a:gd name="connsiteX88" fmla="*/ 671512 w 1128712"/>
              <a:gd name="connsiteY88" fmla="*/ 340063 h 484525"/>
              <a:gd name="connsiteX89" fmla="*/ 676275 w 1128712"/>
              <a:gd name="connsiteY89" fmla="*/ 344825 h 484525"/>
              <a:gd name="connsiteX90" fmla="*/ 684212 w 1128712"/>
              <a:gd name="connsiteY90" fmla="*/ 346413 h 484525"/>
              <a:gd name="connsiteX91" fmla="*/ 688975 w 1128712"/>
              <a:gd name="connsiteY91" fmla="*/ 348000 h 484525"/>
              <a:gd name="connsiteX92" fmla="*/ 698500 w 1128712"/>
              <a:gd name="connsiteY92" fmla="*/ 349588 h 484525"/>
              <a:gd name="connsiteX93" fmla="*/ 712787 w 1128712"/>
              <a:gd name="connsiteY93" fmla="*/ 355938 h 484525"/>
              <a:gd name="connsiteX94" fmla="*/ 717550 w 1128712"/>
              <a:gd name="connsiteY94" fmla="*/ 357525 h 484525"/>
              <a:gd name="connsiteX95" fmla="*/ 725487 w 1128712"/>
              <a:gd name="connsiteY95" fmla="*/ 359113 h 484525"/>
              <a:gd name="connsiteX96" fmla="*/ 728662 w 1128712"/>
              <a:gd name="connsiteY96" fmla="*/ 363875 h 484525"/>
              <a:gd name="connsiteX97" fmla="*/ 736600 w 1128712"/>
              <a:gd name="connsiteY97" fmla="*/ 365463 h 484525"/>
              <a:gd name="connsiteX98" fmla="*/ 774700 w 1128712"/>
              <a:gd name="connsiteY98" fmla="*/ 367050 h 484525"/>
              <a:gd name="connsiteX99" fmla="*/ 801687 w 1128712"/>
              <a:gd name="connsiteY99" fmla="*/ 370225 h 484525"/>
              <a:gd name="connsiteX100" fmla="*/ 806450 w 1128712"/>
              <a:gd name="connsiteY100" fmla="*/ 373400 h 484525"/>
              <a:gd name="connsiteX101" fmla="*/ 815975 w 1128712"/>
              <a:gd name="connsiteY101" fmla="*/ 376575 h 484525"/>
              <a:gd name="connsiteX102" fmla="*/ 825500 w 1128712"/>
              <a:gd name="connsiteY102" fmla="*/ 378163 h 484525"/>
              <a:gd name="connsiteX103" fmla="*/ 835025 w 1128712"/>
              <a:gd name="connsiteY103" fmla="*/ 381338 h 484525"/>
              <a:gd name="connsiteX104" fmla="*/ 839787 w 1128712"/>
              <a:gd name="connsiteY104" fmla="*/ 382925 h 484525"/>
              <a:gd name="connsiteX105" fmla="*/ 852487 w 1128712"/>
              <a:gd name="connsiteY105" fmla="*/ 384513 h 484525"/>
              <a:gd name="connsiteX106" fmla="*/ 887412 w 1128712"/>
              <a:gd name="connsiteY106" fmla="*/ 382925 h 484525"/>
              <a:gd name="connsiteX107" fmla="*/ 942975 w 1128712"/>
              <a:gd name="connsiteY107" fmla="*/ 387688 h 484525"/>
              <a:gd name="connsiteX108" fmla="*/ 949325 w 1128712"/>
              <a:gd name="connsiteY108" fmla="*/ 390863 h 484525"/>
              <a:gd name="connsiteX109" fmla="*/ 965200 w 1128712"/>
              <a:gd name="connsiteY109" fmla="*/ 386100 h 484525"/>
              <a:gd name="connsiteX110" fmla="*/ 971550 w 1128712"/>
              <a:gd name="connsiteY110" fmla="*/ 384513 h 484525"/>
              <a:gd name="connsiteX111" fmla="*/ 982662 w 1128712"/>
              <a:gd name="connsiteY111" fmla="*/ 381338 h 484525"/>
              <a:gd name="connsiteX112" fmla="*/ 992187 w 1128712"/>
              <a:gd name="connsiteY112" fmla="*/ 382925 h 484525"/>
              <a:gd name="connsiteX113" fmla="*/ 998537 w 1128712"/>
              <a:gd name="connsiteY113" fmla="*/ 384513 h 484525"/>
              <a:gd name="connsiteX114" fmla="*/ 1019175 w 1128712"/>
              <a:gd name="connsiteY114" fmla="*/ 386100 h 484525"/>
              <a:gd name="connsiteX115" fmla="*/ 1128712 w 1128712"/>
              <a:gd name="connsiteY115" fmla="*/ 384513 h 484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</a:cxnLst>
            <a:rect l="l" t="t" r="r" b="b"/>
            <a:pathLst>
              <a:path w="1128712" h="484525">
                <a:moveTo>
                  <a:pt x="0" y="484525"/>
                </a:moveTo>
                <a:cubicBezTo>
                  <a:pt x="12700" y="483996"/>
                  <a:pt x="25419" y="483813"/>
                  <a:pt x="38100" y="482938"/>
                </a:cubicBezTo>
                <a:cubicBezTo>
                  <a:pt x="40792" y="482752"/>
                  <a:pt x="43344" y="481524"/>
                  <a:pt x="46037" y="481350"/>
                </a:cubicBezTo>
                <a:cubicBezTo>
                  <a:pt x="59777" y="480464"/>
                  <a:pt x="73558" y="480388"/>
                  <a:pt x="87312" y="479763"/>
                </a:cubicBezTo>
                <a:lnTo>
                  <a:pt x="150812" y="476588"/>
                </a:lnTo>
                <a:cubicBezTo>
                  <a:pt x="165962" y="471537"/>
                  <a:pt x="148877" y="476588"/>
                  <a:pt x="185737" y="476588"/>
                </a:cubicBezTo>
                <a:cubicBezTo>
                  <a:pt x="203120" y="476588"/>
                  <a:pt x="234798" y="474542"/>
                  <a:pt x="254000" y="473413"/>
                </a:cubicBezTo>
                <a:cubicBezTo>
                  <a:pt x="256327" y="473025"/>
                  <a:pt x="265071" y="472076"/>
                  <a:pt x="268287" y="470238"/>
                </a:cubicBezTo>
                <a:cubicBezTo>
                  <a:pt x="274773" y="466532"/>
                  <a:pt x="273842" y="464443"/>
                  <a:pt x="280987" y="462300"/>
                </a:cubicBezTo>
                <a:cubicBezTo>
                  <a:pt x="284070" y="461375"/>
                  <a:pt x="287337" y="461242"/>
                  <a:pt x="290512" y="460713"/>
                </a:cubicBezTo>
                <a:cubicBezTo>
                  <a:pt x="291041" y="457009"/>
                  <a:pt x="291115" y="453210"/>
                  <a:pt x="292100" y="449600"/>
                </a:cubicBezTo>
                <a:cubicBezTo>
                  <a:pt x="292723" y="447317"/>
                  <a:pt x="294343" y="445425"/>
                  <a:pt x="295275" y="443250"/>
                </a:cubicBezTo>
                <a:cubicBezTo>
                  <a:pt x="302282" y="426899"/>
                  <a:pt x="289506" y="453200"/>
                  <a:pt x="300037" y="432138"/>
                </a:cubicBezTo>
                <a:cubicBezTo>
                  <a:pt x="300566" y="418380"/>
                  <a:pt x="300709" y="404601"/>
                  <a:pt x="301625" y="390863"/>
                </a:cubicBezTo>
                <a:cubicBezTo>
                  <a:pt x="301770" y="388686"/>
                  <a:pt x="303127" y="386693"/>
                  <a:pt x="303212" y="384513"/>
                </a:cubicBezTo>
                <a:cubicBezTo>
                  <a:pt x="304187" y="359655"/>
                  <a:pt x="303825" y="334758"/>
                  <a:pt x="304800" y="309900"/>
                </a:cubicBezTo>
                <a:cubicBezTo>
                  <a:pt x="304885" y="307720"/>
                  <a:pt x="305997" y="305697"/>
                  <a:pt x="306387" y="303550"/>
                </a:cubicBezTo>
                <a:cubicBezTo>
                  <a:pt x="307056" y="299869"/>
                  <a:pt x="307446" y="296142"/>
                  <a:pt x="307975" y="292438"/>
                </a:cubicBezTo>
                <a:cubicBezTo>
                  <a:pt x="308593" y="280083"/>
                  <a:pt x="310276" y="245230"/>
                  <a:pt x="311150" y="232113"/>
                </a:cubicBezTo>
                <a:cubicBezTo>
                  <a:pt x="312508" y="211743"/>
                  <a:pt x="309319" y="218191"/>
                  <a:pt x="315912" y="208300"/>
                </a:cubicBezTo>
                <a:cubicBezTo>
                  <a:pt x="317442" y="202181"/>
                  <a:pt x="318379" y="199155"/>
                  <a:pt x="319087" y="192425"/>
                </a:cubicBezTo>
                <a:cubicBezTo>
                  <a:pt x="319809" y="185564"/>
                  <a:pt x="319988" y="178653"/>
                  <a:pt x="320675" y="171788"/>
                </a:cubicBezTo>
                <a:cubicBezTo>
                  <a:pt x="321047" y="168065"/>
                  <a:pt x="321612" y="164360"/>
                  <a:pt x="322262" y="160675"/>
                </a:cubicBezTo>
                <a:cubicBezTo>
                  <a:pt x="323200" y="155361"/>
                  <a:pt x="324841" y="150163"/>
                  <a:pt x="325437" y="144800"/>
                </a:cubicBezTo>
                <a:lnTo>
                  <a:pt x="327025" y="130513"/>
                </a:lnTo>
                <a:cubicBezTo>
                  <a:pt x="327554" y="120988"/>
                  <a:pt x="326666" y="111277"/>
                  <a:pt x="328612" y="101938"/>
                </a:cubicBezTo>
                <a:cubicBezTo>
                  <a:pt x="329390" y="98202"/>
                  <a:pt x="333755" y="96033"/>
                  <a:pt x="334962" y="92413"/>
                </a:cubicBezTo>
                <a:lnTo>
                  <a:pt x="336550" y="87650"/>
                </a:lnTo>
                <a:cubicBezTo>
                  <a:pt x="337079" y="80242"/>
                  <a:pt x="337359" y="72811"/>
                  <a:pt x="338137" y="65425"/>
                </a:cubicBezTo>
                <a:cubicBezTo>
                  <a:pt x="338409" y="62842"/>
                  <a:pt x="340481" y="54046"/>
                  <a:pt x="341312" y="51138"/>
                </a:cubicBezTo>
                <a:cubicBezTo>
                  <a:pt x="341772" y="49529"/>
                  <a:pt x="342440" y="47984"/>
                  <a:pt x="342900" y="46375"/>
                </a:cubicBezTo>
                <a:cubicBezTo>
                  <a:pt x="345463" y="37404"/>
                  <a:pt x="342828" y="42514"/>
                  <a:pt x="347662" y="35263"/>
                </a:cubicBezTo>
                <a:cubicBezTo>
                  <a:pt x="348191" y="32617"/>
                  <a:pt x="348397" y="29885"/>
                  <a:pt x="349250" y="27325"/>
                </a:cubicBezTo>
                <a:cubicBezTo>
                  <a:pt x="349998" y="25080"/>
                  <a:pt x="351493" y="23150"/>
                  <a:pt x="352425" y="20975"/>
                </a:cubicBezTo>
                <a:cubicBezTo>
                  <a:pt x="353084" y="19437"/>
                  <a:pt x="353552" y="17822"/>
                  <a:pt x="354012" y="16213"/>
                </a:cubicBezTo>
                <a:cubicBezTo>
                  <a:pt x="354611" y="14115"/>
                  <a:pt x="354390" y="11678"/>
                  <a:pt x="355600" y="9863"/>
                </a:cubicBezTo>
                <a:cubicBezTo>
                  <a:pt x="356658" y="8276"/>
                  <a:pt x="358775" y="7746"/>
                  <a:pt x="360362" y="6688"/>
                </a:cubicBezTo>
                <a:cubicBezTo>
                  <a:pt x="361343" y="5216"/>
                  <a:pt x="364465" y="-1580"/>
                  <a:pt x="368300" y="338"/>
                </a:cubicBezTo>
                <a:cubicBezTo>
                  <a:pt x="370666" y="1521"/>
                  <a:pt x="371053" y="4966"/>
                  <a:pt x="373062" y="6688"/>
                </a:cubicBezTo>
                <a:cubicBezTo>
                  <a:pt x="374859" y="8228"/>
                  <a:pt x="377343" y="8714"/>
                  <a:pt x="379412" y="9863"/>
                </a:cubicBezTo>
                <a:cubicBezTo>
                  <a:pt x="382109" y="11361"/>
                  <a:pt x="384590" y="13245"/>
                  <a:pt x="387350" y="14625"/>
                </a:cubicBezTo>
                <a:cubicBezTo>
                  <a:pt x="400491" y="21196"/>
                  <a:pt x="383229" y="10291"/>
                  <a:pt x="396875" y="19388"/>
                </a:cubicBezTo>
                <a:cubicBezTo>
                  <a:pt x="398462" y="21505"/>
                  <a:pt x="400454" y="23372"/>
                  <a:pt x="401637" y="25738"/>
                </a:cubicBezTo>
                <a:cubicBezTo>
                  <a:pt x="402613" y="27690"/>
                  <a:pt x="402142" y="30194"/>
                  <a:pt x="403225" y="32088"/>
                </a:cubicBezTo>
                <a:cubicBezTo>
                  <a:pt x="404339" y="34037"/>
                  <a:pt x="406550" y="35125"/>
                  <a:pt x="407987" y="36850"/>
                </a:cubicBezTo>
                <a:cubicBezTo>
                  <a:pt x="415491" y="45856"/>
                  <a:pt x="406567" y="37087"/>
                  <a:pt x="414337" y="47963"/>
                </a:cubicBezTo>
                <a:cubicBezTo>
                  <a:pt x="415642" y="49790"/>
                  <a:pt x="417512" y="51138"/>
                  <a:pt x="419100" y="52725"/>
                </a:cubicBezTo>
                <a:cubicBezTo>
                  <a:pt x="419629" y="55371"/>
                  <a:pt x="419740" y="58136"/>
                  <a:pt x="420687" y="60663"/>
                </a:cubicBezTo>
                <a:cubicBezTo>
                  <a:pt x="422675" y="65965"/>
                  <a:pt x="425376" y="65639"/>
                  <a:pt x="428625" y="70188"/>
                </a:cubicBezTo>
                <a:cubicBezTo>
                  <a:pt x="435950" y="80442"/>
                  <a:pt x="427174" y="73453"/>
                  <a:pt x="436562" y="79713"/>
                </a:cubicBezTo>
                <a:cubicBezTo>
                  <a:pt x="437091" y="81300"/>
                  <a:pt x="437669" y="82872"/>
                  <a:pt x="438150" y="84475"/>
                </a:cubicBezTo>
                <a:cubicBezTo>
                  <a:pt x="439257" y="88165"/>
                  <a:pt x="439343" y="92284"/>
                  <a:pt x="441325" y="95588"/>
                </a:cubicBezTo>
                <a:cubicBezTo>
                  <a:pt x="442686" y="97857"/>
                  <a:pt x="445558" y="98763"/>
                  <a:pt x="447675" y="100350"/>
                </a:cubicBezTo>
                <a:cubicBezTo>
                  <a:pt x="448733" y="102996"/>
                  <a:pt x="449849" y="105620"/>
                  <a:pt x="450850" y="108288"/>
                </a:cubicBezTo>
                <a:cubicBezTo>
                  <a:pt x="451437" y="109855"/>
                  <a:pt x="451689" y="111553"/>
                  <a:pt x="452437" y="113050"/>
                </a:cubicBezTo>
                <a:cubicBezTo>
                  <a:pt x="453290" y="114757"/>
                  <a:pt x="454759" y="116106"/>
                  <a:pt x="455612" y="117813"/>
                </a:cubicBezTo>
                <a:cubicBezTo>
                  <a:pt x="456360" y="119310"/>
                  <a:pt x="456155" y="121268"/>
                  <a:pt x="457200" y="122575"/>
                </a:cubicBezTo>
                <a:cubicBezTo>
                  <a:pt x="458392" y="124065"/>
                  <a:pt x="460496" y="124529"/>
                  <a:pt x="461962" y="125750"/>
                </a:cubicBezTo>
                <a:cubicBezTo>
                  <a:pt x="463687" y="127187"/>
                  <a:pt x="465288" y="128788"/>
                  <a:pt x="466725" y="130513"/>
                </a:cubicBezTo>
                <a:cubicBezTo>
                  <a:pt x="472249" y="137141"/>
                  <a:pt x="466844" y="134256"/>
                  <a:pt x="474662" y="136863"/>
                </a:cubicBezTo>
                <a:cubicBezTo>
                  <a:pt x="478741" y="153172"/>
                  <a:pt x="473196" y="132950"/>
                  <a:pt x="479425" y="149563"/>
                </a:cubicBezTo>
                <a:cubicBezTo>
                  <a:pt x="480191" y="151606"/>
                  <a:pt x="480385" y="153823"/>
                  <a:pt x="481012" y="155913"/>
                </a:cubicBezTo>
                <a:cubicBezTo>
                  <a:pt x="482325" y="160291"/>
                  <a:pt x="487440" y="176073"/>
                  <a:pt x="490537" y="178138"/>
                </a:cubicBezTo>
                <a:lnTo>
                  <a:pt x="495300" y="181313"/>
                </a:lnTo>
                <a:cubicBezTo>
                  <a:pt x="496358" y="182900"/>
                  <a:pt x="497622" y="184369"/>
                  <a:pt x="498475" y="186075"/>
                </a:cubicBezTo>
                <a:cubicBezTo>
                  <a:pt x="501058" y="191241"/>
                  <a:pt x="498686" y="191050"/>
                  <a:pt x="503237" y="195600"/>
                </a:cubicBezTo>
                <a:cubicBezTo>
                  <a:pt x="506314" y="198677"/>
                  <a:pt x="508889" y="199072"/>
                  <a:pt x="512762" y="200363"/>
                </a:cubicBezTo>
                <a:cubicBezTo>
                  <a:pt x="516625" y="205191"/>
                  <a:pt x="522718" y="212338"/>
                  <a:pt x="525462" y="217825"/>
                </a:cubicBezTo>
                <a:cubicBezTo>
                  <a:pt x="527978" y="222856"/>
                  <a:pt x="529277" y="226402"/>
                  <a:pt x="533400" y="230525"/>
                </a:cubicBezTo>
                <a:cubicBezTo>
                  <a:pt x="534749" y="231874"/>
                  <a:pt x="536575" y="232642"/>
                  <a:pt x="538162" y="233700"/>
                </a:cubicBezTo>
                <a:cubicBezTo>
                  <a:pt x="538691" y="235288"/>
                  <a:pt x="538567" y="237280"/>
                  <a:pt x="539750" y="238463"/>
                </a:cubicBezTo>
                <a:cubicBezTo>
                  <a:pt x="540933" y="239646"/>
                  <a:pt x="543120" y="239122"/>
                  <a:pt x="544512" y="240050"/>
                </a:cubicBezTo>
                <a:cubicBezTo>
                  <a:pt x="549532" y="243397"/>
                  <a:pt x="554534" y="246897"/>
                  <a:pt x="558800" y="251163"/>
                </a:cubicBezTo>
                <a:cubicBezTo>
                  <a:pt x="573163" y="265526"/>
                  <a:pt x="553196" y="246563"/>
                  <a:pt x="569912" y="259100"/>
                </a:cubicBezTo>
                <a:cubicBezTo>
                  <a:pt x="572307" y="260896"/>
                  <a:pt x="573989" y="263502"/>
                  <a:pt x="576262" y="265450"/>
                </a:cubicBezTo>
                <a:cubicBezTo>
                  <a:pt x="585897" y="273708"/>
                  <a:pt x="575940" y="261906"/>
                  <a:pt x="587375" y="274975"/>
                </a:cubicBezTo>
                <a:cubicBezTo>
                  <a:pt x="589117" y="276966"/>
                  <a:pt x="590415" y="279316"/>
                  <a:pt x="592137" y="281325"/>
                </a:cubicBezTo>
                <a:cubicBezTo>
                  <a:pt x="593598" y="283030"/>
                  <a:pt x="595553" y="284292"/>
                  <a:pt x="596900" y="286088"/>
                </a:cubicBezTo>
                <a:cubicBezTo>
                  <a:pt x="598751" y="288556"/>
                  <a:pt x="599654" y="291682"/>
                  <a:pt x="601662" y="294025"/>
                </a:cubicBezTo>
                <a:cubicBezTo>
                  <a:pt x="602904" y="295474"/>
                  <a:pt x="604872" y="296091"/>
                  <a:pt x="606425" y="297200"/>
                </a:cubicBezTo>
                <a:cubicBezTo>
                  <a:pt x="616037" y="304066"/>
                  <a:pt x="609260" y="300557"/>
                  <a:pt x="620712" y="305138"/>
                </a:cubicBezTo>
                <a:cubicBezTo>
                  <a:pt x="622829" y="307255"/>
                  <a:pt x="624626" y="309748"/>
                  <a:pt x="627062" y="311488"/>
                </a:cubicBezTo>
                <a:cubicBezTo>
                  <a:pt x="628424" y="312461"/>
                  <a:pt x="630518" y="312030"/>
                  <a:pt x="631825" y="313075"/>
                </a:cubicBezTo>
                <a:cubicBezTo>
                  <a:pt x="633315" y="314267"/>
                  <a:pt x="633534" y="316616"/>
                  <a:pt x="635000" y="317838"/>
                </a:cubicBezTo>
                <a:cubicBezTo>
                  <a:pt x="638558" y="320803"/>
                  <a:pt x="643427" y="321532"/>
                  <a:pt x="647700" y="322600"/>
                </a:cubicBezTo>
                <a:cubicBezTo>
                  <a:pt x="649287" y="324188"/>
                  <a:pt x="650737" y="325926"/>
                  <a:pt x="652462" y="327363"/>
                </a:cubicBezTo>
                <a:cubicBezTo>
                  <a:pt x="653928" y="328585"/>
                  <a:pt x="655876" y="329189"/>
                  <a:pt x="657225" y="330538"/>
                </a:cubicBezTo>
                <a:cubicBezTo>
                  <a:pt x="659096" y="332409"/>
                  <a:pt x="659786" y="335420"/>
                  <a:pt x="661987" y="336888"/>
                </a:cubicBezTo>
                <a:cubicBezTo>
                  <a:pt x="664772" y="338744"/>
                  <a:pt x="671512" y="340063"/>
                  <a:pt x="671512" y="340063"/>
                </a:cubicBezTo>
                <a:cubicBezTo>
                  <a:pt x="673100" y="341650"/>
                  <a:pt x="674267" y="343821"/>
                  <a:pt x="676275" y="344825"/>
                </a:cubicBezTo>
                <a:cubicBezTo>
                  <a:pt x="678688" y="346032"/>
                  <a:pt x="681594" y="345759"/>
                  <a:pt x="684212" y="346413"/>
                </a:cubicBezTo>
                <a:cubicBezTo>
                  <a:pt x="685836" y="346819"/>
                  <a:pt x="687341" y="347637"/>
                  <a:pt x="688975" y="348000"/>
                </a:cubicBezTo>
                <a:cubicBezTo>
                  <a:pt x="692117" y="348698"/>
                  <a:pt x="695325" y="349059"/>
                  <a:pt x="698500" y="349588"/>
                </a:cubicBezTo>
                <a:cubicBezTo>
                  <a:pt x="705712" y="353194"/>
                  <a:pt x="704684" y="352900"/>
                  <a:pt x="712787" y="355938"/>
                </a:cubicBezTo>
                <a:cubicBezTo>
                  <a:pt x="714354" y="356526"/>
                  <a:pt x="715926" y="357119"/>
                  <a:pt x="717550" y="357525"/>
                </a:cubicBezTo>
                <a:cubicBezTo>
                  <a:pt x="720168" y="358179"/>
                  <a:pt x="722841" y="358584"/>
                  <a:pt x="725487" y="359113"/>
                </a:cubicBezTo>
                <a:cubicBezTo>
                  <a:pt x="726545" y="360700"/>
                  <a:pt x="727006" y="362928"/>
                  <a:pt x="728662" y="363875"/>
                </a:cubicBezTo>
                <a:cubicBezTo>
                  <a:pt x="731005" y="365214"/>
                  <a:pt x="733908" y="365277"/>
                  <a:pt x="736600" y="365463"/>
                </a:cubicBezTo>
                <a:cubicBezTo>
                  <a:pt x="749281" y="366338"/>
                  <a:pt x="762000" y="366521"/>
                  <a:pt x="774700" y="367050"/>
                </a:cubicBezTo>
                <a:cubicBezTo>
                  <a:pt x="790109" y="372188"/>
                  <a:pt x="761809" y="363189"/>
                  <a:pt x="801687" y="370225"/>
                </a:cubicBezTo>
                <a:cubicBezTo>
                  <a:pt x="803566" y="370557"/>
                  <a:pt x="804706" y="372625"/>
                  <a:pt x="806450" y="373400"/>
                </a:cubicBezTo>
                <a:cubicBezTo>
                  <a:pt x="809508" y="374759"/>
                  <a:pt x="812674" y="376025"/>
                  <a:pt x="815975" y="376575"/>
                </a:cubicBezTo>
                <a:cubicBezTo>
                  <a:pt x="819150" y="377104"/>
                  <a:pt x="822377" y="377382"/>
                  <a:pt x="825500" y="378163"/>
                </a:cubicBezTo>
                <a:cubicBezTo>
                  <a:pt x="828747" y="378975"/>
                  <a:pt x="831850" y="380280"/>
                  <a:pt x="835025" y="381338"/>
                </a:cubicBezTo>
                <a:cubicBezTo>
                  <a:pt x="836612" y="381867"/>
                  <a:pt x="838127" y="382717"/>
                  <a:pt x="839787" y="382925"/>
                </a:cubicBezTo>
                <a:lnTo>
                  <a:pt x="852487" y="384513"/>
                </a:lnTo>
                <a:cubicBezTo>
                  <a:pt x="864129" y="383984"/>
                  <a:pt x="875758" y="382925"/>
                  <a:pt x="887412" y="382925"/>
                </a:cubicBezTo>
                <a:cubicBezTo>
                  <a:pt x="899076" y="382925"/>
                  <a:pt x="926975" y="380831"/>
                  <a:pt x="942975" y="387688"/>
                </a:cubicBezTo>
                <a:cubicBezTo>
                  <a:pt x="945150" y="388620"/>
                  <a:pt x="947208" y="389805"/>
                  <a:pt x="949325" y="390863"/>
                </a:cubicBezTo>
                <a:cubicBezTo>
                  <a:pt x="968722" y="387629"/>
                  <a:pt x="950429" y="391638"/>
                  <a:pt x="965200" y="386100"/>
                </a:cubicBezTo>
                <a:cubicBezTo>
                  <a:pt x="967243" y="385334"/>
                  <a:pt x="969452" y="385112"/>
                  <a:pt x="971550" y="384513"/>
                </a:cubicBezTo>
                <a:cubicBezTo>
                  <a:pt x="987492" y="379958"/>
                  <a:pt x="962810" y="386299"/>
                  <a:pt x="982662" y="381338"/>
                </a:cubicBezTo>
                <a:cubicBezTo>
                  <a:pt x="985837" y="381867"/>
                  <a:pt x="989031" y="382294"/>
                  <a:pt x="992187" y="382925"/>
                </a:cubicBezTo>
                <a:cubicBezTo>
                  <a:pt x="994326" y="383353"/>
                  <a:pt x="996370" y="384258"/>
                  <a:pt x="998537" y="384513"/>
                </a:cubicBezTo>
                <a:cubicBezTo>
                  <a:pt x="1005389" y="385319"/>
                  <a:pt x="1012296" y="385571"/>
                  <a:pt x="1019175" y="386100"/>
                </a:cubicBezTo>
                <a:lnTo>
                  <a:pt x="1128712" y="384513"/>
                </a:ln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F7FAD53E-46D9-2FF9-D02F-502773DAF573}"/>
              </a:ext>
            </a:extLst>
          </p:cNvPr>
          <p:cNvGrpSpPr/>
          <p:nvPr/>
        </p:nvGrpSpPr>
        <p:grpSpPr>
          <a:xfrm>
            <a:off x="1893938" y="4694362"/>
            <a:ext cx="1108075" cy="184319"/>
            <a:chOff x="2456920" y="5578306"/>
            <a:chExt cx="1108075" cy="184319"/>
          </a:xfrm>
        </p:grpSpPr>
        <p:sp>
          <p:nvSpPr>
            <p:cNvPr id="22" name="フリーフォーム: 図形 21">
              <a:extLst>
                <a:ext uri="{FF2B5EF4-FFF2-40B4-BE49-F238E27FC236}">
                  <a16:creationId xmlns:a16="http://schemas.microsoft.com/office/drawing/2014/main" id="{031A54C4-4498-A8BD-CEE8-13825BF0E33A}"/>
                </a:ext>
              </a:extLst>
            </p:cNvPr>
            <p:cNvSpPr/>
            <p:nvPr/>
          </p:nvSpPr>
          <p:spPr>
            <a:xfrm>
              <a:off x="2456920" y="5646738"/>
              <a:ext cx="739775" cy="115887"/>
            </a:xfrm>
            <a:custGeom>
              <a:avLst/>
              <a:gdLst>
                <a:gd name="connsiteX0" fmla="*/ 0 w 739775"/>
                <a:gd name="connsiteY0" fmla="*/ 33337 h 115887"/>
                <a:gd name="connsiteX1" fmla="*/ 36512 w 739775"/>
                <a:gd name="connsiteY1" fmla="*/ 30162 h 115887"/>
                <a:gd name="connsiteX2" fmla="*/ 71437 w 739775"/>
                <a:gd name="connsiteY2" fmla="*/ 26987 h 115887"/>
                <a:gd name="connsiteX3" fmla="*/ 211137 w 739775"/>
                <a:gd name="connsiteY3" fmla="*/ 23812 h 115887"/>
                <a:gd name="connsiteX4" fmla="*/ 249237 w 739775"/>
                <a:gd name="connsiteY4" fmla="*/ 20637 h 115887"/>
                <a:gd name="connsiteX5" fmla="*/ 280987 w 739775"/>
                <a:gd name="connsiteY5" fmla="*/ 14287 h 115887"/>
                <a:gd name="connsiteX6" fmla="*/ 282575 w 739775"/>
                <a:gd name="connsiteY6" fmla="*/ 7937 h 115887"/>
                <a:gd name="connsiteX7" fmla="*/ 290512 w 739775"/>
                <a:gd name="connsiteY7" fmla="*/ 9525 h 115887"/>
                <a:gd name="connsiteX8" fmla="*/ 292100 w 739775"/>
                <a:gd name="connsiteY8" fmla="*/ 25400 h 115887"/>
                <a:gd name="connsiteX9" fmla="*/ 295275 w 739775"/>
                <a:gd name="connsiteY9" fmla="*/ 34925 h 115887"/>
                <a:gd name="connsiteX10" fmla="*/ 296862 w 739775"/>
                <a:gd name="connsiteY10" fmla="*/ 39687 h 115887"/>
                <a:gd name="connsiteX11" fmla="*/ 303212 w 739775"/>
                <a:gd name="connsiteY11" fmla="*/ 52387 h 115887"/>
                <a:gd name="connsiteX12" fmla="*/ 306387 w 739775"/>
                <a:gd name="connsiteY12" fmla="*/ 60325 h 115887"/>
                <a:gd name="connsiteX13" fmla="*/ 315912 w 739775"/>
                <a:gd name="connsiteY13" fmla="*/ 76200 h 115887"/>
                <a:gd name="connsiteX14" fmla="*/ 317500 w 739775"/>
                <a:gd name="connsiteY14" fmla="*/ 80962 h 115887"/>
                <a:gd name="connsiteX15" fmla="*/ 319087 w 739775"/>
                <a:gd name="connsiteY15" fmla="*/ 87312 h 115887"/>
                <a:gd name="connsiteX16" fmla="*/ 323850 w 739775"/>
                <a:gd name="connsiteY16" fmla="*/ 95250 h 115887"/>
                <a:gd name="connsiteX17" fmla="*/ 330200 w 739775"/>
                <a:gd name="connsiteY17" fmla="*/ 104775 h 115887"/>
                <a:gd name="connsiteX18" fmla="*/ 334962 w 739775"/>
                <a:gd name="connsiteY18" fmla="*/ 106362 h 115887"/>
                <a:gd name="connsiteX19" fmla="*/ 347662 w 739775"/>
                <a:gd name="connsiteY19" fmla="*/ 112712 h 115887"/>
                <a:gd name="connsiteX20" fmla="*/ 360362 w 739775"/>
                <a:gd name="connsiteY20" fmla="*/ 115887 h 115887"/>
                <a:gd name="connsiteX21" fmla="*/ 379412 w 739775"/>
                <a:gd name="connsiteY21" fmla="*/ 114300 h 115887"/>
                <a:gd name="connsiteX22" fmla="*/ 415925 w 739775"/>
                <a:gd name="connsiteY22" fmla="*/ 107950 h 115887"/>
                <a:gd name="connsiteX23" fmla="*/ 422275 w 739775"/>
                <a:gd name="connsiteY23" fmla="*/ 104775 h 115887"/>
                <a:gd name="connsiteX24" fmla="*/ 427037 w 739775"/>
                <a:gd name="connsiteY24" fmla="*/ 101600 h 115887"/>
                <a:gd name="connsiteX25" fmla="*/ 441325 w 739775"/>
                <a:gd name="connsiteY25" fmla="*/ 95250 h 115887"/>
                <a:gd name="connsiteX26" fmla="*/ 454025 w 739775"/>
                <a:gd name="connsiteY26" fmla="*/ 93662 h 115887"/>
                <a:gd name="connsiteX27" fmla="*/ 460375 w 739775"/>
                <a:gd name="connsiteY27" fmla="*/ 88900 h 115887"/>
                <a:gd name="connsiteX28" fmla="*/ 466725 w 739775"/>
                <a:gd name="connsiteY28" fmla="*/ 87312 h 115887"/>
                <a:gd name="connsiteX29" fmla="*/ 477837 w 739775"/>
                <a:gd name="connsiteY29" fmla="*/ 82550 h 115887"/>
                <a:gd name="connsiteX30" fmla="*/ 495300 w 739775"/>
                <a:gd name="connsiteY30" fmla="*/ 71437 h 115887"/>
                <a:gd name="connsiteX31" fmla="*/ 500062 w 739775"/>
                <a:gd name="connsiteY31" fmla="*/ 65087 h 115887"/>
                <a:gd name="connsiteX32" fmla="*/ 506412 w 739775"/>
                <a:gd name="connsiteY32" fmla="*/ 63500 h 115887"/>
                <a:gd name="connsiteX33" fmla="*/ 511175 w 739775"/>
                <a:gd name="connsiteY33" fmla="*/ 61912 h 115887"/>
                <a:gd name="connsiteX34" fmla="*/ 515937 w 739775"/>
                <a:gd name="connsiteY34" fmla="*/ 57150 h 115887"/>
                <a:gd name="connsiteX35" fmla="*/ 528637 w 739775"/>
                <a:gd name="connsiteY35" fmla="*/ 52387 h 115887"/>
                <a:gd name="connsiteX36" fmla="*/ 534987 w 739775"/>
                <a:gd name="connsiteY36" fmla="*/ 47625 h 115887"/>
                <a:gd name="connsiteX37" fmla="*/ 554037 w 739775"/>
                <a:gd name="connsiteY37" fmla="*/ 44450 h 115887"/>
                <a:gd name="connsiteX38" fmla="*/ 563562 w 739775"/>
                <a:gd name="connsiteY38" fmla="*/ 38100 h 115887"/>
                <a:gd name="connsiteX39" fmla="*/ 574675 w 739775"/>
                <a:gd name="connsiteY39" fmla="*/ 34925 h 115887"/>
                <a:gd name="connsiteX40" fmla="*/ 581025 w 739775"/>
                <a:gd name="connsiteY40" fmla="*/ 31750 h 115887"/>
                <a:gd name="connsiteX41" fmla="*/ 592137 w 739775"/>
                <a:gd name="connsiteY41" fmla="*/ 26987 h 115887"/>
                <a:gd name="connsiteX42" fmla="*/ 603250 w 739775"/>
                <a:gd name="connsiteY42" fmla="*/ 20637 h 115887"/>
                <a:gd name="connsiteX43" fmla="*/ 619125 w 739775"/>
                <a:gd name="connsiteY43" fmla="*/ 19050 h 115887"/>
                <a:gd name="connsiteX44" fmla="*/ 625475 w 739775"/>
                <a:gd name="connsiteY44" fmla="*/ 17462 h 115887"/>
                <a:gd name="connsiteX45" fmla="*/ 642937 w 739775"/>
                <a:gd name="connsiteY45" fmla="*/ 12700 h 115887"/>
                <a:gd name="connsiteX46" fmla="*/ 650875 w 739775"/>
                <a:gd name="connsiteY46" fmla="*/ 11112 h 115887"/>
                <a:gd name="connsiteX47" fmla="*/ 660400 w 739775"/>
                <a:gd name="connsiteY47" fmla="*/ 7937 h 115887"/>
                <a:gd name="connsiteX48" fmla="*/ 688975 w 739775"/>
                <a:gd name="connsiteY48" fmla="*/ 4762 h 115887"/>
                <a:gd name="connsiteX49" fmla="*/ 698500 w 739775"/>
                <a:gd name="connsiteY49" fmla="*/ 3175 h 115887"/>
                <a:gd name="connsiteX50" fmla="*/ 731837 w 739775"/>
                <a:gd name="connsiteY50" fmla="*/ 1587 h 115887"/>
                <a:gd name="connsiteX51" fmla="*/ 739775 w 739775"/>
                <a:gd name="connsiteY51" fmla="*/ 0 h 1158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</a:cxnLst>
              <a:rect l="l" t="t" r="r" b="b"/>
              <a:pathLst>
                <a:path w="739775" h="115887">
                  <a:moveTo>
                    <a:pt x="0" y="33337"/>
                  </a:moveTo>
                  <a:cubicBezTo>
                    <a:pt x="12171" y="32279"/>
                    <a:pt x="24418" y="31889"/>
                    <a:pt x="36512" y="30162"/>
                  </a:cubicBezTo>
                  <a:cubicBezTo>
                    <a:pt x="53319" y="27762"/>
                    <a:pt x="48528" y="28162"/>
                    <a:pt x="71437" y="26987"/>
                  </a:cubicBezTo>
                  <a:cubicBezTo>
                    <a:pt x="123949" y="24294"/>
                    <a:pt x="148602" y="24789"/>
                    <a:pt x="211137" y="23812"/>
                  </a:cubicBezTo>
                  <a:cubicBezTo>
                    <a:pt x="238227" y="18396"/>
                    <a:pt x="181757" y="29289"/>
                    <a:pt x="249237" y="20637"/>
                  </a:cubicBezTo>
                  <a:cubicBezTo>
                    <a:pt x="259942" y="19264"/>
                    <a:pt x="270404" y="16404"/>
                    <a:pt x="280987" y="14287"/>
                  </a:cubicBezTo>
                  <a:cubicBezTo>
                    <a:pt x="281516" y="12170"/>
                    <a:pt x="280623" y="8913"/>
                    <a:pt x="282575" y="7937"/>
                  </a:cubicBezTo>
                  <a:cubicBezTo>
                    <a:pt x="284988" y="6730"/>
                    <a:pt x="289220" y="7156"/>
                    <a:pt x="290512" y="9525"/>
                  </a:cubicBezTo>
                  <a:cubicBezTo>
                    <a:pt x="293059" y="14194"/>
                    <a:pt x="291120" y="20173"/>
                    <a:pt x="292100" y="25400"/>
                  </a:cubicBezTo>
                  <a:cubicBezTo>
                    <a:pt x="292717" y="28689"/>
                    <a:pt x="294217" y="31750"/>
                    <a:pt x="295275" y="34925"/>
                  </a:cubicBezTo>
                  <a:cubicBezTo>
                    <a:pt x="295804" y="36512"/>
                    <a:pt x="296114" y="38190"/>
                    <a:pt x="296862" y="39687"/>
                  </a:cubicBezTo>
                  <a:cubicBezTo>
                    <a:pt x="298979" y="43920"/>
                    <a:pt x="301454" y="47992"/>
                    <a:pt x="303212" y="52387"/>
                  </a:cubicBezTo>
                  <a:cubicBezTo>
                    <a:pt x="304270" y="55033"/>
                    <a:pt x="305022" y="57823"/>
                    <a:pt x="306387" y="60325"/>
                  </a:cubicBezTo>
                  <a:cubicBezTo>
                    <a:pt x="313917" y="74130"/>
                    <a:pt x="311113" y="65004"/>
                    <a:pt x="315912" y="76200"/>
                  </a:cubicBezTo>
                  <a:cubicBezTo>
                    <a:pt x="316571" y="77738"/>
                    <a:pt x="317040" y="79353"/>
                    <a:pt x="317500" y="80962"/>
                  </a:cubicBezTo>
                  <a:cubicBezTo>
                    <a:pt x="318099" y="83060"/>
                    <a:pt x="318201" y="85318"/>
                    <a:pt x="319087" y="87312"/>
                  </a:cubicBezTo>
                  <a:cubicBezTo>
                    <a:pt x="320340" y="90132"/>
                    <a:pt x="322193" y="92647"/>
                    <a:pt x="323850" y="95250"/>
                  </a:cubicBezTo>
                  <a:cubicBezTo>
                    <a:pt x="325899" y="98469"/>
                    <a:pt x="326580" y="103569"/>
                    <a:pt x="330200" y="104775"/>
                  </a:cubicBezTo>
                  <a:cubicBezTo>
                    <a:pt x="331787" y="105304"/>
                    <a:pt x="333439" y="105670"/>
                    <a:pt x="334962" y="106362"/>
                  </a:cubicBezTo>
                  <a:cubicBezTo>
                    <a:pt x="339271" y="108320"/>
                    <a:pt x="343172" y="111215"/>
                    <a:pt x="347662" y="112712"/>
                  </a:cubicBezTo>
                  <a:cubicBezTo>
                    <a:pt x="354985" y="115153"/>
                    <a:pt x="350784" y="113972"/>
                    <a:pt x="360362" y="115887"/>
                  </a:cubicBezTo>
                  <a:cubicBezTo>
                    <a:pt x="366712" y="115358"/>
                    <a:pt x="373075" y="114967"/>
                    <a:pt x="379412" y="114300"/>
                  </a:cubicBezTo>
                  <a:cubicBezTo>
                    <a:pt x="391681" y="113009"/>
                    <a:pt x="403854" y="110364"/>
                    <a:pt x="415925" y="107950"/>
                  </a:cubicBezTo>
                  <a:cubicBezTo>
                    <a:pt x="418042" y="106892"/>
                    <a:pt x="420220" y="105949"/>
                    <a:pt x="422275" y="104775"/>
                  </a:cubicBezTo>
                  <a:cubicBezTo>
                    <a:pt x="423931" y="103828"/>
                    <a:pt x="425381" y="102547"/>
                    <a:pt x="427037" y="101600"/>
                  </a:cubicBezTo>
                  <a:cubicBezTo>
                    <a:pt x="429890" y="99970"/>
                    <a:pt x="438471" y="95909"/>
                    <a:pt x="441325" y="95250"/>
                  </a:cubicBezTo>
                  <a:cubicBezTo>
                    <a:pt x="445482" y="94291"/>
                    <a:pt x="449792" y="94191"/>
                    <a:pt x="454025" y="93662"/>
                  </a:cubicBezTo>
                  <a:cubicBezTo>
                    <a:pt x="456142" y="92075"/>
                    <a:pt x="458009" y="90083"/>
                    <a:pt x="460375" y="88900"/>
                  </a:cubicBezTo>
                  <a:cubicBezTo>
                    <a:pt x="462327" y="87924"/>
                    <a:pt x="464627" y="87911"/>
                    <a:pt x="466725" y="87312"/>
                  </a:cubicBezTo>
                  <a:cubicBezTo>
                    <a:pt x="470250" y="86305"/>
                    <a:pt x="474916" y="84595"/>
                    <a:pt x="477837" y="82550"/>
                  </a:cubicBezTo>
                  <a:cubicBezTo>
                    <a:pt x="494757" y="70705"/>
                    <a:pt x="479935" y="77583"/>
                    <a:pt x="495300" y="71437"/>
                  </a:cubicBezTo>
                  <a:cubicBezTo>
                    <a:pt x="496887" y="69320"/>
                    <a:pt x="497909" y="66625"/>
                    <a:pt x="500062" y="65087"/>
                  </a:cubicBezTo>
                  <a:cubicBezTo>
                    <a:pt x="501837" y="63819"/>
                    <a:pt x="504314" y="64099"/>
                    <a:pt x="506412" y="63500"/>
                  </a:cubicBezTo>
                  <a:cubicBezTo>
                    <a:pt x="508021" y="63040"/>
                    <a:pt x="509587" y="62441"/>
                    <a:pt x="511175" y="61912"/>
                  </a:cubicBezTo>
                  <a:cubicBezTo>
                    <a:pt x="512762" y="60325"/>
                    <a:pt x="514033" y="58340"/>
                    <a:pt x="515937" y="57150"/>
                  </a:cubicBezTo>
                  <a:cubicBezTo>
                    <a:pt x="518102" y="55797"/>
                    <a:pt x="525473" y="53442"/>
                    <a:pt x="528637" y="52387"/>
                  </a:cubicBezTo>
                  <a:cubicBezTo>
                    <a:pt x="530754" y="50800"/>
                    <a:pt x="532621" y="48808"/>
                    <a:pt x="534987" y="47625"/>
                  </a:cubicBezTo>
                  <a:cubicBezTo>
                    <a:pt x="538486" y="45875"/>
                    <a:pt x="552839" y="44600"/>
                    <a:pt x="554037" y="44450"/>
                  </a:cubicBezTo>
                  <a:cubicBezTo>
                    <a:pt x="565363" y="40674"/>
                    <a:pt x="551670" y="46028"/>
                    <a:pt x="563562" y="38100"/>
                  </a:cubicBezTo>
                  <a:cubicBezTo>
                    <a:pt x="564931" y="37188"/>
                    <a:pt x="573825" y="35138"/>
                    <a:pt x="574675" y="34925"/>
                  </a:cubicBezTo>
                  <a:cubicBezTo>
                    <a:pt x="576792" y="33867"/>
                    <a:pt x="578850" y="32682"/>
                    <a:pt x="581025" y="31750"/>
                  </a:cubicBezTo>
                  <a:cubicBezTo>
                    <a:pt x="587897" y="28804"/>
                    <a:pt x="584481" y="31772"/>
                    <a:pt x="592137" y="26987"/>
                  </a:cubicBezTo>
                  <a:cubicBezTo>
                    <a:pt x="597483" y="23646"/>
                    <a:pt x="597459" y="21528"/>
                    <a:pt x="603250" y="20637"/>
                  </a:cubicBezTo>
                  <a:cubicBezTo>
                    <a:pt x="608506" y="19828"/>
                    <a:pt x="613833" y="19579"/>
                    <a:pt x="619125" y="19050"/>
                  </a:cubicBezTo>
                  <a:cubicBezTo>
                    <a:pt x="621242" y="18521"/>
                    <a:pt x="623377" y="18061"/>
                    <a:pt x="625475" y="17462"/>
                  </a:cubicBezTo>
                  <a:cubicBezTo>
                    <a:pt x="636114" y="14422"/>
                    <a:pt x="624083" y="16472"/>
                    <a:pt x="642937" y="12700"/>
                  </a:cubicBezTo>
                  <a:cubicBezTo>
                    <a:pt x="645583" y="12171"/>
                    <a:pt x="648272" y="11822"/>
                    <a:pt x="650875" y="11112"/>
                  </a:cubicBezTo>
                  <a:cubicBezTo>
                    <a:pt x="654104" y="10231"/>
                    <a:pt x="657128" y="8638"/>
                    <a:pt x="660400" y="7937"/>
                  </a:cubicBezTo>
                  <a:cubicBezTo>
                    <a:pt x="664907" y="6971"/>
                    <a:pt x="685646" y="5178"/>
                    <a:pt x="688975" y="4762"/>
                  </a:cubicBezTo>
                  <a:cubicBezTo>
                    <a:pt x="692169" y="4363"/>
                    <a:pt x="695290" y="3413"/>
                    <a:pt x="698500" y="3175"/>
                  </a:cubicBezTo>
                  <a:cubicBezTo>
                    <a:pt x="709595" y="2353"/>
                    <a:pt x="720725" y="2116"/>
                    <a:pt x="731837" y="1587"/>
                  </a:cubicBezTo>
                  <a:lnTo>
                    <a:pt x="739775" y="0"/>
                  </a:lnTo>
                </a:path>
              </a:pathLst>
            </a:cu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23" name="フリーフォーム: 図形 22">
              <a:extLst>
                <a:ext uri="{FF2B5EF4-FFF2-40B4-BE49-F238E27FC236}">
                  <a16:creationId xmlns:a16="http://schemas.microsoft.com/office/drawing/2014/main" id="{41E28D00-922C-A923-1A38-5D4DBED75848}"/>
                </a:ext>
              </a:extLst>
            </p:cNvPr>
            <p:cNvSpPr/>
            <p:nvPr/>
          </p:nvSpPr>
          <p:spPr>
            <a:xfrm>
              <a:off x="3191932" y="5578306"/>
              <a:ext cx="373063" cy="70019"/>
            </a:xfrm>
            <a:custGeom>
              <a:avLst/>
              <a:gdLst>
                <a:gd name="connsiteX0" fmla="*/ 0 w 373063"/>
                <a:gd name="connsiteY0" fmla="*/ 70019 h 70019"/>
                <a:gd name="connsiteX1" fmla="*/ 12700 w 373063"/>
                <a:gd name="connsiteY1" fmla="*/ 65257 h 70019"/>
                <a:gd name="connsiteX2" fmla="*/ 23813 w 373063"/>
                <a:gd name="connsiteY2" fmla="*/ 63669 h 70019"/>
                <a:gd name="connsiteX3" fmla="*/ 28575 w 373063"/>
                <a:gd name="connsiteY3" fmla="*/ 62082 h 70019"/>
                <a:gd name="connsiteX4" fmla="*/ 38100 w 373063"/>
                <a:gd name="connsiteY4" fmla="*/ 57319 h 70019"/>
                <a:gd name="connsiteX5" fmla="*/ 47625 w 373063"/>
                <a:gd name="connsiteY5" fmla="*/ 55732 h 70019"/>
                <a:gd name="connsiteX6" fmla="*/ 58738 w 373063"/>
                <a:gd name="connsiteY6" fmla="*/ 52557 h 70019"/>
                <a:gd name="connsiteX7" fmla="*/ 63500 w 373063"/>
                <a:gd name="connsiteY7" fmla="*/ 50969 h 70019"/>
                <a:gd name="connsiteX8" fmla="*/ 73025 w 373063"/>
                <a:gd name="connsiteY8" fmla="*/ 49382 h 70019"/>
                <a:gd name="connsiteX9" fmla="*/ 85725 w 373063"/>
                <a:gd name="connsiteY9" fmla="*/ 46207 h 70019"/>
                <a:gd name="connsiteX10" fmla="*/ 104775 w 373063"/>
                <a:gd name="connsiteY10" fmla="*/ 43032 h 70019"/>
                <a:gd name="connsiteX11" fmla="*/ 120650 w 373063"/>
                <a:gd name="connsiteY11" fmla="*/ 38269 h 70019"/>
                <a:gd name="connsiteX12" fmla="*/ 139700 w 373063"/>
                <a:gd name="connsiteY12" fmla="*/ 35094 h 70019"/>
                <a:gd name="connsiteX13" fmla="*/ 150813 w 373063"/>
                <a:gd name="connsiteY13" fmla="*/ 31919 h 70019"/>
                <a:gd name="connsiteX14" fmla="*/ 163513 w 373063"/>
                <a:gd name="connsiteY14" fmla="*/ 28744 h 70019"/>
                <a:gd name="connsiteX15" fmla="*/ 168275 w 373063"/>
                <a:gd name="connsiteY15" fmla="*/ 27157 h 70019"/>
                <a:gd name="connsiteX16" fmla="*/ 177800 w 373063"/>
                <a:gd name="connsiteY16" fmla="*/ 25569 h 70019"/>
                <a:gd name="connsiteX17" fmla="*/ 196850 w 373063"/>
                <a:gd name="connsiteY17" fmla="*/ 19219 h 70019"/>
                <a:gd name="connsiteX18" fmla="*/ 242888 w 373063"/>
                <a:gd name="connsiteY18" fmla="*/ 16044 h 70019"/>
                <a:gd name="connsiteX19" fmla="*/ 250825 w 373063"/>
                <a:gd name="connsiteY19" fmla="*/ 14457 h 70019"/>
                <a:gd name="connsiteX20" fmla="*/ 268288 w 373063"/>
                <a:gd name="connsiteY20" fmla="*/ 12869 h 70019"/>
                <a:gd name="connsiteX21" fmla="*/ 273050 w 373063"/>
                <a:gd name="connsiteY21" fmla="*/ 9694 h 70019"/>
                <a:gd name="connsiteX22" fmla="*/ 293688 w 373063"/>
                <a:gd name="connsiteY22" fmla="*/ 6519 h 70019"/>
                <a:gd name="connsiteX23" fmla="*/ 333375 w 373063"/>
                <a:gd name="connsiteY23" fmla="*/ 1757 h 70019"/>
                <a:gd name="connsiteX24" fmla="*/ 373063 w 373063"/>
                <a:gd name="connsiteY24" fmla="*/ 169 h 700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</a:cxnLst>
              <a:rect l="l" t="t" r="r" b="b"/>
              <a:pathLst>
                <a:path w="373063" h="70019">
                  <a:moveTo>
                    <a:pt x="0" y="70019"/>
                  </a:moveTo>
                  <a:cubicBezTo>
                    <a:pt x="1018" y="69612"/>
                    <a:pt x="10209" y="65755"/>
                    <a:pt x="12700" y="65257"/>
                  </a:cubicBezTo>
                  <a:cubicBezTo>
                    <a:pt x="16369" y="64523"/>
                    <a:pt x="20109" y="64198"/>
                    <a:pt x="23813" y="63669"/>
                  </a:cubicBezTo>
                  <a:cubicBezTo>
                    <a:pt x="25400" y="63140"/>
                    <a:pt x="27078" y="62830"/>
                    <a:pt x="28575" y="62082"/>
                  </a:cubicBezTo>
                  <a:cubicBezTo>
                    <a:pt x="35422" y="58659"/>
                    <a:pt x="30921" y="58914"/>
                    <a:pt x="38100" y="57319"/>
                  </a:cubicBezTo>
                  <a:cubicBezTo>
                    <a:pt x="41242" y="56621"/>
                    <a:pt x="44489" y="56456"/>
                    <a:pt x="47625" y="55732"/>
                  </a:cubicBezTo>
                  <a:cubicBezTo>
                    <a:pt x="51379" y="54866"/>
                    <a:pt x="55048" y="53664"/>
                    <a:pt x="58738" y="52557"/>
                  </a:cubicBezTo>
                  <a:cubicBezTo>
                    <a:pt x="60341" y="52076"/>
                    <a:pt x="61867" y="51332"/>
                    <a:pt x="63500" y="50969"/>
                  </a:cubicBezTo>
                  <a:cubicBezTo>
                    <a:pt x="66642" y="50271"/>
                    <a:pt x="69858" y="49958"/>
                    <a:pt x="73025" y="49382"/>
                  </a:cubicBezTo>
                  <a:cubicBezTo>
                    <a:pt x="94461" y="45485"/>
                    <a:pt x="71051" y="49876"/>
                    <a:pt x="85725" y="46207"/>
                  </a:cubicBezTo>
                  <a:cubicBezTo>
                    <a:pt x="94515" y="44009"/>
                    <a:pt x="94897" y="44828"/>
                    <a:pt x="104775" y="43032"/>
                  </a:cubicBezTo>
                  <a:cubicBezTo>
                    <a:pt x="110962" y="41907"/>
                    <a:pt x="114285" y="40178"/>
                    <a:pt x="120650" y="38269"/>
                  </a:cubicBezTo>
                  <a:cubicBezTo>
                    <a:pt x="129575" y="35592"/>
                    <a:pt x="127894" y="37062"/>
                    <a:pt x="139700" y="35094"/>
                  </a:cubicBezTo>
                  <a:cubicBezTo>
                    <a:pt x="146509" y="33959"/>
                    <a:pt x="144874" y="33539"/>
                    <a:pt x="150813" y="31919"/>
                  </a:cubicBezTo>
                  <a:cubicBezTo>
                    <a:pt x="155023" y="30771"/>
                    <a:pt x="159373" y="30124"/>
                    <a:pt x="163513" y="28744"/>
                  </a:cubicBezTo>
                  <a:cubicBezTo>
                    <a:pt x="165100" y="28215"/>
                    <a:pt x="166642" y="27520"/>
                    <a:pt x="168275" y="27157"/>
                  </a:cubicBezTo>
                  <a:cubicBezTo>
                    <a:pt x="171417" y="26459"/>
                    <a:pt x="174677" y="26350"/>
                    <a:pt x="177800" y="25569"/>
                  </a:cubicBezTo>
                  <a:cubicBezTo>
                    <a:pt x="177980" y="25524"/>
                    <a:pt x="196737" y="19242"/>
                    <a:pt x="196850" y="19219"/>
                  </a:cubicBezTo>
                  <a:cubicBezTo>
                    <a:pt x="217252" y="15140"/>
                    <a:pt x="202092" y="17744"/>
                    <a:pt x="242888" y="16044"/>
                  </a:cubicBezTo>
                  <a:cubicBezTo>
                    <a:pt x="245534" y="15515"/>
                    <a:pt x="248148" y="14792"/>
                    <a:pt x="250825" y="14457"/>
                  </a:cubicBezTo>
                  <a:cubicBezTo>
                    <a:pt x="256625" y="13732"/>
                    <a:pt x="262573" y="14094"/>
                    <a:pt x="268288" y="12869"/>
                  </a:cubicBezTo>
                  <a:cubicBezTo>
                    <a:pt x="270153" y="12469"/>
                    <a:pt x="271296" y="10445"/>
                    <a:pt x="273050" y="9694"/>
                  </a:cubicBezTo>
                  <a:cubicBezTo>
                    <a:pt x="277859" y="7633"/>
                    <a:pt x="290827" y="6837"/>
                    <a:pt x="293688" y="6519"/>
                  </a:cubicBezTo>
                  <a:cubicBezTo>
                    <a:pt x="311663" y="2027"/>
                    <a:pt x="293797" y="6156"/>
                    <a:pt x="333375" y="1757"/>
                  </a:cubicBezTo>
                  <a:cubicBezTo>
                    <a:pt x="356078" y="-766"/>
                    <a:pt x="342871" y="169"/>
                    <a:pt x="373063" y="169"/>
                  </a:cubicBezTo>
                </a:path>
              </a:pathLst>
            </a:cu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24" name="フリーフォーム: 図形 23">
            <a:extLst>
              <a:ext uri="{FF2B5EF4-FFF2-40B4-BE49-F238E27FC236}">
                <a16:creationId xmlns:a16="http://schemas.microsoft.com/office/drawing/2014/main" id="{0CC738B4-07E3-2BC6-325A-74E51086AE48}"/>
              </a:ext>
            </a:extLst>
          </p:cNvPr>
          <p:cNvSpPr/>
          <p:nvPr/>
        </p:nvSpPr>
        <p:spPr>
          <a:xfrm>
            <a:off x="3939316" y="3358666"/>
            <a:ext cx="1244600" cy="1520015"/>
          </a:xfrm>
          <a:custGeom>
            <a:avLst/>
            <a:gdLst>
              <a:gd name="connsiteX0" fmla="*/ 0 w 1244600"/>
              <a:gd name="connsiteY0" fmla="*/ 1520015 h 1520015"/>
              <a:gd name="connsiteX1" fmla="*/ 40217 w 1244600"/>
              <a:gd name="connsiteY1" fmla="*/ 1517898 h 1520015"/>
              <a:gd name="connsiteX2" fmla="*/ 46567 w 1244600"/>
              <a:gd name="connsiteY2" fmla="*/ 1511548 h 1520015"/>
              <a:gd name="connsiteX3" fmla="*/ 74083 w 1244600"/>
              <a:gd name="connsiteY3" fmla="*/ 1513665 h 1520015"/>
              <a:gd name="connsiteX4" fmla="*/ 101600 w 1244600"/>
              <a:gd name="connsiteY4" fmla="*/ 1511548 h 1520015"/>
              <a:gd name="connsiteX5" fmla="*/ 107950 w 1244600"/>
              <a:gd name="connsiteY5" fmla="*/ 1509431 h 1520015"/>
              <a:gd name="connsiteX6" fmla="*/ 169333 w 1244600"/>
              <a:gd name="connsiteY6" fmla="*/ 1511548 h 1520015"/>
              <a:gd name="connsiteX7" fmla="*/ 228600 w 1244600"/>
              <a:gd name="connsiteY7" fmla="*/ 1509431 h 1520015"/>
              <a:gd name="connsiteX8" fmla="*/ 270933 w 1244600"/>
              <a:gd name="connsiteY8" fmla="*/ 1507315 h 1520015"/>
              <a:gd name="connsiteX9" fmla="*/ 279400 w 1244600"/>
              <a:gd name="connsiteY9" fmla="*/ 1503081 h 1520015"/>
              <a:gd name="connsiteX10" fmla="*/ 283633 w 1244600"/>
              <a:gd name="connsiteY10" fmla="*/ 1496731 h 1520015"/>
              <a:gd name="connsiteX11" fmla="*/ 285750 w 1244600"/>
              <a:gd name="connsiteY11" fmla="*/ 1490381 h 1520015"/>
              <a:gd name="connsiteX12" fmla="*/ 292100 w 1244600"/>
              <a:gd name="connsiteY12" fmla="*/ 1488265 h 1520015"/>
              <a:gd name="connsiteX13" fmla="*/ 298450 w 1244600"/>
              <a:gd name="connsiteY13" fmla="*/ 1484031 h 1520015"/>
              <a:gd name="connsiteX14" fmla="*/ 302683 w 1244600"/>
              <a:gd name="connsiteY14" fmla="*/ 1477681 h 1520015"/>
              <a:gd name="connsiteX15" fmla="*/ 306917 w 1244600"/>
              <a:gd name="connsiteY15" fmla="*/ 1473448 h 1520015"/>
              <a:gd name="connsiteX16" fmla="*/ 311150 w 1244600"/>
              <a:gd name="connsiteY16" fmla="*/ 1464981 h 1520015"/>
              <a:gd name="connsiteX17" fmla="*/ 315383 w 1244600"/>
              <a:gd name="connsiteY17" fmla="*/ 1448048 h 1520015"/>
              <a:gd name="connsiteX18" fmla="*/ 321733 w 1244600"/>
              <a:gd name="connsiteY18" fmla="*/ 1384548 h 1520015"/>
              <a:gd name="connsiteX19" fmla="*/ 325967 w 1244600"/>
              <a:gd name="connsiteY19" fmla="*/ 1376081 h 1520015"/>
              <a:gd name="connsiteX20" fmla="*/ 330200 w 1244600"/>
              <a:gd name="connsiteY20" fmla="*/ 1276598 h 1520015"/>
              <a:gd name="connsiteX21" fmla="*/ 332317 w 1244600"/>
              <a:gd name="connsiteY21" fmla="*/ 1266015 h 1520015"/>
              <a:gd name="connsiteX22" fmla="*/ 334433 w 1244600"/>
              <a:gd name="connsiteY22" fmla="*/ 1238498 h 1520015"/>
              <a:gd name="connsiteX23" fmla="*/ 338667 w 1244600"/>
              <a:gd name="connsiteY23" fmla="*/ 1181348 h 1520015"/>
              <a:gd name="connsiteX24" fmla="*/ 340783 w 1244600"/>
              <a:gd name="connsiteY24" fmla="*/ 1172881 h 1520015"/>
              <a:gd name="connsiteX25" fmla="*/ 342900 w 1244600"/>
              <a:gd name="connsiteY25" fmla="*/ 1079748 h 1520015"/>
              <a:gd name="connsiteX26" fmla="*/ 345017 w 1244600"/>
              <a:gd name="connsiteY26" fmla="*/ 1073398 h 1520015"/>
              <a:gd name="connsiteX27" fmla="*/ 347133 w 1244600"/>
              <a:gd name="connsiteY27" fmla="*/ 1062815 h 1520015"/>
              <a:gd name="connsiteX28" fmla="*/ 349250 w 1244600"/>
              <a:gd name="connsiteY28" fmla="*/ 1054348 h 1520015"/>
              <a:gd name="connsiteX29" fmla="*/ 351367 w 1244600"/>
              <a:gd name="connsiteY29" fmla="*/ 1035298 h 1520015"/>
              <a:gd name="connsiteX30" fmla="*/ 353483 w 1244600"/>
              <a:gd name="connsiteY30" fmla="*/ 1022598 h 1520015"/>
              <a:gd name="connsiteX31" fmla="*/ 355600 w 1244600"/>
              <a:gd name="connsiteY31" fmla="*/ 961215 h 1520015"/>
              <a:gd name="connsiteX32" fmla="*/ 361950 w 1244600"/>
              <a:gd name="connsiteY32" fmla="*/ 929465 h 1520015"/>
              <a:gd name="connsiteX33" fmla="*/ 364067 w 1244600"/>
              <a:gd name="connsiteY33" fmla="*/ 912531 h 1520015"/>
              <a:gd name="connsiteX34" fmla="*/ 366183 w 1244600"/>
              <a:gd name="connsiteY34" fmla="*/ 893481 h 1520015"/>
              <a:gd name="connsiteX35" fmla="*/ 370417 w 1244600"/>
              <a:gd name="connsiteY35" fmla="*/ 872315 h 1520015"/>
              <a:gd name="connsiteX36" fmla="*/ 372533 w 1244600"/>
              <a:gd name="connsiteY36" fmla="*/ 859615 h 1520015"/>
              <a:gd name="connsiteX37" fmla="*/ 374650 w 1244600"/>
              <a:gd name="connsiteY37" fmla="*/ 804581 h 1520015"/>
              <a:gd name="connsiteX38" fmla="*/ 376767 w 1244600"/>
              <a:gd name="connsiteY38" fmla="*/ 796115 h 1520015"/>
              <a:gd name="connsiteX39" fmla="*/ 378883 w 1244600"/>
              <a:gd name="connsiteY39" fmla="*/ 779181 h 1520015"/>
              <a:gd name="connsiteX40" fmla="*/ 381000 w 1244600"/>
              <a:gd name="connsiteY40" fmla="*/ 745315 h 1520015"/>
              <a:gd name="connsiteX41" fmla="*/ 385233 w 1244600"/>
              <a:gd name="connsiteY41" fmla="*/ 719915 h 1520015"/>
              <a:gd name="connsiteX42" fmla="*/ 389467 w 1244600"/>
              <a:gd name="connsiteY42" fmla="*/ 702981 h 1520015"/>
              <a:gd name="connsiteX43" fmla="*/ 391583 w 1244600"/>
              <a:gd name="connsiteY43" fmla="*/ 690281 h 1520015"/>
              <a:gd name="connsiteX44" fmla="*/ 395817 w 1244600"/>
              <a:gd name="connsiteY44" fmla="*/ 677581 h 1520015"/>
              <a:gd name="connsiteX45" fmla="*/ 397933 w 1244600"/>
              <a:gd name="connsiteY45" fmla="*/ 664881 h 1520015"/>
              <a:gd name="connsiteX46" fmla="*/ 402167 w 1244600"/>
              <a:gd name="connsiteY46" fmla="*/ 647948 h 1520015"/>
              <a:gd name="connsiteX47" fmla="*/ 408517 w 1244600"/>
              <a:gd name="connsiteY47" fmla="*/ 620431 h 1520015"/>
              <a:gd name="connsiteX48" fmla="*/ 414867 w 1244600"/>
              <a:gd name="connsiteY48" fmla="*/ 614081 h 1520015"/>
              <a:gd name="connsiteX49" fmla="*/ 419100 w 1244600"/>
              <a:gd name="connsiteY49" fmla="*/ 599265 h 1520015"/>
              <a:gd name="connsiteX50" fmla="*/ 421217 w 1244600"/>
              <a:gd name="connsiteY50" fmla="*/ 590798 h 1520015"/>
              <a:gd name="connsiteX51" fmla="*/ 425450 w 1244600"/>
              <a:gd name="connsiteY51" fmla="*/ 578098 h 1520015"/>
              <a:gd name="connsiteX52" fmla="*/ 429683 w 1244600"/>
              <a:gd name="connsiteY52" fmla="*/ 559048 h 1520015"/>
              <a:gd name="connsiteX53" fmla="*/ 431800 w 1244600"/>
              <a:gd name="connsiteY53" fmla="*/ 552698 h 1520015"/>
              <a:gd name="connsiteX54" fmla="*/ 436033 w 1244600"/>
              <a:gd name="connsiteY54" fmla="*/ 544231 h 1520015"/>
              <a:gd name="connsiteX55" fmla="*/ 440267 w 1244600"/>
              <a:gd name="connsiteY55" fmla="*/ 493431 h 1520015"/>
              <a:gd name="connsiteX56" fmla="*/ 442383 w 1244600"/>
              <a:gd name="connsiteY56" fmla="*/ 482848 h 1520015"/>
              <a:gd name="connsiteX57" fmla="*/ 450850 w 1244600"/>
              <a:gd name="connsiteY57" fmla="*/ 468031 h 1520015"/>
              <a:gd name="connsiteX58" fmla="*/ 457200 w 1244600"/>
              <a:gd name="connsiteY58" fmla="*/ 461681 h 1520015"/>
              <a:gd name="connsiteX59" fmla="*/ 459317 w 1244600"/>
              <a:gd name="connsiteY59" fmla="*/ 455331 h 1520015"/>
              <a:gd name="connsiteX60" fmla="*/ 463550 w 1244600"/>
              <a:gd name="connsiteY60" fmla="*/ 446865 h 1520015"/>
              <a:gd name="connsiteX61" fmla="*/ 465667 w 1244600"/>
              <a:gd name="connsiteY61" fmla="*/ 436281 h 1520015"/>
              <a:gd name="connsiteX62" fmla="*/ 469900 w 1244600"/>
              <a:gd name="connsiteY62" fmla="*/ 429931 h 1520015"/>
              <a:gd name="connsiteX63" fmla="*/ 474133 w 1244600"/>
              <a:gd name="connsiteY63" fmla="*/ 421465 h 1520015"/>
              <a:gd name="connsiteX64" fmla="*/ 482600 w 1244600"/>
              <a:gd name="connsiteY64" fmla="*/ 410881 h 1520015"/>
              <a:gd name="connsiteX65" fmla="*/ 491067 w 1244600"/>
              <a:gd name="connsiteY65" fmla="*/ 393948 h 1520015"/>
              <a:gd name="connsiteX66" fmla="*/ 497417 w 1244600"/>
              <a:gd name="connsiteY66" fmla="*/ 389715 h 1520015"/>
              <a:gd name="connsiteX67" fmla="*/ 499533 w 1244600"/>
              <a:gd name="connsiteY67" fmla="*/ 383365 h 1520015"/>
              <a:gd name="connsiteX68" fmla="*/ 503767 w 1244600"/>
              <a:gd name="connsiteY68" fmla="*/ 379131 h 1520015"/>
              <a:gd name="connsiteX69" fmla="*/ 505883 w 1244600"/>
              <a:gd name="connsiteY69" fmla="*/ 370665 h 1520015"/>
              <a:gd name="connsiteX70" fmla="*/ 510117 w 1244600"/>
              <a:gd name="connsiteY70" fmla="*/ 364315 h 1520015"/>
              <a:gd name="connsiteX71" fmla="*/ 520700 w 1244600"/>
              <a:gd name="connsiteY71" fmla="*/ 338915 h 1520015"/>
              <a:gd name="connsiteX72" fmla="*/ 524933 w 1244600"/>
              <a:gd name="connsiteY72" fmla="*/ 334681 h 1520015"/>
              <a:gd name="connsiteX73" fmla="*/ 527050 w 1244600"/>
              <a:gd name="connsiteY73" fmla="*/ 328331 h 1520015"/>
              <a:gd name="connsiteX74" fmla="*/ 537633 w 1244600"/>
              <a:gd name="connsiteY74" fmla="*/ 313515 h 1520015"/>
              <a:gd name="connsiteX75" fmla="*/ 554567 w 1244600"/>
              <a:gd name="connsiteY75" fmla="*/ 294465 h 1520015"/>
              <a:gd name="connsiteX76" fmla="*/ 565150 w 1244600"/>
              <a:gd name="connsiteY76" fmla="*/ 283881 h 1520015"/>
              <a:gd name="connsiteX77" fmla="*/ 571500 w 1244600"/>
              <a:gd name="connsiteY77" fmla="*/ 279648 h 1520015"/>
              <a:gd name="connsiteX78" fmla="*/ 573617 w 1244600"/>
              <a:gd name="connsiteY78" fmla="*/ 273298 h 1520015"/>
              <a:gd name="connsiteX79" fmla="*/ 579967 w 1244600"/>
              <a:gd name="connsiteY79" fmla="*/ 271181 h 1520015"/>
              <a:gd name="connsiteX80" fmla="*/ 586317 w 1244600"/>
              <a:gd name="connsiteY80" fmla="*/ 266948 h 1520015"/>
              <a:gd name="connsiteX81" fmla="*/ 594783 w 1244600"/>
              <a:gd name="connsiteY81" fmla="*/ 254248 h 1520015"/>
              <a:gd name="connsiteX82" fmla="*/ 605367 w 1244600"/>
              <a:gd name="connsiteY82" fmla="*/ 245781 h 1520015"/>
              <a:gd name="connsiteX83" fmla="*/ 613833 w 1244600"/>
              <a:gd name="connsiteY83" fmla="*/ 233081 h 1520015"/>
              <a:gd name="connsiteX84" fmla="*/ 630767 w 1244600"/>
              <a:gd name="connsiteY84" fmla="*/ 220381 h 1520015"/>
              <a:gd name="connsiteX85" fmla="*/ 643467 w 1244600"/>
              <a:gd name="connsiteY85" fmla="*/ 214031 h 1520015"/>
              <a:gd name="connsiteX86" fmla="*/ 660400 w 1244600"/>
              <a:gd name="connsiteY86" fmla="*/ 199215 h 1520015"/>
              <a:gd name="connsiteX87" fmla="*/ 679450 w 1244600"/>
              <a:gd name="connsiteY87" fmla="*/ 190748 h 1520015"/>
              <a:gd name="connsiteX88" fmla="*/ 685800 w 1244600"/>
              <a:gd name="connsiteY88" fmla="*/ 184398 h 1520015"/>
              <a:gd name="connsiteX89" fmla="*/ 696383 w 1244600"/>
              <a:gd name="connsiteY89" fmla="*/ 171698 h 1520015"/>
              <a:gd name="connsiteX90" fmla="*/ 702733 w 1244600"/>
              <a:gd name="connsiteY90" fmla="*/ 169581 h 1520015"/>
              <a:gd name="connsiteX91" fmla="*/ 711200 w 1244600"/>
              <a:gd name="connsiteY91" fmla="*/ 163231 h 1520015"/>
              <a:gd name="connsiteX92" fmla="*/ 717550 w 1244600"/>
              <a:gd name="connsiteY92" fmla="*/ 156881 h 1520015"/>
              <a:gd name="connsiteX93" fmla="*/ 734483 w 1244600"/>
              <a:gd name="connsiteY93" fmla="*/ 152648 h 1520015"/>
              <a:gd name="connsiteX94" fmla="*/ 742950 w 1244600"/>
              <a:gd name="connsiteY94" fmla="*/ 148415 h 1520015"/>
              <a:gd name="connsiteX95" fmla="*/ 749300 w 1244600"/>
              <a:gd name="connsiteY95" fmla="*/ 146298 h 1520015"/>
              <a:gd name="connsiteX96" fmla="*/ 759883 w 1244600"/>
              <a:gd name="connsiteY96" fmla="*/ 139948 h 1520015"/>
              <a:gd name="connsiteX97" fmla="*/ 766233 w 1244600"/>
              <a:gd name="connsiteY97" fmla="*/ 135715 h 1520015"/>
              <a:gd name="connsiteX98" fmla="*/ 791633 w 1244600"/>
              <a:gd name="connsiteY98" fmla="*/ 129365 h 1520015"/>
              <a:gd name="connsiteX99" fmla="*/ 804333 w 1244600"/>
              <a:gd name="connsiteY99" fmla="*/ 123015 h 1520015"/>
              <a:gd name="connsiteX100" fmla="*/ 808567 w 1244600"/>
              <a:gd name="connsiteY100" fmla="*/ 118781 h 1520015"/>
              <a:gd name="connsiteX101" fmla="*/ 814917 w 1244600"/>
              <a:gd name="connsiteY101" fmla="*/ 116665 h 1520015"/>
              <a:gd name="connsiteX102" fmla="*/ 821267 w 1244600"/>
              <a:gd name="connsiteY102" fmla="*/ 110315 h 1520015"/>
              <a:gd name="connsiteX103" fmla="*/ 838200 w 1244600"/>
              <a:gd name="connsiteY103" fmla="*/ 101848 h 1520015"/>
              <a:gd name="connsiteX104" fmla="*/ 855133 w 1244600"/>
              <a:gd name="connsiteY104" fmla="*/ 97615 h 1520015"/>
              <a:gd name="connsiteX105" fmla="*/ 878417 w 1244600"/>
              <a:gd name="connsiteY105" fmla="*/ 93381 h 1520015"/>
              <a:gd name="connsiteX106" fmla="*/ 884767 w 1244600"/>
              <a:gd name="connsiteY106" fmla="*/ 89148 h 1520015"/>
              <a:gd name="connsiteX107" fmla="*/ 897467 w 1244600"/>
              <a:gd name="connsiteY107" fmla="*/ 84915 h 1520015"/>
              <a:gd name="connsiteX108" fmla="*/ 912283 w 1244600"/>
              <a:gd name="connsiteY108" fmla="*/ 80681 h 1520015"/>
              <a:gd name="connsiteX109" fmla="*/ 918633 w 1244600"/>
              <a:gd name="connsiteY109" fmla="*/ 76448 h 1520015"/>
              <a:gd name="connsiteX110" fmla="*/ 929217 w 1244600"/>
              <a:gd name="connsiteY110" fmla="*/ 74331 h 1520015"/>
              <a:gd name="connsiteX111" fmla="*/ 937683 w 1244600"/>
              <a:gd name="connsiteY111" fmla="*/ 72215 h 1520015"/>
              <a:gd name="connsiteX112" fmla="*/ 956733 w 1244600"/>
              <a:gd name="connsiteY112" fmla="*/ 65865 h 1520015"/>
              <a:gd name="connsiteX113" fmla="*/ 965200 w 1244600"/>
              <a:gd name="connsiteY113" fmla="*/ 61631 h 1520015"/>
              <a:gd name="connsiteX114" fmla="*/ 973667 w 1244600"/>
              <a:gd name="connsiteY114" fmla="*/ 59515 h 1520015"/>
              <a:gd name="connsiteX115" fmla="*/ 988483 w 1244600"/>
              <a:gd name="connsiteY115" fmla="*/ 53165 h 1520015"/>
              <a:gd name="connsiteX116" fmla="*/ 994833 w 1244600"/>
              <a:gd name="connsiteY116" fmla="*/ 48931 h 1520015"/>
              <a:gd name="connsiteX117" fmla="*/ 1028700 w 1244600"/>
              <a:gd name="connsiteY117" fmla="*/ 42581 h 1520015"/>
              <a:gd name="connsiteX118" fmla="*/ 1054100 w 1244600"/>
              <a:gd name="connsiteY118" fmla="*/ 34115 h 1520015"/>
              <a:gd name="connsiteX119" fmla="*/ 1075267 w 1244600"/>
              <a:gd name="connsiteY119" fmla="*/ 27765 h 1520015"/>
              <a:gd name="connsiteX120" fmla="*/ 1092200 w 1244600"/>
              <a:gd name="connsiteY120" fmla="*/ 25648 h 1520015"/>
              <a:gd name="connsiteX121" fmla="*/ 1107017 w 1244600"/>
              <a:gd name="connsiteY121" fmla="*/ 23531 h 1520015"/>
              <a:gd name="connsiteX122" fmla="*/ 1121833 w 1244600"/>
              <a:gd name="connsiteY122" fmla="*/ 19298 h 1520015"/>
              <a:gd name="connsiteX123" fmla="*/ 1140883 w 1244600"/>
              <a:gd name="connsiteY123" fmla="*/ 17181 h 1520015"/>
              <a:gd name="connsiteX124" fmla="*/ 1162050 w 1244600"/>
              <a:gd name="connsiteY124" fmla="*/ 10831 h 1520015"/>
              <a:gd name="connsiteX125" fmla="*/ 1168400 w 1244600"/>
              <a:gd name="connsiteY125" fmla="*/ 8715 h 1520015"/>
              <a:gd name="connsiteX126" fmla="*/ 1187450 w 1244600"/>
              <a:gd name="connsiteY126" fmla="*/ 4481 h 1520015"/>
              <a:gd name="connsiteX127" fmla="*/ 1204383 w 1244600"/>
              <a:gd name="connsiteY127" fmla="*/ 248 h 1520015"/>
              <a:gd name="connsiteX128" fmla="*/ 1244600 w 1244600"/>
              <a:gd name="connsiteY128" fmla="*/ 248 h 15200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</a:cxnLst>
            <a:rect l="l" t="t" r="r" b="b"/>
            <a:pathLst>
              <a:path w="1244600" h="1520015">
                <a:moveTo>
                  <a:pt x="0" y="1520015"/>
                </a:moveTo>
                <a:cubicBezTo>
                  <a:pt x="13406" y="1519309"/>
                  <a:pt x="27009" y="1520299"/>
                  <a:pt x="40217" y="1517898"/>
                </a:cubicBezTo>
                <a:cubicBezTo>
                  <a:pt x="43162" y="1517363"/>
                  <a:pt x="43597" y="1511919"/>
                  <a:pt x="46567" y="1511548"/>
                </a:cubicBezTo>
                <a:cubicBezTo>
                  <a:pt x="55695" y="1510407"/>
                  <a:pt x="64911" y="1512959"/>
                  <a:pt x="74083" y="1513665"/>
                </a:cubicBezTo>
                <a:cubicBezTo>
                  <a:pt x="83255" y="1512959"/>
                  <a:pt x="92472" y="1512689"/>
                  <a:pt x="101600" y="1511548"/>
                </a:cubicBezTo>
                <a:cubicBezTo>
                  <a:pt x="103814" y="1511271"/>
                  <a:pt x="105719" y="1509431"/>
                  <a:pt x="107950" y="1509431"/>
                </a:cubicBezTo>
                <a:cubicBezTo>
                  <a:pt x="128423" y="1509431"/>
                  <a:pt x="148872" y="1510842"/>
                  <a:pt x="169333" y="1511548"/>
                </a:cubicBezTo>
                <a:cubicBezTo>
                  <a:pt x="194723" y="1517896"/>
                  <a:pt x="172342" y="1513267"/>
                  <a:pt x="228600" y="1509431"/>
                </a:cubicBezTo>
                <a:cubicBezTo>
                  <a:pt x="242696" y="1508470"/>
                  <a:pt x="256822" y="1508020"/>
                  <a:pt x="270933" y="1507315"/>
                </a:cubicBezTo>
                <a:cubicBezTo>
                  <a:pt x="273755" y="1505904"/>
                  <a:pt x="276976" y="1505101"/>
                  <a:pt x="279400" y="1503081"/>
                </a:cubicBezTo>
                <a:cubicBezTo>
                  <a:pt x="281354" y="1501452"/>
                  <a:pt x="282495" y="1499006"/>
                  <a:pt x="283633" y="1496731"/>
                </a:cubicBezTo>
                <a:cubicBezTo>
                  <a:pt x="284631" y="1494735"/>
                  <a:pt x="284172" y="1491959"/>
                  <a:pt x="285750" y="1490381"/>
                </a:cubicBezTo>
                <a:cubicBezTo>
                  <a:pt x="287328" y="1488803"/>
                  <a:pt x="289983" y="1488970"/>
                  <a:pt x="292100" y="1488265"/>
                </a:cubicBezTo>
                <a:cubicBezTo>
                  <a:pt x="294217" y="1486854"/>
                  <a:pt x="296651" y="1485830"/>
                  <a:pt x="298450" y="1484031"/>
                </a:cubicBezTo>
                <a:cubicBezTo>
                  <a:pt x="300249" y="1482232"/>
                  <a:pt x="301094" y="1479667"/>
                  <a:pt x="302683" y="1477681"/>
                </a:cubicBezTo>
                <a:cubicBezTo>
                  <a:pt x="303930" y="1476123"/>
                  <a:pt x="305506" y="1474859"/>
                  <a:pt x="306917" y="1473448"/>
                </a:cubicBezTo>
                <a:cubicBezTo>
                  <a:pt x="308328" y="1470626"/>
                  <a:pt x="310152" y="1467974"/>
                  <a:pt x="311150" y="1464981"/>
                </a:cubicBezTo>
                <a:cubicBezTo>
                  <a:pt x="312990" y="1459461"/>
                  <a:pt x="315383" y="1448048"/>
                  <a:pt x="315383" y="1448048"/>
                </a:cubicBezTo>
                <a:cubicBezTo>
                  <a:pt x="315566" y="1444380"/>
                  <a:pt x="315897" y="1396218"/>
                  <a:pt x="321733" y="1384548"/>
                </a:cubicBezTo>
                <a:lnTo>
                  <a:pt x="325967" y="1376081"/>
                </a:lnTo>
                <a:cubicBezTo>
                  <a:pt x="335641" y="1337378"/>
                  <a:pt x="325940" y="1378827"/>
                  <a:pt x="330200" y="1276598"/>
                </a:cubicBezTo>
                <a:cubicBezTo>
                  <a:pt x="330350" y="1273004"/>
                  <a:pt x="331611" y="1269543"/>
                  <a:pt x="332317" y="1266015"/>
                </a:cubicBezTo>
                <a:cubicBezTo>
                  <a:pt x="333022" y="1256843"/>
                  <a:pt x="333877" y="1247681"/>
                  <a:pt x="334433" y="1238498"/>
                </a:cubicBezTo>
                <a:cubicBezTo>
                  <a:pt x="335964" y="1213242"/>
                  <a:pt x="334847" y="1202362"/>
                  <a:pt x="338667" y="1181348"/>
                </a:cubicBezTo>
                <a:cubicBezTo>
                  <a:pt x="339187" y="1178486"/>
                  <a:pt x="340078" y="1175703"/>
                  <a:pt x="340783" y="1172881"/>
                </a:cubicBezTo>
                <a:cubicBezTo>
                  <a:pt x="341489" y="1141837"/>
                  <a:pt x="341580" y="1110772"/>
                  <a:pt x="342900" y="1079748"/>
                </a:cubicBezTo>
                <a:cubicBezTo>
                  <a:pt x="342995" y="1077519"/>
                  <a:pt x="344476" y="1075563"/>
                  <a:pt x="345017" y="1073398"/>
                </a:cubicBezTo>
                <a:cubicBezTo>
                  <a:pt x="345889" y="1069908"/>
                  <a:pt x="346353" y="1066327"/>
                  <a:pt x="347133" y="1062815"/>
                </a:cubicBezTo>
                <a:cubicBezTo>
                  <a:pt x="347764" y="1059975"/>
                  <a:pt x="348544" y="1057170"/>
                  <a:pt x="349250" y="1054348"/>
                </a:cubicBezTo>
                <a:cubicBezTo>
                  <a:pt x="349956" y="1047998"/>
                  <a:pt x="350523" y="1041631"/>
                  <a:pt x="351367" y="1035298"/>
                </a:cubicBezTo>
                <a:cubicBezTo>
                  <a:pt x="351934" y="1031044"/>
                  <a:pt x="353238" y="1026883"/>
                  <a:pt x="353483" y="1022598"/>
                </a:cubicBezTo>
                <a:cubicBezTo>
                  <a:pt x="354651" y="1002158"/>
                  <a:pt x="354030" y="981628"/>
                  <a:pt x="355600" y="961215"/>
                </a:cubicBezTo>
                <a:cubicBezTo>
                  <a:pt x="356872" y="944675"/>
                  <a:pt x="360255" y="943026"/>
                  <a:pt x="361950" y="929465"/>
                </a:cubicBezTo>
                <a:cubicBezTo>
                  <a:pt x="362656" y="923820"/>
                  <a:pt x="363402" y="918181"/>
                  <a:pt x="364067" y="912531"/>
                </a:cubicBezTo>
                <a:cubicBezTo>
                  <a:pt x="364813" y="906186"/>
                  <a:pt x="365339" y="899814"/>
                  <a:pt x="366183" y="893481"/>
                </a:cubicBezTo>
                <a:cubicBezTo>
                  <a:pt x="369085" y="871711"/>
                  <a:pt x="367051" y="889147"/>
                  <a:pt x="370417" y="872315"/>
                </a:cubicBezTo>
                <a:cubicBezTo>
                  <a:pt x="371259" y="868107"/>
                  <a:pt x="371828" y="863848"/>
                  <a:pt x="372533" y="859615"/>
                </a:cubicBezTo>
                <a:cubicBezTo>
                  <a:pt x="373239" y="841270"/>
                  <a:pt x="373429" y="822899"/>
                  <a:pt x="374650" y="804581"/>
                </a:cubicBezTo>
                <a:cubicBezTo>
                  <a:pt x="374844" y="801679"/>
                  <a:pt x="376289" y="798984"/>
                  <a:pt x="376767" y="796115"/>
                </a:cubicBezTo>
                <a:cubicBezTo>
                  <a:pt x="377702" y="790504"/>
                  <a:pt x="378411" y="784850"/>
                  <a:pt x="378883" y="779181"/>
                </a:cubicBezTo>
                <a:cubicBezTo>
                  <a:pt x="379822" y="767909"/>
                  <a:pt x="379795" y="756561"/>
                  <a:pt x="381000" y="745315"/>
                </a:cubicBezTo>
                <a:cubicBezTo>
                  <a:pt x="381914" y="736780"/>
                  <a:pt x="382518" y="728058"/>
                  <a:pt x="385233" y="719915"/>
                </a:cubicBezTo>
                <a:cubicBezTo>
                  <a:pt x="388171" y="711104"/>
                  <a:pt x="387424" y="714218"/>
                  <a:pt x="389467" y="702981"/>
                </a:cubicBezTo>
                <a:cubicBezTo>
                  <a:pt x="390235" y="698759"/>
                  <a:pt x="390542" y="694445"/>
                  <a:pt x="391583" y="690281"/>
                </a:cubicBezTo>
                <a:cubicBezTo>
                  <a:pt x="392665" y="685952"/>
                  <a:pt x="395817" y="677581"/>
                  <a:pt x="395817" y="677581"/>
                </a:cubicBezTo>
                <a:cubicBezTo>
                  <a:pt x="396522" y="673348"/>
                  <a:pt x="397034" y="669077"/>
                  <a:pt x="397933" y="664881"/>
                </a:cubicBezTo>
                <a:cubicBezTo>
                  <a:pt x="399152" y="659192"/>
                  <a:pt x="401344" y="653708"/>
                  <a:pt x="402167" y="647948"/>
                </a:cubicBezTo>
                <a:cubicBezTo>
                  <a:pt x="402749" y="643871"/>
                  <a:pt x="404641" y="624307"/>
                  <a:pt x="408517" y="620431"/>
                </a:cubicBezTo>
                <a:lnTo>
                  <a:pt x="414867" y="614081"/>
                </a:lnTo>
                <a:cubicBezTo>
                  <a:pt x="421472" y="587654"/>
                  <a:pt x="413035" y="620491"/>
                  <a:pt x="419100" y="599265"/>
                </a:cubicBezTo>
                <a:cubicBezTo>
                  <a:pt x="419899" y="596468"/>
                  <a:pt x="420381" y="593585"/>
                  <a:pt x="421217" y="590798"/>
                </a:cubicBezTo>
                <a:cubicBezTo>
                  <a:pt x="422499" y="586524"/>
                  <a:pt x="424575" y="582474"/>
                  <a:pt x="425450" y="578098"/>
                </a:cubicBezTo>
                <a:cubicBezTo>
                  <a:pt x="426902" y="570839"/>
                  <a:pt x="427694" y="566011"/>
                  <a:pt x="429683" y="559048"/>
                </a:cubicBezTo>
                <a:cubicBezTo>
                  <a:pt x="430296" y="556903"/>
                  <a:pt x="430921" y="554749"/>
                  <a:pt x="431800" y="552698"/>
                </a:cubicBezTo>
                <a:cubicBezTo>
                  <a:pt x="433043" y="549798"/>
                  <a:pt x="434622" y="547053"/>
                  <a:pt x="436033" y="544231"/>
                </a:cubicBezTo>
                <a:cubicBezTo>
                  <a:pt x="437890" y="510804"/>
                  <a:pt x="436227" y="515655"/>
                  <a:pt x="440267" y="493431"/>
                </a:cubicBezTo>
                <a:cubicBezTo>
                  <a:pt x="440910" y="489892"/>
                  <a:pt x="441245" y="486261"/>
                  <a:pt x="442383" y="482848"/>
                </a:cubicBezTo>
                <a:cubicBezTo>
                  <a:pt x="443532" y="479400"/>
                  <a:pt x="448271" y="471126"/>
                  <a:pt x="450850" y="468031"/>
                </a:cubicBezTo>
                <a:cubicBezTo>
                  <a:pt x="452766" y="465731"/>
                  <a:pt x="455083" y="463798"/>
                  <a:pt x="457200" y="461681"/>
                </a:cubicBezTo>
                <a:cubicBezTo>
                  <a:pt x="457906" y="459564"/>
                  <a:pt x="458438" y="457382"/>
                  <a:pt x="459317" y="455331"/>
                </a:cubicBezTo>
                <a:cubicBezTo>
                  <a:pt x="460560" y="452431"/>
                  <a:pt x="462552" y="449858"/>
                  <a:pt x="463550" y="446865"/>
                </a:cubicBezTo>
                <a:cubicBezTo>
                  <a:pt x="464688" y="443452"/>
                  <a:pt x="464404" y="439650"/>
                  <a:pt x="465667" y="436281"/>
                </a:cubicBezTo>
                <a:cubicBezTo>
                  <a:pt x="466560" y="433899"/>
                  <a:pt x="468638" y="432140"/>
                  <a:pt x="469900" y="429931"/>
                </a:cubicBezTo>
                <a:cubicBezTo>
                  <a:pt x="471465" y="427192"/>
                  <a:pt x="472383" y="424090"/>
                  <a:pt x="474133" y="421465"/>
                </a:cubicBezTo>
                <a:cubicBezTo>
                  <a:pt x="479997" y="412669"/>
                  <a:pt x="477475" y="422413"/>
                  <a:pt x="482600" y="410881"/>
                </a:cubicBezTo>
                <a:cubicBezTo>
                  <a:pt x="487702" y="399400"/>
                  <a:pt x="483571" y="399944"/>
                  <a:pt x="491067" y="393948"/>
                </a:cubicBezTo>
                <a:cubicBezTo>
                  <a:pt x="493054" y="392359"/>
                  <a:pt x="495300" y="391126"/>
                  <a:pt x="497417" y="389715"/>
                </a:cubicBezTo>
                <a:cubicBezTo>
                  <a:pt x="498122" y="387598"/>
                  <a:pt x="498385" y="385278"/>
                  <a:pt x="499533" y="383365"/>
                </a:cubicBezTo>
                <a:cubicBezTo>
                  <a:pt x="500560" y="381653"/>
                  <a:pt x="502874" y="380916"/>
                  <a:pt x="503767" y="379131"/>
                </a:cubicBezTo>
                <a:cubicBezTo>
                  <a:pt x="505068" y="376529"/>
                  <a:pt x="504737" y="373339"/>
                  <a:pt x="505883" y="370665"/>
                </a:cubicBezTo>
                <a:cubicBezTo>
                  <a:pt x="506885" y="368327"/>
                  <a:pt x="508706" y="366432"/>
                  <a:pt x="510117" y="364315"/>
                </a:cubicBezTo>
                <a:cubicBezTo>
                  <a:pt x="512263" y="355727"/>
                  <a:pt x="514186" y="345431"/>
                  <a:pt x="520700" y="338915"/>
                </a:cubicBezTo>
                <a:lnTo>
                  <a:pt x="524933" y="334681"/>
                </a:lnTo>
                <a:cubicBezTo>
                  <a:pt x="525639" y="332564"/>
                  <a:pt x="526052" y="330327"/>
                  <a:pt x="527050" y="328331"/>
                </a:cubicBezTo>
                <a:cubicBezTo>
                  <a:pt x="528715" y="325002"/>
                  <a:pt x="536032" y="315757"/>
                  <a:pt x="537633" y="313515"/>
                </a:cubicBezTo>
                <a:cubicBezTo>
                  <a:pt x="547077" y="300294"/>
                  <a:pt x="535622" y="313411"/>
                  <a:pt x="554567" y="294465"/>
                </a:cubicBezTo>
                <a:lnTo>
                  <a:pt x="565150" y="283881"/>
                </a:lnTo>
                <a:lnTo>
                  <a:pt x="571500" y="279648"/>
                </a:lnTo>
                <a:cubicBezTo>
                  <a:pt x="572206" y="277531"/>
                  <a:pt x="572039" y="274876"/>
                  <a:pt x="573617" y="273298"/>
                </a:cubicBezTo>
                <a:cubicBezTo>
                  <a:pt x="575195" y="271720"/>
                  <a:pt x="577971" y="272179"/>
                  <a:pt x="579967" y="271181"/>
                </a:cubicBezTo>
                <a:cubicBezTo>
                  <a:pt x="582242" y="270043"/>
                  <a:pt x="584200" y="268359"/>
                  <a:pt x="586317" y="266948"/>
                </a:cubicBezTo>
                <a:cubicBezTo>
                  <a:pt x="590164" y="251556"/>
                  <a:pt x="585038" y="263992"/>
                  <a:pt x="594783" y="254248"/>
                </a:cubicBezTo>
                <a:cubicBezTo>
                  <a:pt x="604358" y="244674"/>
                  <a:pt x="593005" y="249902"/>
                  <a:pt x="605367" y="245781"/>
                </a:cubicBezTo>
                <a:cubicBezTo>
                  <a:pt x="621519" y="229629"/>
                  <a:pt x="604641" y="248401"/>
                  <a:pt x="613833" y="233081"/>
                </a:cubicBezTo>
                <a:cubicBezTo>
                  <a:pt x="616442" y="228733"/>
                  <a:pt x="629723" y="221077"/>
                  <a:pt x="630767" y="220381"/>
                </a:cubicBezTo>
                <a:cubicBezTo>
                  <a:pt x="638972" y="214911"/>
                  <a:pt x="634705" y="216952"/>
                  <a:pt x="643467" y="214031"/>
                </a:cubicBezTo>
                <a:cubicBezTo>
                  <a:pt x="648406" y="206622"/>
                  <a:pt x="649815" y="202744"/>
                  <a:pt x="660400" y="199215"/>
                </a:cubicBezTo>
                <a:cubicBezTo>
                  <a:pt x="669627" y="196139"/>
                  <a:pt x="672742" y="196338"/>
                  <a:pt x="679450" y="190748"/>
                </a:cubicBezTo>
                <a:cubicBezTo>
                  <a:pt x="681750" y="188832"/>
                  <a:pt x="683884" y="186698"/>
                  <a:pt x="685800" y="184398"/>
                </a:cubicBezTo>
                <a:cubicBezTo>
                  <a:pt x="690682" y="178540"/>
                  <a:pt x="689425" y="176337"/>
                  <a:pt x="696383" y="171698"/>
                </a:cubicBezTo>
                <a:cubicBezTo>
                  <a:pt x="698239" y="170460"/>
                  <a:pt x="700616" y="170287"/>
                  <a:pt x="702733" y="169581"/>
                </a:cubicBezTo>
                <a:cubicBezTo>
                  <a:pt x="705555" y="167464"/>
                  <a:pt x="708521" y="165527"/>
                  <a:pt x="711200" y="163231"/>
                </a:cubicBezTo>
                <a:cubicBezTo>
                  <a:pt x="713473" y="161283"/>
                  <a:pt x="714825" y="158120"/>
                  <a:pt x="717550" y="156881"/>
                </a:cubicBezTo>
                <a:cubicBezTo>
                  <a:pt x="722847" y="154474"/>
                  <a:pt x="729279" y="155250"/>
                  <a:pt x="734483" y="152648"/>
                </a:cubicBezTo>
                <a:cubicBezTo>
                  <a:pt x="737305" y="151237"/>
                  <a:pt x="740050" y="149658"/>
                  <a:pt x="742950" y="148415"/>
                </a:cubicBezTo>
                <a:cubicBezTo>
                  <a:pt x="745001" y="147536"/>
                  <a:pt x="747304" y="147296"/>
                  <a:pt x="749300" y="146298"/>
                </a:cubicBezTo>
                <a:cubicBezTo>
                  <a:pt x="752980" y="144458"/>
                  <a:pt x="756394" y="142128"/>
                  <a:pt x="759883" y="139948"/>
                </a:cubicBezTo>
                <a:cubicBezTo>
                  <a:pt x="762040" y="138600"/>
                  <a:pt x="763908" y="136748"/>
                  <a:pt x="766233" y="135715"/>
                </a:cubicBezTo>
                <a:cubicBezTo>
                  <a:pt x="776300" y="131241"/>
                  <a:pt x="780980" y="131140"/>
                  <a:pt x="791633" y="129365"/>
                </a:cubicBezTo>
                <a:cubicBezTo>
                  <a:pt x="801494" y="119504"/>
                  <a:pt x="788728" y="130817"/>
                  <a:pt x="804333" y="123015"/>
                </a:cubicBezTo>
                <a:cubicBezTo>
                  <a:pt x="806118" y="122122"/>
                  <a:pt x="806855" y="119808"/>
                  <a:pt x="808567" y="118781"/>
                </a:cubicBezTo>
                <a:cubicBezTo>
                  <a:pt x="810480" y="117633"/>
                  <a:pt x="812800" y="117370"/>
                  <a:pt x="814917" y="116665"/>
                </a:cubicBezTo>
                <a:cubicBezTo>
                  <a:pt x="817034" y="114548"/>
                  <a:pt x="818742" y="111922"/>
                  <a:pt x="821267" y="110315"/>
                </a:cubicBezTo>
                <a:cubicBezTo>
                  <a:pt x="826591" y="106927"/>
                  <a:pt x="832078" y="103378"/>
                  <a:pt x="838200" y="101848"/>
                </a:cubicBezTo>
                <a:cubicBezTo>
                  <a:pt x="843844" y="100437"/>
                  <a:pt x="849373" y="98438"/>
                  <a:pt x="855133" y="97615"/>
                </a:cubicBezTo>
                <a:cubicBezTo>
                  <a:pt x="872830" y="95087"/>
                  <a:pt x="865110" y="96708"/>
                  <a:pt x="878417" y="93381"/>
                </a:cubicBezTo>
                <a:cubicBezTo>
                  <a:pt x="880534" y="91970"/>
                  <a:pt x="882442" y="90181"/>
                  <a:pt x="884767" y="89148"/>
                </a:cubicBezTo>
                <a:cubicBezTo>
                  <a:pt x="888845" y="87336"/>
                  <a:pt x="893234" y="86326"/>
                  <a:pt x="897467" y="84915"/>
                </a:cubicBezTo>
                <a:cubicBezTo>
                  <a:pt x="906582" y="81877"/>
                  <a:pt x="901645" y="83341"/>
                  <a:pt x="912283" y="80681"/>
                </a:cubicBezTo>
                <a:cubicBezTo>
                  <a:pt x="914400" y="79270"/>
                  <a:pt x="916251" y="77341"/>
                  <a:pt x="918633" y="76448"/>
                </a:cubicBezTo>
                <a:cubicBezTo>
                  <a:pt x="922002" y="75185"/>
                  <a:pt x="925705" y="75111"/>
                  <a:pt x="929217" y="74331"/>
                </a:cubicBezTo>
                <a:cubicBezTo>
                  <a:pt x="932057" y="73700"/>
                  <a:pt x="934861" y="72920"/>
                  <a:pt x="937683" y="72215"/>
                </a:cubicBezTo>
                <a:cubicBezTo>
                  <a:pt x="950882" y="63414"/>
                  <a:pt x="935993" y="72087"/>
                  <a:pt x="956733" y="65865"/>
                </a:cubicBezTo>
                <a:cubicBezTo>
                  <a:pt x="959755" y="64958"/>
                  <a:pt x="962245" y="62739"/>
                  <a:pt x="965200" y="61631"/>
                </a:cubicBezTo>
                <a:cubicBezTo>
                  <a:pt x="967924" y="60610"/>
                  <a:pt x="970845" y="60220"/>
                  <a:pt x="973667" y="59515"/>
                </a:cubicBezTo>
                <a:cubicBezTo>
                  <a:pt x="989610" y="48885"/>
                  <a:pt x="969348" y="61366"/>
                  <a:pt x="988483" y="53165"/>
                </a:cubicBezTo>
                <a:cubicBezTo>
                  <a:pt x="990821" y="52163"/>
                  <a:pt x="992401" y="49679"/>
                  <a:pt x="994833" y="48931"/>
                </a:cubicBezTo>
                <a:cubicBezTo>
                  <a:pt x="1000823" y="47088"/>
                  <a:pt x="1020465" y="43954"/>
                  <a:pt x="1028700" y="42581"/>
                </a:cubicBezTo>
                <a:cubicBezTo>
                  <a:pt x="1047801" y="33032"/>
                  <a:pt x="1024094" y="44119"/>
                  <a:pt x="1054100" y="34115"/>
                </a:cubicBezTo>
                <a:cubicBezTo>
                  <a:pt x="1059758" y="32229"/>
                  <a:pt x="1068861" y="28833"/>
                  <a:pt x="1075267" y="27765"/>
                </a:cubicBezTo>
                <a:cubicBezTo>
                  <a:pt x="1080878" y="26830"/>
                  <a:pt x="1086562" y="26400"/>
                  <a:pt x="1092200" y="25648"/>
                </a:cubicBezTo>
                <a:lnTo>
                  <a:pt x="1107017" y="23531"/>
                </a:lnTo>
                <a:cubicBezTo>
                  <a:pt x="1111754" y="21952"/>
                  <a:pt x="1116903" y="20057"/>
                  <a:pt x="1121833" y="19298"/>
                </a:cubicBezTo>
                <a:cubicBezTo>
                  <a:pt x="1128148" y="18326"/>
                  <a:pt x="1134533" y="17887"/>
                  <a:pt x="1140883" y="17181"/>
                </a:cubicBezTo>
                <a:cubicBezTo>
                  <a:pt x="1153686" y="13981"/>
                  <a:pt x="1146580" y="15988"/>
                  <a:pt x="1162050" y="10831"/>
                </a:cubicBezTo>
                <a:cubicBezTo>
                  <a:pt x="1164167" y="10125"/>
                  <a:pt x="1166212" y="9153"/>
                  <a:pt x="1168400" y="8715"/>
                </a:cubicBezTo>
                <a:cubicBezTo>
                  <a:pt x="1175680" y="7259"/>
                  <a:pt x="1180471" y="6475"/>
                  <a:pt x="1187450" y="4481"/>
                </a:cubicBezTo>
                <a:cubicBezTo>
                  <a:pt x="1193975" y="2617"/>
                  <a:pt x="1196833" y="563"/>
                  <a:pt x="1204383" y="248"/>
                </a:cubicBezTo>
                <a:cubicBezTo>
                  <a:pt x="1217777" y="-310"/>
                  <a:pt x="1231194" y="248"/>
                  <a:pt x="1244600" y="248"/>
                </a:cubicBez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5" name="フリーフォーム: 図形 24">
            <a:extLst>
              <a:ext uri="{FF2B5EF4-FFF2-40B4-BE49-F238E27FC236}">
                <a16:creationId xmlns:a16="http://schemas.microsoft.com/office/drawing/2014/main" id="{A96B3D3F-17F7-3938-AD0B-015953F3B6FE}"/>
              </a:ext>
            </a:extLst>
          </p:cNvPr>
          <p:cNvSpPr/>
          <p:nvPr/>
        </p:nvSpPr>
        <p:spPr>
          <a:xfrm>
            <a:off x="1893938" y="6342500"/>
            <a:ext cx="715433" cy="59267"/>
          </a:xfrm>
          <a:custGeom>
            <a:avLst/>
            <a:gdLst>
              <a:gd name="connsiteX0" fmla="*/ 0 w 715433"/>
              <a:gd name="connsiteY0" fmla="*/ 59267 h 59267"/>
              <a:gd name="connsiteX1" fmla="*/ 91017 w 715433"/>
              <a:gd name="connsiteY1" fmla="*/ 55034 h 59267"/>
              <a:gd name="connsiteX2" fmla="*/ 182033 w 715433"/>
              <a:gd name="connsiteY2" fmla="*/ 52917 h 59267"/>
              <a:gd name="connsiteX3" fmla="*/ 209550 w 715433"/>
              <a:gd name="connsiteY3" fmla="*/ 50800 h 59267"/>
              <a:gd name="connsiteX4" fmla="*/ 220133 w 715433"/>
              <a:gd name="connsiteY4" fmla="*/ 48684 h 59267"/>
              <a:gd name="connsiteX5" fmla="*/ 237067 w 715433"/>
              <a:gd name="connsiteY5" fmla="*/ 44450 h 59267"/>
              <a:gd name="connsiteX6" fmla="*/ 328083 w 715433"/>
              <a:gd name="connsiteY6" fmla="*/ 42334 h 59267"/>
              <a:gd name="connsiteX7" fmla="*/ 359833 w 715433"/>
              <a:gd name="connsiteY7" fmla="*/ 48684 h 59267"/>
              <a:gd name="connsiteX8" fmla="*/ 361950 w 715433"/>
              <a:gd name="connsiteY8" fmla="*/ 55034 h 59267"/>
              <a:gd name="connsiteX9" fmla="*/ 376767 w 715433"/>
              <a:gd name="connsiteY9" fmla="*/ 52917 h 59267"/>
              <a:gd name="connsiteX10" fmla="*/ 381000 w 715433"/>
              <a:gd name="connsiteY10" fmla="*/ 35984 h 59267"/>
              <a:gd name="connsiteX11" fmla="*/ 389467 w 715433"/>
              <a:gd name="connsiteY11" fmla="*/ 33867 h 59267"/>
              <a:gd name="connsiteX12" fmla="*/ 400050 w 715433"/>
              <a:gd name="connsiteY12" fmla="*/ 29634 h 59267"/>
              <a:gd name="connsiteX13" fmla="*/ 431800 w 715433"/>
              <a:gd name="connsiteY13" fmla="*/ 25400 h 59267"/>
              <a:gd name="connsiteX14" fmla="*/ 472017 w 715433"/>
              <a:gd name="connsiteY14" fmla="*/ 21167 h 59267"/>
              <a:gd name="connsiteX15" fmla="*/ 535517 w 715433"/>
              <a:gd name="connsiteY15" fmla="*/ 19050 h 59267"/>
              <a:gd name="connsiteX16" fmla="*/ 573617 w 715433"/>
              <a:gd name="connsiteY16" fmla="*/ 14817 h 59267"/>
              <a:gd name="connsiteX17" fmla="*/ 582083 w 715433"/>
              <a:gd name="connsiteY17" fmla="*/ 12700 h 59267"/>
              <a:gd name="connsiteX18" fmla="*/ 645583 w 715433"/>
              <a:gd name="connsiteY18" fmla="*/ 10584 h 59267"/>
              <a:gd name="connsiteX19" fmla="*/ 666750 w 715433"/>
              <a:gd name="connsiteY19" fmla="*/ 6350 h 59267"/>
              <a:gd name="connsiteX20" fmla="*/ 673100 w 715433"/>
              <a:gd name="connsiteY20" fmla="*/ 4234 h 59267"/>
              <a:gd name="connsiteX21" fmla="*/ 700617 w 715433"/>
              <a:gd name="connsiteY21" fmla="*/ 2117 h 59267"/>
              <a:gd name="connsiteX22" fmla="*/ 715433 w 715433"/>
              <a:gd name="connsiteY22" fmla="*/ 0 h 592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</a:cxnLst>
            <a:rect l="l" t="t" r="r" b="b"/>
            <a:pathLst>
              <a:path w="715433" h="59267">
                <a:moveTo>
                  <a:pt x="0" y="59267"/>
                </a:moveTo>
                <a:cubicBezTo>
                  <a:pt x="43081" y="54958"/>
                  <a:pt x="18234" y="56949"/>
                  <a:pt x="91017" y="55034"/>
                </a:cubicBezTo>
                <a:lnTo>
                  <a:pt x="182033" y="52917"/>
                </a:lnTo>
                <a:cubicBezTo>
                  <a:pt x="191205" y="52211"/>
                  <a:pt x="200407" y="51816"/>
                  <a:pt x="209550" y="50800"/>
                </a:cubicBezTo>
                <a:cubicBezTo>
                  <a:pt x="213125" y="50403"/>
                  <a:pt x="216628" y="49493"/>
                  <a:pt x="220133" y="48684"/>
                </a:cubicBezTo>
                <a:cubicBezTo>
                  <a:pt x="225802" y="47376"/>
                  <a:pt x="231250" y="44585"/>
                  <a:pt x="237067" y="44450"/>
                </a:cubicBezTo>
                <a:lnTo>
                  <a:pt x="328083" y="42334"/>
                </a:lnTo>
                <a:cubicBezTo>
                  <a:pt x="355383" y="40234"/>
                  <a:pt x="352640" y="31900"/>
                  <a:pt x="359833" y="48684"/>
                </a:cubicBezTo>
                <a:cubicBezTo>
                  <a:pt x="360712" y="50735"/>
                  <a:pt x="361244" y="52917"/>
                  <a:pt x="361950" y="55034"/>
                </a:cubicBezTo>
                <a:cubicBezTo>
                  <a:pt x="366889" y="54328"/>
                  <a:pt x="372776" y="55911"/>
                  <a:pt x="376767" y="52917"/>
                </a:cubicBezTo>
                <a:cubicBezTo>
                  <a:pt x="393074" y="40687"/>
                  <a:pt x="369215" y="45411"/>
                  <a:pt x="381000" y="35984"/>
                </a:cubicBezTo>
                <a:cubicBezTo>
                  <a:pt x="383272" y="34167"/>
                  <a:pt x="386707" y="34787"/>
                  <a:pt x="389467" y="33867"/>
                </a:cubicBezTo>
                <a:cubicBezTo>
                  <a:pt x="393071" y="32666"/>
                  <a:pt x="396446" y="30835"/>
                  <a:pt x="400050" y="29634"/>
                </a:cubicBezTo>
                <a:cubicBezTo>
                  <a:pt x="410570" y="26127"/>
                  <a:pt x="420374" y="26439"/>
                  <a:pt x="431800" y="25400"/>
                </a:cubicBezTo>
                <a:cubicBezTo>
                  <a:pt x="450065" y="21748"/>
                  <a:pt x="444381" y="22423"/>
                  <a:pt x="472017" y="21167"/>
                </a:cubicBezTo>
                <a:cubicBezTo>
                  <a:pt x="493174" y="20205"/>
                  <a:pt x="514350" y="19756"/>
                  <a:pt x="535517" y="19050"/>
                </a:cubicBezTo>
                <a:cubicBezTo>
                  <a:pt x="553140" y="13177"/>
                  <a:pt x="533887" y="19000"/>
                  <a:pt x="573617" y="14817"/>
                </a:cubicBezTo>
                <a:cubicBezTo>
                  <a:pt x="576510" y="14512"/>
                  <a:pt x="579179" y="12871"/>
                  <a:pt x="582083" y="12700"/>
                </a:cubicBezTo>
                <a:cubicBezTo>
                  <a:pt x="603225" y="11456"/>
                  <a:pt x="624416" y="11289"/>
                  <a:pt x="645583" y="10584"/>
                </a:cubicBezTo>
                <a:cubicBezTo>
                  <a:pt x="655569" y="8919"/>
                  <a:pt x="657904" y="8877"/>
                  <a:pt x="666750" y="6350"/>
                </a:cubicBezTo>
                <a:cubicBezTo>
                  <a:pt x="668895" y="5737"/>
                  <a:pt x="670886" y="4511"/>
                  <a:pt x="673100" y="4234"/>
                </a:cubicBezTo>
                <a:cubicBezTo>
                  <a:pt x="682228" y="3093"/>
                  <a:pt x="691463" y="3033"/>
                  <a:pt x="700617" y="2117"/>
                </a:cubicBezTo>
                <a:cubicBezTo>
                  <a:pt x="705581" y="1621"/>
                  <a:pt x="715433" y="0"/>
                  <a:pt x="715433" y="0"/>
                </a:cubicBez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26" name="フリーフォーム: 図形 25">
            <a:extLst>
              <a:ext uri="{FF2B5EF4-FFF2-40B4-BE49-F238E27FC236}">
                <a16:creationId xmlns:a16="http://schemas.microsoft.com/office/drawing/2014/main" id="{69F00BEF-A70C-7C26-2F6A-9628B700CEB3}"/>
              </a:ext>
            </a:extLst>
          </p:cNvPr>
          <p:cNvSpPr/>
          <p:nvPr/>
        </p:nvSpPr>
        <p:spPr>
          <a:xfrm>
            <a:off x="3939316" y="5065092"/>
            <a:ext cx="1171575" cy="1336675"/>
          </a:xfrm>
          <a:custGeom>
            <a:avLst/>
            <a:gdLst>
              <a:gd name="connsiteX0" fmla="*/ 0 w 1171575"/>
              <a:gd name="connsiteY0" fmla="*/ 1336675 h 1336675"/>
              <a:gd name="connsiteX1" fmla="*/ 28575 w 1171575"/>
              <a:gd name="connsiteY1" fmla="*/ 1336675 h 1336675"/>
              <a:gd name="connsiteX2" fmla="*/ 44450 w 1171575"/>
              <a:gd name="connsiteY2" fmla="*/ 1333500 h 1336675"/>
              <a:gd name="connsiteX3" fmla="*/ 88900 w 1171575"/>
              <a:gd name="connsiteY3" fmla="*/ 1330325 h 1336675"/>
              <a:gd name="connsiteX4" fmla="*/ 123825 w 1171575"/>
              <a:gd name="connsiteY4" fmla="*/ 1333500 h 1336675"/>
              <a:gd name="connsiteX5" fmla="*/ 219075 w 1171575"/>
              <a:gd name="connsiteY5" fmla="*/ 1323975 h 1336675"/>
              <a:gd name="connsiteX6" fmla="*/ 228600 w 1171575"/>
              <a:gd name="connsiteY6" fmla="*/ 1320800 h 1336675"/>
              <a:gd name="connsiteX7" fmla="*/ 244475 w 1171575"/>
              <a:gd name="connsiteY7" fmla="*/ 1317625 h 1336675"/>
              <a:gd name="connsiteX8" fmla="*/ 257175 w 1171575"/>
              <a:gd name="connsiteY8" fmla="*/ 1314450 h 1336675"/>
              <a:gd name="connsiteX9" fmla="*/ 304800 w 1171575"/>
              <a:gd name="connsiteY9" fmla="*/ 1320800 h 1336675"/>
              <a:gd name="connsiteX10" fmla="*/ 323850 w 1171575"/>
              <a:gd name="connsiteY10" fmla="*/ 1327150 h 1336675"/>
              <a:gd name="connsiteX11" fmla="*/ 330200 w 1171575"/>
              <a:gd name="connsiteY11" fmla="*/ 1317625 h 1336675"/>
              <a:gd name="connsiteX12" fmla="*/ 339725 w 1171575"/>
              <a:gd name="connsiteY12" fmla="*/ 1311275 h 1336675"/>
              <a:gd name="connsiteX13" fmla="*/ 342900 w 1171575"/>
              <a:gd name="connsiteY13" fmla="*/ 1301750 h 1336675"/>
              <a:gd name="connsiteX14" fmla="*/ 349250 w 1171575"/>
              <a:gd name="connsiteY14" fmla="*/ 1292225 h 1336675"/>
              <a:gd name="connsiteX15" fmla="*/ 352425 w 1171575"/>
              <a:gd name="connsiteY15" fmla="*/ 1260475 h 1336675"/>
              <a:gd name="connsiteX16" fmla="*/ 358775 w 1171575"/>
              <a:gd name="connsiteY16" fmla="*/ 1247775 h 1336675"/>
              <a:gd name="connsiteX17" fmla="*/ 361950 w 1171575"/>
              <a:gd name="connsiteY17" fmla="*/ 1235075 h 1336675"/>
              <a:gd name="connsiteX18" fmla="*/ 368300 w 1171575"/>
              <a:gd name="connsiteY18" fmla="*/ 1209675 h 1336675"/>
              <a:gd name="connsiteX19" fmla="*/ 371475 w 1171575"/>
              <a:gd name="connsiteY19" fmla="*/ 1060450 h 1336675"/>
              <a:gd name="connsiteX20" fmla="*/ 374650 w 1171575"/>
              <a:gd name="connsiteY20" fmla="*/ 1006475 h 1336675"/>
              <a:gd name="connsiteX21" fmla="*/ 377825 w 1171575"/>
              <a:gd name="connsiteY21" fmla="*/ 860425 h 1336675"/>
              <a:gd name="connsiteX22" fmla="*/ 384175 w 1171575"/>
              <a:gd name="connsiteY22" fmla="*/ 768350 h 1336675"/>
              <a:gd name="connsiteX23" fmla="*/ 390525 w 1171575"/>
              <a:gd name="connsiteY23" fmla="*/ 739775 h 1336675"/>
              <a:gd name="connsiteX24" fmla="*/ 393700 w 1171575"/>
              <a:gd name="connsiteY24" fmla="*/ 730250 h 1336675"/>
              <a:gd name="connsiteX25" fmla="*/ 400050 w 1171575"/>
              <a:gd name="connsiteY25" fmla="*/ 695325 h 1336675"/>
              <a:gd name="connsiteX26" fmla="*/ 403225 w 1171575"/>
              <a:gd name="connsiteY26" fmla="*/ 682625 h 1336675"/>
              <a:gd name="connsiteX27" fmla="*/ 406400 w 1171575"/>
              <a:gd name="connsiteY27" fmla="*/ 666750 h 1336675"/>
              <a:gd name="connsiteX28" fmla="*/ 409575 w 1171575"/>
              <a:gd name="connsiteY28" fmla="*/ 631825 h 1336675"/>
              <a:gd name="connsiteX29" fmla="*/ 415925 w 1171575"/>
              <a:gd name="connsiteY29" fmla="*/ 606425 h 1336675"/>
              <a:gd name="connsiteX30" fmla="*/ 419100 w 1171575"/>
              <a:gd name="connsiteY30" fmla="*/ 590550 h 1336675"/>
              <a:gd name="connsiteX31" fmla="*/ 425450 w 1171575"/>
              <a:gd name="connsiteY31" fmla="*/ 561975 h 1336675"/>
              <a:gd name="connsiteX32" fmla="*/ 441325 w 1171575"/>
              <a:gd name="connsiteY32" fmla="*/ 533400 h 1336675"/>
              <a:gd name="connsiteX33" fmla="*/ 450850 w 1171575"/>
              <a:gd name="connsiteY33" fmla="*/ 520700 h 1336675"/>
              <a:gd name="connsiteX34" fmla="*/ 454025 w 1171575"/>
              <a:gd name="connsiteY34" fmla="*/ 501650 h 1336675"/>
              <a:gd name="connsiteX35" fmla="*/ 466725 w 1171575"/>
              <a:gd name="connsiteY35" fmla="*/ 482600 h 1336675"/>
              <a:gd name="connsiteX36" fmla="*/ 473075 w 1171575"/>
              <a:gd name="connsiteY36" fmla="*/ 466725 h 1336675"/>
              <a:gd name="connsiteX37" fmla="*/ 488950 w 1171575"/>
              <a:gd name="connsiteY37" fmla="*/ 434975 h 1336675"/>
              <a:gd name="connsiteX38" fmla="*/ 492125 w 1171575"/>
              <a:gd name="connsiteY38" fmla="*/ 406400 h 1336675"/>
              <a:gd name="connsiteX39" fmla="*/ 504825 w 1171575"/>
              <a:gd name="connsiteY39" fmla="*/ 371475 h 1336675"/>
              <a:gd name="connsiteX40" fmla="*/ 508000 w 1171575"/>
              <a:gd name="connsiteY40" fmla="*/ 358775 h 1336675"/>
              <a:gd name="connsiteX41" fmla="*/ 539750 w 1171575"/>
              <a:gd name="connsiteY41" fmla="*/ 323850 h 1336675"/>
              <a:gd name="connsiteX42" fmla="*/ 561975 w 1171575"/>
              <a:gd name="connsiteY42" fmla="*/ 295275 h 1336675"/>
              <a:gd name="connsiteX43" fmla="*/ 574675 w 1171575"/>
              <a:gd name="connsiteY43" fmla="*/ 282575 h 1336675"/>
              <a:gd name="connsiteX44" fmla="*/ 584200 w 1171575"/>
              <a:gd name="connsiteY44" fmla="*/ 273050 h 1336675"/>
              <a:gd name="connsiteX45" fmla="*/ 596900 w 1171575"/>
              <a:gd name="connsiteY45" fmla="*/ 263525 h 1336675"/>
              <a:gd name="connsiteX46" fmla="*/ 619125 w 1171575"/>
              <a:gd name="connsiteY46" fmla="*/ 244475 h 1336675"/>
              <a:gd name="connsiteX47" fmla="*/ 638175 w 1171575"/>
              <a:gd name="connsiteY47" fmla="*/ 225425 h 1336675"/>
              <a:gd name="connsiteX48" fmla="*/ 647700 w 1171575"/>
              <a:gd name="connsiteY48" fmla="*/ 219075 h 1336675"/>
              <a:gd name="connsiteX49" fmla="*/ 660400 w 1171575"/>
              <a:gd name="connsiteY49" fmla="*/ 206375 h 1336675"/>
              <a:gd name="connsiteX50" fmla="*/ 669925 w 1171575"/>
              <a:gd name="connsiteY50" fmla="*/ 203200 h 1336675"/>
              <a:gd name="connsiteX51" fmla="*/ 688975 w 1171575"/>
              <a:gd name="connsiteY51" fmla="*/ 190500 h 1336675"/>
              <a:gd name="connsiteX52" fmla="*/ 698500 w 1171575"/>
              <a:gd name="connsiteY52" fmla="*/ 184150 h 1336675"/>
              <a:gd name="connsiteX53" fmla="*/ 730250 w 1171575"/>
              <a:gd name="connsiteY53" fmla="*/ 161925 h 1336675"/>
              <a:gd name="connsiteX54" fmla="*/ 746125 w 1171575"/>
              <a:gd name="connsiteY54" fmla="*/ 152400 h 1336675"/>
              <a:gd name="connsiteX55" fmla="*/ 758825 w 1171575"/>
              <a:gd name="connsiteY55" fmla="*/ 142875 h 1336675"/>
              <a:gd name="connsiteX56" fmla="*/ 768350 w 1171575"/>
              <a:gd name="connsiteY56" fmla="*/ 139700 h 1336675"/>
              <a:gd name="connsiteX57" fmla="*/ 777875 w 1171575"/>
              <a:gd name="connsiteY57" fmla="*/ 133350 h 1336675"/>
              <a:gd name="connsiteX58" fmla="*/ 812800 w 1171575"/>
              <a:gd name="connsiteY58" fmla="*/ 117475 h 1336675"/>
              <a:gd name="connsiteX59" fmla="*/ 822325 w 1171575"/>
              <a:gd name="connsiteY59" fmla="*/ 111125 h 1336675"/>
              <a:gd name="connsiteX60" fmla="*/ 835025 w 1171575"/>
              <a:gd name="connsiteY60" fmla="*/ 98425 h 1336675"/>
              <a:gd name="connsiteX61" fmla="*/ 860425 w 1171575"/>
              <a:gd name="connsiteY61" fmla="*/ 82550 h 1336675"/>
              <a:gd name="connsiteX62" fmla="*/ 869950 w 1171575"/>
              <a:gd name="connsiteY62" fmla="*/ 76200 h 1336675"/>
              <a:gd name="connsiteX63" fmla="*/ 895350 w 1171575"/>
              <a:gd name="connsiteY63" fmla="*/ 69850 h 1336675"/>
              <a:gd name="connsiteX64" fmla="*/ 911225 w 1171575"/>
              <a:gd name="connsiteY64" fmla="*/ 63500 h 1336675"/>
              <a:gd name="connsiteX65" fmla="*/ 942975 w 1171575"/>
              <a:gd name="connsiteY65" fmla="*/ 57150 h 1336675"/>
              <a:gd name="connsiteX66" fmla="*/ 968375 w 1171575"/>
              <a:gd name="connsiteY66" fmla="*/ 47625 h 1336675"/>
              <a:gd name="connsiteX67" fmla="*/ 981075 w 1171575"/>
              <a:gd name="connsiteY67" fmla="*/ 41275 h 1336675"/>
              <a:gd name="connsiteX68" fmla="*/ 993775 w 1171575"/>
              <a:gd name="connsiteY68" fmla="*/ 38100 h 1336675"/>
              <a:gd name="connsiteX69" fmla="*/ 1022350 w 1171575"/>
              <a:gd name="connsiteY69" fmla="*/ 28575 h 1336675"/>
              <a:gd name="connsiteX70" fmla="*/ 1069975 w 1171575"/>
              <a:gd name="connsiteY70" fmla="*/ 22225 h 1336675"/>
              <a:gd name="connsiteX71" fmla="*/ 1123950 w 1171575"/>
              <a:gd name="connsiteY71" fmla="*/ 12700 h 1336675"/>
              <a:gd name="connsiteX72" fmla="*/ 1136650 w 1171575"/>
              <a:gd name="connsiteY72" fmla="*/ 6350 h 1336675"/>
              <a:gd name="connsiteX73" fmla="*/ 1171575 w 1171575"/>
              <a:gd name="connsiteY73" fmla="*/ 0 h 13366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</a:cxnLst>
            <a:rect l="l" t="t" r="r" b="b"/>
            <a:pathLst>
              <a:path w="1171575" h="1336675">
                <a:moveTo>
                  <a:pt x="0" y="1336675"/>
                </a:moveTo>
                <a:cubicBezTo>
                  <a:pt x="47880" y="1327099"/>
                  <a:pt x="-11780" y="1336675"/>
                  <a:pt x="28575" y="1336675"/>
                </a:cubicBezTo>
                <a:cubicBezTo>
                  <a:pt x="33971" y="1336675"/>
                  <a:pt x="39083" y="1334065"/>
                  <a:pt x="44450" y="1333500"/>
                </a:cubicBezTo>
                <a:cubicBezTo>
                  <a:pt x="59223" y="1331945"/>
                  <a:pt x="74083" y="1331383"/>
                  <a:pt x="88900" y="1330325"/>
                </a:cubicBezTo>
                <a:cubicBezTo>
                  <a:pt x="100542" y="1331383"/>
                  <a:pt x="112141" y="1333854"/>
                  <a:pt x="123825" y="1333500"/>
                </a:cubicBezTo>
                <a:cubicBezTo>
                  <a:pt x="152030" y="1332645"/>
                  <a:pt x="188776" y="1327762"/>
                  <a:pt x="219075" y="1323975"/>
                </a:cubicBezTo>
                <a:cubicBezTo>
                  <a:pt x="222250" y="1322917"/>
                  <a:pt x="225353" y="1321612"/>
                  <a:pt x="228600" y="1320800"/>
                </a:cubicBezTo>
                <a:cubicBezTo>
                  <a:pt x="233835" y="1319491"/>
                  <a:pt x="239207" y="1318796"/>
                  <a:pt x="244475" y="1317625"/>
                </a:cubicBezTo>
                <a:cubicBezTo>
                  <a:pt x="248735" y="1316678"/>
                  <a:pt x="252942" y="1315508"/>
                  <a:pt x="257175" y="1314450"/>
                </a:cubicBezTo>
                <a:cubicBezTo>
                  <a:pt x="272465" y="1315979"/>
                  <a:pt x="289571" y="1316647"/>
                  <a:pt x="304800" y="1320800"/>
                </a:cubicBezTo>
                <a:cubicBezTo>
                  <a:pt x="311258" y="1322561"/>
                  <a:pt x="317500" y="1325033"/>
                  <a:pt x="323850" y="1327150"/>
                </a:cubicBezTo>
                <a:cubicBezTo>
                  <a:pt x="325967" y="1323975"/>
                  <a:pt x="327502" y="1320323"/>
                  <a:pt x="330200" y="1317625"/>
                </a:cubicBezTo>
                <a:cubicBezTo>
                  <a:pt x="332898" y="1314927"/>
                  <a:pt x="337341" y="1314255"/>
                  <a:pt x="339725" y="1311275"/>
                </a:cubicBezTo>
                <a:cubicBezTo>
                  <a:pt x="341816" y="1308662"/>
                  <a:pt x="341403" y="1304743"/>
                  <a:pt x="342900" y="1301750"/>
                </a:cubicBezTo>
                <a:cubicBezTo>
                  <a:pt x="344607" y="1298337"/>
                  <a:pt x="347133" y="1295400"/>
                  <a:pt x="349250" y="1292225"/>
                </a:cubicBezTo>
                <a:cubicBezTo>
                  <a:pt x="350308" y="1281642"/>
                  <a:pt x="350196" y="1270875"/>
                  <a:pt x="352425" y="1260475"/>
                </a:cubicBezTo>
                <a:cubicBezTo>
                  <a:pt x="353417" y="1255847"/>
                  <a:pt x="357113" y="1252207"/>
                  <a:pt x="358775" y="1247775"/>
                </a:cubicBezTo>
                <a:cubicBezTo>
                  <a:pt x="360307" y="1243689"/>
                  <a:pt x="360751" y="1239271"/>
                  <a:pt x="361950" y="1235075"/>
                </a:cubicBezTo>
                <a:cubicBezTo>
                  <a:pt x="368459" y="1212295"/>
                  <a:pt x="361845" y="1241950"/>
                  <a:pt x="368300" y="1209675"/>
                </a:cubicBezTo>
                <a:cubicBezTo>
                  <a:pt x="369358" y="1159933"/>
                  <a:pt x="369921" y="1110179"/>
                  <a:pt x="371475" y="1060450"/>
                </a:cubicBezTo>
                <a:cubicBezTo>
                  <a:pt x="372038" y="1042436"/>
                  <a:pt x="374078" y="1024489"/>
                  <a:pt x="374650" y="1006475"/>
                </a:cubicBezTo>
                <a:cubicBezTo>
                  <a:pt x="376195" y="957805"/>
                  <a:pt x="376327" y="909097"/>
                  <a:pt x="377825" y="860425"/>
                </a:cubicBezTo>
                <a:cubicBezTo>
                  <a:pt x="378562" y="836465"/>
                  <a:pt x="380579" y="795318"/>
                  <a:pt x="384175" y="768350"/>
                </a:cubicBezTo>
                <a:cubicBezTo>
                  <a:pt x="384993" y="762212"/>
                  <a:pt x="388639" y="746377"/>
                  <a:pt x="390525" y="739775"/>
                </a:cubicBezTo>
                <a:cubicBezTo>
                  <a:pt x="391444" y="736557"/>
                  <a:pt x="392888" y="733497"/>
                  <a:pt x="393700" y="730250"/>
                </a:cubicBezTo>
                <a:cubicBezTo>
                  <a:pt x="397105" y="716629"/>
                  <a:pt x="397219" y="709479"/>
                  <a:pt x="400050" y="695325"/>
                </a:cubicBezTo>
                <a:cubicBezTo>
                  <a:pt x="400906" y="691046"/>
                  <a:pt x="402278" y="686885"/>
                  <a:pt x="403225" y="682625"/>
                </a:cubicBezTo>
                <a:cubicBezTo>
                  <a:pt x="404396" y="677357"/>
                  <a:pt x="405342" y="672042"/>
                  <a:pt x="406400" y="666750"/>
                </a:cubicBezTo>
                <a:cubicBezTo>
                  <a:pt x="407458" y="655108"/>
                  <a:pt x="407752" y="643372"/>
                  <a:pt x="409575" y="631825"/>
                </a:cubicBezTo>
                <a:cubicBezTo>
                  <a:pt x="410936" y="623205"/>
                  <a:pt x="414213" y="614983"/>
                  <a:pt x="415925" y="606425"/>
                </a:cubicBezTo>
                <a:cubicBezTo>
                  <a:pt x="416983" y="601133"/>
                  <a:pt x="418135" y="595859"/>
                  <a:pt x="419100" y="590550"/>
                </a:cubicBezTo>
                <a:cubicBezTo>
                  <a:pt x="421303" y="578432"/>
                  <a:pt x="421030" y="572287"/>
                  <a:pt x="425450" y="561975"/>
                </a:cubicBezTo>
                <a:cubicBezTo>
                  <a:pt x="429081" y="553502"/>
                  <a:pt x="436508" y="540626"/>
                  <a:pt x="441325" y="533400"/>
                </a:cubicBezTo>
                <a:cubicBezTo>
                  <a:pt x="444260" y="528997"/>
                  <a:pt x="447675" y="524933"/>
                  <a:pt x="450850" y="520700"/>
                </a:cubicBezTo>
                <a:cubicBezTo>
                  <a:pt x="451908" y="514350"/>
                  <a:pt x="451549" y="507592"/>
                  <a:pt x="454025" y="501650"/>
                </a:cubicBezTo>
                <a:cubicBezTo>
                  <a:pt x="456960" y="494605"/>
                  <a:pt x="463071" y="489300"/>
                  <a:pt x="466725" y="482600"/>
                </a:cubicBezTo>
                <a:cubicBezTo>
                  <a:pt x="469454" y="477597"/>
                  <a:pt x="470526" y="471823"/>
                  <a:pt x="473075" y="466725"/>
                </a:cubicBezTo>
                <a:cubicBezTo>
                  <a:pt x="493837" y="425201"/>
                  <a:pt x="472638" y="475755"/>
                  <a:pt x="488950" y="434975"/>
                </a:cubicBezTo>
                <a:cubicBezTo>
                  <a:pt x="490008" y="425450"/>
                  <a:pt x="490245" y="415798"/>
                  <a:pt x="492125" y="406400"/>
                </a:cubicBezTo>
                <a:cubicBezTo>
                  <a:pt x="494719" y="393428"/>
                  <a:pt x="500722" y="383785"/>
                  <a:pt x="504825" y="371475"/>
                </a:cubicBezTo>
                <a:cubicBezTo>
                  <a:pt x="506205" y="367335"/>
                  <a:pt x="505498" y="362350"/>
                  <a:pt x="508000" y="358775"/>
                </a:cubicBezTo>
                <a:cubicBezTo>
                  <a:pt x="537538" y="316577"/>
                  <a:pt x="517141" y="360589"/>
                  <a:pt x="539750" y="323850"/>
                </a:cubicBezTo>
                <a:cubicBezTo>
                  <a:pt x="558068" y="294083"/>
                  <a:pt x="542013" y="301929"/>
                  <a:pt x="561975" y="295275"/>
                </a:cubicBezTo>
                <a:cubicBezTo>
                  <a:pt x="568023" y="277132"/>
                  <a:pt x="560161" y="292251"/>
                  <a:pt x="574675" y="282575"/>
                </a:cubicBezTo>
                <a:cubicBezTo>
                  <a:pt x="578411" y="280084"/>
                  <a:pt x="580791" y="275972"/>
                  <a:pt x="584200" y="273050"/>
                </a:cubicBezTo>
                <a:cubicBezTo>
                  <a:pt x="588218" y="269606"/>
                  <a:pt x="593158" y="267267"/>
                  <a:pt x="596900" y="263525"/>
                </a:cubicBezTo>
                <a:cubicBezTo>
                  <a:pt x="617237" y="243188"/>
                  <a:pt x="600432" y="250706"/>
                  <a:pt x="619125" y="244475"/>
                </a:cubicBezTo>
                <a:cubicBezTo>
                  <a:pt x="625475" y="238125"/>
                  <a:pt x="630703" y="230406"/>
                  <a:pt x="638175" y="225425"/>
                </a:cubicBezTo>
                <a:cubicBezTo>
                  <a:pt x="641350" y="223308"/>
                  <a:pt x="644803" y="221558"/>
                  <a:pt x="647700" y="219075"/>
                </a:cubicBezTo>
                <a:cubicBezTo>
                  <a:pt x="652246" y="215179"/>
                  <a:pt x="655528" y="209855"/>
                  <a:pt x="660400" y="206375"/>
                </a:cubicBezTo>
                <a:cubicBezTo>
                  <a:pt x="663123" y="204430"/>
                  <a:pt x="666999" y="204825"/>
                  <a:pt x="669925" y="203200"/>
                </a:cubicBezTo>
                <a:cubicBezTo>
                  <a:pt x="676596" y="199494"/>
                  <a:pt x="682625" y="194733"/>
                  <a:pt x="688975" y="190500"/>
                </a:cubicBezTo>
                <a:cubicBezTo>
                  <a:pt x="692150" y="188383"/>
                  <a:pt x="695802" y="186848"/>
                  <a:pt x="698500" y="184150"/>
                </a:cubicBezTo>
                <a:cubicBezTo>
                  <a:pt x="720636" y="162014"/>
                  <a:pt x="708838" y="167278"/>
                  <a:pt x="730250" y="161925"/>
                </a:cubicBezTo>
                <a:cubicBezTo>
                  <a:pt x="735542" y="158750"/>
                  <a:pt x="740990" y="155823"/>
                  <a:pt x="746125" y="152400"/>
                </a:cubicBezTo>
                <a:cubicBezTo>
                  <a:pt x="750528" y="149465"/>
                  <a:pt x="754231" y="145500"/>
                  <a:pt x="758825" y="142875"/>
                </a:cubicBezTo>
                <a:cubicBezTo>
                  <a:pt x="761731" y="141215"/>
                  <a:pt x="765357" y="141197"/>
                  <a:pt x="768350" y="139700"/>
                </a:cubicBezTo>
                <a:cubicBezTo>
                  <a:pt x="771763" y="137993"/>
                  <a:pt x="774462" y="135057"/>
                  <a:pt x="777875" y="133350"/>
                </a:cubicBezTo>
                <a:cubicBezTo>
                  <a:pt x="804847" y="119864"/>
                  <a:pt x="760459" y="152369"/>
                  <a:pt x="812800" y="117475"/>
                </a:cubicBezTo>
                <a:cubicBezTo>
                  <a:pt x="815975" y="115358"/>
                  <a:pt x="819428" y="113608"/>
                  <a:pt x="822325" y="111125"/>
                </a:cubicBezTo>
                <a:cubicBezTo>
                  <a:pt x="826871" y="107229"/>
                  <a:pt x="830236" y="102017"/>
                  <a:pt x="835025" y="98425"/>
                </a:cubicBezTo>
                <a:cubicBezTo>
                  <a:pt x="843012" y="92434"/>
                  <a:pt x="852118" y="88088"/>
                  <a:pt x="860425" y="82550"/>
                </a:cubicBezTo>
                <a:cubicBezTo>
                  <a:pt x="863600" y="80433"/>
                  <a:pt x="866364" y="77504"/>
                  <a:pt x="869950" y="76200"/>
                </a:cubicBezTo>
                <a:cubicBezTo>
                  <a:pt x="878152" y="73218"/>
                  <a:pt x="887247" y="73091"/>
                  <a:pt x="895350" y="69850"/>
                </a:cubicBezTo>
                <a:cubicBezTo>
                  <a:pt x="900642" y="67733"/>
                  <a:pt x="905818" y="65302"/>
                  <a:pt x="911225" y="63500"/>
                </a:cubicBezTo>
                <a:cubicBezTo>
                  <a:pt x="920698" y="60342"/>
                  <a:pt x="933596" y="58713"/>
                  <a:pt x="942975" y="57150"/>
                </a:cubicBezTo>
                <a:cubicBezTo>
                  <a:pt x="978333" y="39471"/>
                  <a:pt x="933792" y="60594"/>
                  <a:pt x="968375" y="47625"/>
                </a:cubicBezTo>
                <a:cubicBezTo>
                  <a:pt x="972807" y="45963"/>
                  <a:pt x="976643" y="42937"/>
                  <a:pt x="981075" y="41275"/>
                </a:cubicBezTo>
                <a:cubicBezTo>
                  <a:pt x="985161" y="39743"/>
                  <a:pt x="989635" y="39480"/>
                  <a:pt x="993775" y="38100"/>
                </a:cubicBezTo>
                <a:cubicBezTo>
                  <a:pt x="1009768" y="32769"/>
                  <a:pt x="1007133" y="31111"/>
                  <a:pt x="1022350" y="28575"/>
                </a:cubicBezTo>
                <a:cubicBezTo>
                  <a:pt x="1074784" y="19836"/>
                  <a:pt x="1022106" y="30673"/>
                  <a:pt x="1069975" y="22225"/>
                </a:cubicBezTo>
                <a:cubicBezTo>
                  <a:pt x="1136425" y="10499"/>
                  <a:pt x="1072069" y="20112"/>
                  <a:pt x="1123950" y="12700"/>
                </a:cubicBezTo>
                <a:cubicBezTo>
                  <a:pt x="1128183" y="10583"/>
                  <a:pt x="1132160" y="7847"/>
                  <a:pt x="1136650" y="6350"/>
                </a:cubicBezTo>
                <a:cubicBezTo>
                  <a:pt x="1141088" y="4871"/>
                  <a:pt x="1168377" y="533"/>
                  <a:pt x="1171575" y="0"/>
                </a:cubicBezTo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FD2CB820-37A6-E5CD-F046-B3DA61D27A20}"/>
              </a:ext>
            </a:extLst>
          </p:cNvPr>
          <p:cNvCxnSpPr>
            <a:cxnSpLocks/>
          </p:cNvCxnSpPr>
          <p:nvPr/>
        </p:nvCxnSpPr>
        <p:spPr>
          <a:xfrm flipV="1">
            <a:off x="2333914" y="915126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FA89C084-2A4B-68E3-924A-C2CA88071957}"/>
              </a:ext>
            </a:extLst>
          </p:cNvPr>
          <p:cNvCxnSpPr>
            <a:cxnSpLocks/>
          </p:cNvCxnSpPr>
          <p:nvPr/>
        </p:nvCxnSpPr>
        <p:spPr>
          <a:xfrm flipV="1">
            <a:off x="4484447" y="915126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A06C7617-B4B3-9C8A-2305-3C55ACDD9928}"/>
              </a:ext>
            </a:extLst>
          </p:cNvPr>
          <p:cNvCxnSpPr>
            <a:cxnSpLocks/>
          </p:cNvCxnSpPr>
          <p:nvPr/>
        </p:nvCxnSpPr>
        <p:spPr>
          <a:xfrm flipV="1">
            <a:off x="4238913" y="1981927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67EBA3AE-F68E-6D7C-7BAB-60DB49940768}"/>
              </a:ext>
            </a:extLst>
          </p:cNvPr>
          <p:cNvCxnSpPr>
            <a:cxnSpLocks/>
          </p:cNvCxnSpPr>
          <p:nvPr/>
        </p:nvCxnSpPr>
        <p:spPr>
          <a:xfrm flipV="1">
            <a:off x="2295813" y="1956324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F3C8B1C2-F195-3D41-E50F-8667A4828C4E}"/>
              </a:ext>
            </a:extLst>
          </p:cNvPr>
          <p:cNvCxnSpPr>
            <a:cxnSpLocks/>
          </p:cNvCxnSpPr>
          <p:nvPr/>
        </p:nvCxnSpPr>
        <p:spPr>
          <a:xfrm flipV="1">
            <a:off x="2274646" y="3048323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A86ACD57-D226-58F7-9613-605D73193218}"/>
              </a:ext>
            </a:extLst>
          </p:cNvPr>
          <p:cNvCxnSpPr>
            <a:cxnSpLocks/>
          </p:cNvCxnSpPr>
          <p:nvPr/>
        </p:nvCxnSpPr>
        <p:spPr>
          <a:xfrm flipV="1">
            <a:off x="4230447" y="3073064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5091C00D-A8EE-8C31-18ED-959D0B9E545A}"/>
              </a:ext>
            </a:extLst>
          </p:cNvPr>
          <p:cNvCxnSpPr>
            <a:cxnSpLocks/>
          </p:cNvCxnSpPr>
          <p:nvPr/>
        </p:nvCxnSpPr>
        <p:spPr>
          <a:xfrm flipV="1">
            <a:off x="2168813" y="4807185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868B1206-B1FA-5A54-7614-A575A39F4852}"/>
              </a:ext>
            </a:extLst>
          </p:cNvPr>
          <p:cNvCxnSpPr>
            <a:cxnSpLocks/>
          </p:cNvCxnSpPr>
          <p:nvPr/>
        </p:nvCxnSpPr>
        <p:spPr>
          <a:xfrm flipV="1">
            <a:off x="4240261" y="4876626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線矢印コネクタ 38">
            <a:extLst>
              <a:ext uri="{FF2B5EF4-FFF2-40B4-BE49-F238E27FC236}">
                <a16:creationId xmlns:a16="http://schemas.microsoft.com/office/drawing/2014/main" id="{BDBEE200-ED5E-21DD-FCB5-CA2BF5EFBEBF}"/>
              </a:ext>
            </a:extLst>
          </p:cNvPr>
          <p:cNvCxnSpPr>
            <a:cxnSpLocks/>
          </p:cNvCxnSpPr>
          <p:nvPr/>
        </p:nvCxnSpPr>
        <p:spPr>
          <a:xfrm flipV="1">
            <a:off x="2266180" y="6410233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A01F5B28-22EB-88AB-AA49-36F1F27479A2}"/>
              </a:ext>
            </a:extLst>
          </p:cNvPr>
          <p:cNvCxnSpPr>
            <a:cxnSpLocks/>
          </p:cNvCxnSpPr>
          <p:nvPr/>
        </p:nvCxnSpPr>
        <p:spPr>
          <a:xfrm flipV="1">
            <a:off x="4277013" y="6401767"/>
            <a:ext cx="0" cy="360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3E1D2B4-5608-41BA-684A-BEC5280FFC67}"/>
              </a:ext>
            </a:extLst>
          </p:cNvPr>
          <p:cNvSpPr txBox="1"/>
          <p:nvPr/>
        </p:nvSpPr>
        <p:spPr>
          <a:xfrm>
            <a:off x="6732697" y="1271136"/>
            <a:ext cx="550156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ure S4. Cation/H⁺ antiport activity in inverted membrane vesicles of </a:t>
            </a:r>
            <a:r>
              <a:rPr kumimoji="1" lang="en-US" altLang="ja-JP" sz="14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. coli </a:t>
            </a:r>
            <a:r>
              <a:rPr kumimoji="1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pBAD24 and </a:t>
            </a:r>
            <a:r>
              <a:rPr kumimoji="1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</a:t>
            </a:r>
            <a:r>
              <a:rPr kumimoji="1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b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</a:b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Representative fluorescence quenching traces from three independent experiments are shown for each inverted membrane vesicle preparation at pH 9.0, upon the addition of 30 mM Na⁺, K⁺, Ca²⁺, Cs⁺, or Gdm⁺. Arrows indicate the time points at which each cation was added.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5135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A403357B-1D72-46D3-BAE4-8207C722BEF3}"/>
              </a:ext>
            </a:extLst>
          </p:cNvPr>
          <p:cNvGraphicFramePr>
            <a:graphicFrameLocks/>
          </p:cNvGraphicFramePr>
          <p:nvPr/>
        </p:nvGraphicFramePr>
        <p:xfrm>
          <a:off x="2992583" y="1126202"/>
          <a:ext cx="2489214" cy="36385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C42BAFAE-8013-E435-FC8F-1FEF187222D1}"/>
              </a:ext>
            </a:extLst>
          </p:cNvPr>
          <p:cNvGraphicFramePr>
            <a:graphicFrameLocks/>
          </p:cNvGraphicFramePr>
          <p:nvPr/>
        </p:nvGraphicFramePr>
        <p:xfrm>
          <a:off x="5481796" y="1126202"/>
          <a:ext cx="2489214" cy="36385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BCD6D4-B868-7EC1-5EBF-90DF44CA2B21}"/>
              </a:ext>
            </a:extLst>
          </p:cNvPr>
          <p:cNvSpPr txBox="1"/>
          <p:nvPr/>
        </p:nvSpPr>
        <p:spPr>
          <a:xfrm>
            <a:off x="4032971" y="266461"/>
            <a:ext cx="1230284" cy="374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0 mM K</a:t>
            </a:r>
            <a:r>
              <a:rPr kumimoji="1" lang="en-US" altLang="ja-JP" sz="1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+</a:t>
            </a:r>
            <a:endParaRPr kumimoji="1" lang="ja-JP" altLang="en-US" sz="1800" b="1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F69D9A4-8718-EE80-F06B-5044B1A2E2D5}"/>
              </a:ext>
            </a:extLst>
          </p:cNvPr>
          <p:cNvSpPr txBox="1"/>
          <p:nvPr/>
        </p:nvSpPr>
        <p:spPr>
          <a:xfrm>
            <a:off x="6185461" y="265703"/>
            <a:ext cx="1486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0 mM Ca</a:t>
            </a:r>
            <a:r>
              <a:rPr kumimoji="1" lang="en-US" altLang="ja-JP" sz="18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2+</a:t>
            </a:r>
            <a:endParaRPr kumimoji="1" lang="ja-JP" altLang="en-US" sz="1800" b="1" i="0" u="none" strike="noStrike" kern="1200" cap="none" spc="0" normalizeH="0" baseline="3000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AACBCD8-C541-C636-6C8B-E560D69EB128}"/>
              </a:ext>
            </a:extLst>
          </p:cNvPr>
          <p:cNvSpPr txBox="1"/>
          <p:nvPr/>
        </p:nvSpPr>
        <p:spPr>
          <a:xfrm>
            <a:off x="89461" y="5485161"/>
            <a:ext cx="12192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ure S5. Antiport activity of everted membrane vesicles from </a:t>
            </a:r>
            <a:r>
              <a:rPr kumimoji="1" lang="en-US" altLang="ja-JP" sz="14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. coli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</a:t>
            </a:r>
            <a:r>
              <a:rPr kumimoji="1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nd </a:t>
            </a:r>
            <a:r>
              <a:rPr kumimoji="1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pBAD24 upon addition of 30 mM K⁺ or Ca²⁺</a:t>
            </a:r>
            <a:b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</a:b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left graph shows the antiport activity upon addition of 30 mM K⁺, and the right graph shows the antiport activity upon addition of 30 mM Ca²⁺ in both strains. The results of t-tests revealed no statistically significant differences (P = 0.99 and P = 0.062; P &gt; 0.05). Red bars represent 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and blue bars represent 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pBAD24. The y-axis indicates % dequenching. Error bars represent standard deviations from three independent experiments. 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“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n.s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t>.”, not significant.</a:t>
            </a:r>
            <a:endParaRPr kumimoji="1" lang="en-US" altLang="ja-JP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BE0511F-4807-3E53-60C7-B7F757A5FE07}"/>
              </a:ext>
            </a:extLst>
          </p:cNvPr>
          <p:cNvSpPr txBox="1"/>
          <p:nvPr/>
        </p:nvSpPr>
        <p:spPr>
          <a:xfrm>
            <a:off x="4305300" y="1370836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.s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" name="左大かっこ 10">
            <a:extLst>
              <a:ext uri="{FF2B5EF4-FFF2-40B4-BE49-F238E27FC236}">
                <a16:creationId xmlns:a16="http://schemas.microsoft.com/office/drawing/2014/main" id="{E268FB55-7E16-AEA7-AB32-9AEE53E81864}"/>
              </a:ext>
            </a:extLst>
          </p:cNvPr>
          <p:cNvSpPr/>
          <p:nvPr/>
        </p:nvSpPr>
        <p:spPr>
          <a:xfrm rot="5400000">
            <a:off x="4391891" y="1558639"/>
            <a:ext cx="360218" cy="831270"/>
          </a:xfrm>
          <a:prstGeom prst="leftBracket">
            <a:avLst>
              <a:gd name="adj" fmla="val 0"/>
            </a:avLst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CC0D782-158C-070C-A4BB-16A12C2501FB}"/>
              </a:ext>
            </a:extLst>
          </p:cNvPr>
          <p:cNvSpPr txBox="1"/>
          <p:nvPr/>
        </p:nvSpPr>
        <p:spPr>
          <a:xfrm>
            <a:off x="6662047" y="587289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.s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" name="左大かっこ 12">
            <a:extLst>
              <a:ext uri="{FF2B5EF4-FFF2-40B4-BE49-F238E27FC236}">
                <a16:creationId xmlns:a16="http://schemas.microsoft.com/office/drawing/2014/main" id="{BF8B7363-DF94-633F-3AC2-48E55E464D23}"/>
              </a:ext>
            </a:extLst>
          </p:cNvPr>
          <p:cNvSpPr/>
          <p:nvPr/>
        </p:nvSpPr>
        <p:spPr>
          <a:xfrm rot="5400000">
            <a:off x="6748638" y="775092"/>
            <a:ext cx="360218" cy="831270"/>
          </a:xfrm>
          <a:prstGeom prst="leftBracket">
            <a:avLst>
              <a:gd name="adj" fmla="val 0"/>
            </a:avLst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480128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暗い部屋の中にある星のcg&#10;&#10;AI 生成コンテンツは誤りを含む可能性があります。">
            <a:extLst>
              <a:ext uri="{FF2B5EF4-FFF2-40B4-BE49-F238E27FC236}">
                <a16:creationId xmlns:a16="http://schemas.microsoft.com/office/drawing/2014/main" id="{B14CCD4C-7DE0-F6FB-D86B-A28F7F7451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8332" y="318580"/>
            <a:ext cx="10071370" cy="5292398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1468CF4-27C7-E100-57E7-7A1F0CB65172}"/>
              </a:ext>
            </a:extLst>
          </p:cNvPr>
          <p:cNvSpPr txBox="1"/>
          <p:nvPr/>
        </p:nvSpPr>
        <p:spPr>
          <a:xfrm>
            <a:off x="0" y="5919281"/>
            <a:ext cx="12192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ure S6. Measurement of Cs⁺/H⁺ and Gdm⁺/H⁺ antiport activities of everted membrane vesicles from </a:t>
            </a:r>
            <a:r>
              <a:rPr kumimoji="1" lang="en-US" altLang="ja-JP" sz="11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. coli</a:t>
            </a: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</a:t>
            </a:r>
            <a:r>
              <a:rPr kumimoji="1" lang="en-US" altLang="ja-JP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nd corresponding Lineweaver–Burk plots at pH 8.0</a:t>
            </a:r>
            <a:b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</a:b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A) Representative fluorescence quenching traces from three independent experiments are shown. The upper panel shows Cs⁺/H⁺ antiport activity and the lower panel shows Gdm⁺/H⁺ antiport activity. Arrows indicate the timing of Cs⁺ or Gdm⁺ addition at varying concentrations.</a:t>
            </a:r>
            <a:b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</a:b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B) Lineweaver–Burk plots were generated from the reciprocal values of antiport activity and substrate concentration (Cs⁺ or Gdm⁺) at pH 8.0. The y-axis represents the reciprocal of the antiport activity, and the x-axis represents the reciprocal of the cation concentration. Error bars represent standard deviations from three independent experiments.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36811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64371EC-F9B5-954A-731E-08A46CC1E387}"/>
              </a:ext>
            </a:extLst>
          </p:cNvPr>
          <p:cNvSpPr txBox="1"/>
          <p:nvPr/>
        </p:nvSpPr>
        <p:spPr>
          <a:xfrm>
            <a:off x="0" y="5927213"/>
            <a:ext cx="12192000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lementary Figure S7. Measurement of Cs⁺/H⁺ and Gdm⁺/H⁺ antiport activities of everted membrane vesicles from </a:t>
            </a:r>
            <a:r>
              <a:rPr kumimoji="1" lang="en-US" altLang="ja-JP" sz="105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. coli</a:t>
            </a:r>
            <a:r>
              <a:rPr kumimoji="1" lang="en-US" altLang="ja-JP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05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Nabc</a:t>
            </a:r>
            <a:r>
              <a:rPr kumimoji="1" lang="en-US" altLang="ja-JP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/</a:t>
            </a:r>
            <a:r>
              <a:rPr kumimoji="1" lang="en-US" altLang="ja-JP" sz="105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pBAD_Gdx</a:t>
            </a:r>
            <a:r>
              <a:rPr kumimoji="1" lang="en-US" altLang="ja-JP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nd corresponding Lineweaver–Burk plots at pH 9.0</a:t>
            </a:r>
            <a:b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</a:b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A) Representative fluorescence quenching traces from three independent experiments are shown. The upper panel shows Cs⁺/H⁺ antiport activity and the lower panel shows Gdm⁺/H⁺ antiport activity. Arrows indicate the timing of Cs⁺ or Gdm⁺ addition at varying concentrations.</a:t>
            </a:r>
            <a:b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</a:br>
            <a:r>
              <a:rPr kumimoji="1" lang="en-US" altLang="ja-JP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(B) Lineweaver–Burk plots were generated from the reciprocal values of antiport activity and substrate concentration (Cs⁺ or Gdm⁺) at pH 9.0. The y-axis represents the reciprocal of the antiport activity, and the x-axis represents the reciprocal of the cation concentration. Error bars represent standard deviations from three independent experiments.</a:t>
            </a:r>
            <a:endParaRPr kumimoji="1" lang="ja-JP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4" name="図 3" descr="コンピューターの画面&#10;&#10;AI 生成コンテンツは誤りを含む可能性があります。">
            <a:extLst>
              <a:ext uri="{FF2B5EF4-FFF2-40B4-BE49-F238E27FC236}">
                <a16:creationId xmlns:a16="http://schemas.microsoft.com/office/drawing/2014/main" id="{3C5D43B1-77E5-6E71-F332-ED5B4A5E70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0012" y="0"/>
            <a:ext cx="10115436" cy="57276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6901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906</Words>
  <Application>Microsoft Office PowerPoint</Application>
  <PresentationFormat>ワイド画面</PresentationFormat>
  <Paragraphs>39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游ゴシック</vt:lpstr>
      <vt:lpstr>游ゴシック Light</vt:lpstr>
      <vt:lpstr>Arial</vt:lpstr>
      <vt:lpstr>Times New Roman</vt:lpstr>
      <vt:lpstr>Office テーマ</vt:lpstr>
      <vt:lpstr>1_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伊藤 政博</dc:creator>
  <cp:lastModifiedBy>伊藤 政博</cp:lastModifiedBy>
  <cp:revision>4</cp:revision>
  <cp:lastPrinted>2025-11-22T04:49:35Z</cp:lastPrinted>
  <dcterms:created xsi:type="dcterms:W3CDTF">2025-10-01T08:10:45Z</dcterms:created>
  <dcterms:modified xsi:type="dcterms:W3CDTF">2025-11-22T08:35:22Z</dcterms:modified>
</cp:coreProperties>
</file>